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1453" r:id="rId2"/>
    <p:sldId id="1452" r:id="rId3"/>
    <p:sldId id="1451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10F078C-0986-4636-AE96-409868DC7F32}" v="3" dt="2024-12-04T14:28:42.7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1"/>
    <p:restoredTop sz="96070"/>
  </p:normalViewPr>
  <p:slideViewPr>
    <p:cSldViewPr snapToGrid="0">
      <p:cViewPr varScale="1">
        <p:scale>
          <a:sx n="74" d="100"/>
          <a:sy n="74" d="100"/>
        </p:scale>
        <p:origin x="-55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notesViewPr>
    <p:cSldViewPr snapToGrid="0">
      <p:cViewPr varScale="1">
        <p:scale>
          <a:sx n="89" d="100"/>
          <a:sy n="89" d="100"/>
        </p:scale>
        <p:origin x="3960" y="1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edric Portugues" userId="462c9a9c-d0b5-4f9e-81ca-7459ab7dae3e" providerId="ADAL" clId="{F10F078C-0986-4636-AE96-409868DC7F32}"/>
    <pc:docChg chg="undo custSel modSld">
      <pc:chgData name="Cedric Portugues" userId="462c9a9c-d0b5-4f9e-81ca-7459ab7dae3e" providerId="ADAL" clId="{F10F078C-0986-4636-AE96-409868DC7F32}" dt="2024-12-04T14:28:57.994" v="14" actId="14100"/>
      <pc:docMkLst>
        <pc:docMk/>
      </pc:docMkLst>
      <pc:sldChg chg="addSp delSp modSp mod">
        <pc:chgData name="Cedric Portugues" userId="462c9a9c-d0b5-4f9e-81ca-7459ab7dae3e" providerId="ADAL" clId="{F10F078C-0986-4636-AE96-409868DC7F32}" dt="2024-12-04T14:28:57.994" v="14" actId="14100"/>
        <pc:sldMkLst>
          <pc:docMk/>
          <pc:sldMk cId="2136216684" sldId="1451"/>
        </pc:sldMkLst>
        <pc:picChg chg="add mod">
          <ac:chgData name="Cedric Portugues" userId="462c9a9c-d0b5-4f9e-81ca-7459ab7dae3e" providerId="ADAL" clId="{F10F078C-0986-4636-AE96-409868DC7F32}" dt="2024-12-04T14:26:53.122" v="5"/>
          <ac:picMkLst>
            <pc:docMk/>
            <pc:sldMk cId="2136216684" sldId="1451"/>
            <ac:picMk id="9" creationId="{1DF9D57F-3589-2C8A-EF07-A71BC8238398}"/>
          </ac:picMkLst>
        </pc:picChg>
        <pc:picChg chg="add mod">
          <ac:chgData name="Cedric Portugues" userId="462c9a9c-d0b5-4f9e-81ca-7459ab7dae3e" providerId="ADAL" clId="{F10F078C-0986-4636-AE96-409868DC7F32}" dt="2024-12-04T14:28:57.994" v="14" actId="14100"/>
          <ac:picMkLst>
            <pc:docMk/>
            <pc:sldMk cId="2136216684" sldId="1451"/>
            <ac:picMk id="11" creationId="{DBDE98D1-A5D2-7DD8-9A15-E5BAA8B1EDEF}"/>
          </ac:picMkLst>
        </pc:picChg>
        <pc:picChg chg="add del">
          <ac:chgData name="Cedric Portugues" userId="462c9a9c-d0b5-4f9e-81ca-7459ab7dae3e" providerId="ADAL" clId="{F10F078C-0986-4636-AE96-409868DC7F32}" dt="2024-12-04T14:28:41.759" v="7" actId="478"/>
          <ac:picMkLst>
            <pc:docMk/>
            <pc:sldMk cId="2136216684" sldId="1451"/>
            <ac:picMk id="16" creationId="{21C0E4D9-6498-3B55-728F-7D40D7E1FC8F}"/>
          </ac:picMkLst>
        </pc:pic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4B9DD132-064E-4130-AA26-2A893CB3956B}" type="doc">
      <dgm:prSet loTypeId="urn:microsoft.com/office/officeart/2005/8/layout/orgChart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fr-FR"/>
        </a:p>
      </dgm:t>
    </dgm:pt>
    <dgm:pt modelId="{7E099C14-93D6-491F-9E8C-32DC4FC4F976}">
      <dgm:prSet phldrT="[Texte]" custT="1"/>
      <dgm:spPr/>
      <dgm:t>
        <a:bodyPr/>
        <a:lstStyle/>
        <a:p>
          <a:r>
            <a:rPr lang="fr-FR" sz="800" dirty="0" err="1"/>
            <a:t>Safety</a:t>
          </a:r>
          <a:r>
            <a:rPr lang="fr-FR" sz="800" dirty="0"/>
            <a:t>  and </a:t>
          </a:r>
          <a:r>
            <a:rPr lang="fr-FR" sz="800" dirty="0" err="1"/>
            <a:t>efficacy</a:t>
          </a:r>
          <a:r>
            <a:rPr lang="fr-FR" sz="800" dirty="0"/>
            <a:t> set </a:t>
          </a:r>
        </a:p>
        <a:p>
          <a:r>
            <a:rPr lang="fr-FR" sz="800" dirty="0"/>
            <a:t>N=122</a:t>
          </a:r>
        </a:p>
      </dgm:t>
    </dgm:pt>
    <dgm:pt modelId="{02010345-7750-4E9D-9697-27CE4FEAF7D3}" type="parTrans" cxnId="{4A956295-D7AA-4465-96CD-BCAD910804C1}">
      <dgm:prSet/>
      <dgm:spPr/>
      <dgm:t>
        <a:bodyPr/>
        <a:lstStyle/>
        <a:p>
          <a:endParaRPr lang="fr-FR" sz="800"/>
        </a:p>
      </dgm:t>
    </dgm:pt>
    <dgm:pt modelId="{6781A97C-391C-467B-A9E0-6FA12238C1E7}" type="sibTrans" cxnId="{4A956295-D7AA-4465-96CD-BCAD910804C1}">
      <dgm:prSet/>
      <dgm:spPr/>
      <dgm:t>
        <a:bodyPr/>
        <a:lstStyle/>
        <a:p>
          <a:endParaRPr lang="fr-FR" sz="800"/>
        </a:p>
      </dgm:t>
    </dgm:pt>
    <dgm:pt modelId="{30EBEB49-9185-4367-BE27-32CD5A0191D6}">
      <dgm:prSet phldrT="[Texte]" custT="1"/>
      <dgm:spPr/>
      <dgm:t>
        <a:bodyPr/>
        <a:lstStyle/>
        <a:p>
          <a:r>
            <a:rPr lang="fr-FR" sz="800"/>
            <a:t>Cycle 1 done</a:t>
          </a:r>
        </a:p>
        <a:p>
          <a:r>
            <a:rPr lang="fr-FR" sz="800"/>
            <a:t>N=122</a:t>
          </a:r>
        </a:p>
      </dgm:t>
    </dgm:pt>
    <dgm:pt modelId="{7BD8408E-3F24-43D7-848B-4689ADD09AAC}" type="parTrans" cxnId="{306C5D5A-12D1-4AA6-BB81-3BD18AD93FFE}">
      <dgm:prSet/>
      <dgm:spPr/>
      <dgm:t>
        <a:bodyPr/>
        <a:lstStyle/>
        <a:p>
          <a:endParaRPr lang="fr-FR" sz="800"/>
        </a:p>
      </dgm:t>
    </dgm:pt>
    <dgm:pt modelId="{03E277A8-220D-456E-A1D5-D0CAC015AB9F}" type="sibTrans" cxnId="{306C5D5A-12D1-4AA6-BB81-3BD18AD93FFE}">
      <dgm:prSet/>
      <dgm:spPr/>
      <dgm:t>
        <a:bodyPr/>
        <a:lstStyle/>
        <a:p>
          <a:endParaRPr lang="fr-FR" sz="800"/>
        </a:p>
      </dgm:t>
    </dgm:pt>
    <dgm:pt modelId="{AE26EAF7-5BF4-42EB-92F1-66A6F28C0D38}">
      <dgm:prSet custT="1"/>
      <dgm:spPr/>
      <dgm:t>
        <a:bodyPr/>
        <a:lstStyle/>
        <a:p>
          <a:r>
            <a:rPr lang="fr-FR" sz="800"/>
            <a:t>Cycle 2 done</a:t>
          </a:r>
        </a:p>
        <a:p>
          <a:r>
            <a:rPr lang="fr-FR" sz="800"/>
            <a:t>N=113</a:t>
          </a:r>
        </a:p>
      </dgm:t>
    </dgm:pt>
    <dgm:pt modelId="{6A6C0A6C-FA8B-4046-9A6E-BABB970C63BA}" type="parTrans" cxnId="{ABAA48A4-6BD8-4ADA-91A4-E4327573BAF8}">
      <dgm:prSet/>
      <dgm:spPr/>
      <dgm:t>
        <a:bodyPr/>
        <a:lstStyle/>
        <a:p>
          <a:endParaRPr lang="fr-FR" sz="800"/>
        </a:p>
      </dgm:t>
    </dgm:pt>
    <dgm:pt modelId="{3F07C414-3533-4813-BE51-98FFBCE7D3E6}" type="sibTrans" cxnId="{ABAA48A4-6BD8-4ADA-91A4-E4327573BAF8}">
      <dgm:prSet/>
      <dgm:spPr/>
      <dgm:t>
        <a:bodyPr/>
        <a:lstStyle/>
        <a:p>
          <a:endParaRPr lang="fr-FR" sz="800"/>
        </a:p>
      </dgm:t>
    </dgm:pt>
    <dgm:pt modelId="{50E63AF7-6BBD-4A95-9588-2D4922A02307}">
      <dgm:prSet custT="1"/>
      <dgm:spPr/>
      <dgm:t>
        <a:bodyPr/>
        <a:lstStyle/>
        <a:p>
          <a:r>
            <a:rPr lang="fr-FR" sz="800"/>
            <a:t>Cycle 3 done</a:t>
          </a:r>
        </a:p>
        <a:p>
          <a:r>
            <a:rPr lang="fr-FR" sz="800"/>
            <a:t>N=110</a:t>
          </a:r>
        </a:p>
      </dgm:t>
    </dgm:pt>
    <dgm:pt modelId="{26DFCC3E-2E77-4BA3-AB4A-4F23137359B1}" type="parTrans" cxnId="{E4C0216B-C7C9-44FD-ACA6-A7EC32337064}">
      <dgm:prSet/>
      <dgm:spPr/>
      <dgm:t>
        <a:bodyPr/>
        <a:lstStyle/>
        <a:p>
          <a:endParaRPr lang="fr-FR" sz="800"/>
        </a:p>
      </dgm:t>
    </dgm:pt>
    <dgm:pt modelId="{E07CEB10-DE2D-456F-9026-98DD7D7BFE09}" type="sibTrans" cxnId="{E4C0216B-C7C9-44FD-ACA6-A7EC32337064}">
      <dgm:prSet/>
      <dgm:spPr/>
      <dgm:t>
        <a:bodyPr/>
        <a:lstStyle/>
        <a:p>
          <a:endParaRPr lang="fr-FR" sz="800"/>
        </a:p>
      </dgm:t>
    </dgm:pt>
    <dgm:pt modelId="{147877A7-848B-4D29-AC0B-0898B164DC79}">
      <dgm:prSet custT="1"/>
      <dgm:spPr/>
      <dgm:t>
        <a:bodyPr/>
        <a:lstStyle/>
        <a:p>
          <a:r>
            <a:rPr lang="fr-FR" sz="800"/>
            <a:t>Cycle 4 done</a:t>
          </a:r>
        </a:p>
        <a:p>
          <a:r>
            <a:rPr lang="fr-FR" sz="800"/>
            <a:t>N=107</a:t>
          </a:r>
        </a:p>
      </dgm:t>
    </dgm:pt>
    <dgm:pt modelId="{245A5A4E-8B59-454F-94D8-2EE5BB68F38D}" type="parTrans" cxnId="{E999A008-5582-4623-A531-409975A799E2}">
      <dgm:prSet/>
      <dgm:spPr/>
      <dgm:t>
        <a:bodyPr/>
        <a:lstStyle/>
        <a:p>
          <a:endParaRPr lang="fr-FR" sz="800"/>
        </a:p>
      </dgm:t>
    </dgm:pt>
    <dgm:pt modelId="{D6324E60-7E32-4E08-A9C5-7005CCB9D9F3}" type="sibTrans" cxnId="{E999A008-5582-4623-A531-409975A799E2}">
      <dgm:prSet/>
      <dgm:spPr/>
      <dgm:t>
        <a:bodyPr/>
        <a:lstStyle/>
        <a:p>
          <a:endParaRPr lang="fr-FR" sz="800"/>
        </a:p>
      </dgm:t>
    </dgm:pt>
    <dgm:pt modelId="{27568990-8594-43EE-BD59-20464603E34D}">
      <dgm:prSet custT="1"/>
      <dgm:spPr/>
      <dgm:t>
        <a:bodyPr/>
        <a:lstStyle/>
        <a:p>
          <a:r>
            <a:rPr lang="fr-FR" sz="800"/>
            <a:t>Cycle 5 done</a:t>
          </a:r>
        </a:p>
        <a:p>
          <a:r>
            <a:rPr lang="fr-FR" sz="800"/>
            <a:t>N=105</a:t>
          </a:r>
        </a:p>
      </dgm:t>
    </dgm:pt>
    <dgm:pt modelId="{F57039EE-DEA8-472F-8BCA-F387F3C4A87F}" type="parTrans" cxnId="{63BE0ADB-62AC-4423-8CB2-9BC06EE1549F}">
      <dgm:prSet/>
      <dgm:spPr/>
      <dgm:t>
        <a:bodyPr/>
        <a:lstStyle/>
        <a:p>
          <a:endParaRPr lang="fr-FR" sz="800"/>
        </a:p>
      </dgm:t>
    </dgm:pt>
    <dgm:pt modelId="{2C556C56-A559-4329-8B1F-C9DAFD91B46C}" type="sibTrans" cxnId="{63BE0ADB-62AC-4423-8CB2-9BC06EE1549F}">
      <dgm:prSet/>
      <dgm:spPr/>
      <dgm:t>
        <a:bodyPr/>
        <a:lstStyle/>
        <a:p>
          <a:endParaRPr lang="fr-FR" sz="800"/>
        </a:p>
      </dgm:t>
    </dgm:pt>
    <dgm:pt modelId="{06B64C62-2D1B-4B3C-B4CB-36776F767BF3}">
      <dgm:prSet custT="1"/>
      <dgm:spPr/>
      <dgm:t>
        <a:bodyPr/>
        <a:lstStyle/>
        <a:p>
          <a:r>
            <a:rPr lang="fr-FR" sz="800"/>
            <a:t>Cycle 6 done</a:t>
          </a:r>
        </a:p>
        <a:p>
          <a:r>
            <a:rPr lang="fr-FR" sz="800"/>
            <a:t>N=103</a:t>
          </a:r>
        </a:p>
      </dgm:t>
    </dgm:pt>
    <dgm:pt modelId="{5309080B-6865-42C2-A2D7-0115F241DF00}" type="parTrans" cxnId="{D39766F6-C16F-4D9E-957A-62C96D74A064}">
      <dgm:prSet/>
      <dgm:spPr/>
      <dgm:t>
        <a:bodyPr/>
        <a:lstStyle/>
        <a:p>
          <a:endParaRPr lang="fr-FR" sz="800"/>
        </a:p>
      </dgm:t>
    </dgm:pt>
    <dgm:pt modelId="{2C2F0A77-968D-479D-A430-E87F57F8BE2D}" type="sibTrans" cxnId="{D39766F6-C16F-4D9E-957A-62C96D74A064}">
      <dgm:prSet/>
      <dgm:spPr/>
      <dgm:t>
        <a:bodyPr/>
        <a:lstStyle/>
        <a:p>
          <a:endParaRPr lang="fr-FR" sz="800"/>
        </a:p>
      </dgm:t>
    </dgm:pt>
    <dgm:pt modelId="{183F33F1-BA65-43CB-9836-95C4F58C2E5A}">
      <dgm:prSet custT="1"/>
      <dgm:spPr/>
      <dgm:t>
        <a:bodyPr/>
        <a:lstStyle/>
        <a:p>
          <a:r>
            <a:rPr lang="fr-FR" sz="800"/>
            <a:t>Cycle 7 done</a:t>
          </a:r>
        </a:p>
        <a:p>
          <a:r>
            <a:rPr lang="fr-FR" sz="800"/>
            <a:t>N=102</a:t>
          </a:r>
        </a:p>
      </dgm:t>
    </dgm:pt>
    <dgm:pt modelId="{4A1A5591-00C8-4709-90E5-8E3779A0118D}" type="parTrans" cxnId="{F797817B-3707-4915-ACC8-9A66A7B2FC07}">
      <dgm:prSet/>
      <dgm:spPr/>
      <dgm:t>
        <a:bodyPr/>
        <a:lstStyle/>
        <a:p>
          <a:endParaRPr lang="fr-FR" sz="800"/>
        </a:p>
      </dgm:t>
    </dgm:pt>
    <dgm:pt modelId="{45066345-0372-4BBB-A758-65897650D2EB}" type="sibTrans" cxnId="{F797817B-3707-4915-ACC8-9A66A7B2FC07}">
      <dgm:prSet/>
      <dgm:spPr/>
      <dgm:t>
        <a:bodyPr/>
        <a:lstStyle/>
        <a:p>
          <a:endParaRPr lang="fr-FR" sz="800"/>
        </a:p>
      </dgm:t>
    </dgm:pt>
    <dgm:pt modelId="{63776243-3727-4304-80F7-AE3A96EBE3C4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9:</a:t>
          </a:r>
        </a:p>
        <a:p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: N=5*</a:t>
          </a:r>
        </a:p>
        <a:p>
          <a:r>
            <a:rPr lang="fr-FR" sz="800" dirty="0" err="1">
              <a:solidFill>
                <a:schemeClr val="tx1"/>
              </a:solidFill>
            </a:rPr>
            <a:t>Death</a:t>
          </a:r>
          <a:r>
            <a:rPr lang="fr-FR" sz="800" dirty="0">
              <a:solidFill>
                <a:schemeClr val="tx1"/>
              </a:solidFill>
            </a:rPr>
            <a:t>: N=2 (SEPTIC SHOCK TO KLEBSIELLA PNEUMONIA; SEPTIC SHOCK)</a:t>
          </a:r>
        </a:p>
        <a:p>
          <a:r>
            <a:rPr lang="fr-FR" sz="800" dirty="0">
              <a:solidFill>
                <a:schemeClr val="tx1"/>
              </a:solidFill>
            </a:rPr>
            <a:t>Adverse </a:t>
          </a:r>
          <a:r>
            <a:rPr lang="fr-FR" sz="800" dirty="0" err="1">
              <a:solidFill>
                <a:schemeClr val="tx1"/>
              </a:solidFill>
            </a:rPr>
            <a:t>event</a:t>
          </a:r>
          <a:r>
            <a:rPr lang="fr-FR" sz="800" dirty="0">
              <a:solidFill>
                <a:schemeClr val="tx1"/>
              </a:solidFill>
            </a:rPr>
            <a:t>: N=2 (CEREBROVASCULAR ACCIDENT; DEPRESSION)</a:t>
          </a:r>
        </a:p>
      </dgm:t>
    </dgm:pt>
    <dgm:pt modelId="{F53E1CA3-B4B0-492B-9547-78FE4C905AE7}" type="parTrans" cxnId="{89C9B4DC-489A-4B11-8256-4F6937A34A35}">
      <dgm:prSet/>
      <dgm:spPr/>
      <dgm:t>
        <a:bodyPr/>
        <a:lstStyle/>
        <a:p>
          <a:endParaRPr lang="fr-FR" sz="800"/>
        </a:p>
      </dgm:t>
    </dgm:pt>
    <dgm:pt modelId="{FBCD1DD2-4A7A-496A-9EED-389E0A1526FB}" type="sibTrans" cxnId="{89C9B4DC-489A-4B11-8256-4F6937A34A35}">
      <dgm:prSet/>
      <dgm:spPr/>
      <dgm:t>
        <a:bodyPr/>
        <a:lstStyle/>
        <a:p>
          <a:endParaRPr lang="fr-FR" sz="800"/>
        </a:p>
      </dgm:t>
    </dgm:pt>
    <dgm:pt modelId="{CF684B7D-C5E1-4A50-988C-916E87CEAE83}">
      <dgm:prSet custT="1"/>
      <dgm:spPr/>
      <dgm:t>
        <a:bodyPr/>
        <a:lstStyle/>
        <a:p>
          <a:r>
            <a:rPr lang="fr-FR" sz="800" dirty="0">
              <a:solidFill>
                <a:schemeClr val="tx1"/>
              </a:solidFill>
            </a:rPr>
            <a:t>Cycle 8 </a:t>
          </a:r>
          <a:r>
            <a:rPr lang="fr-FR" sz="800" dirty="0" err="1">
              <a:solidFill>
                <a:schemeClr val="tx1"/>
              </a:solidFill>
            </a:rPr>
            <a:t>done</a:t>
          </a:r>
          <a:endParaRPr lang="fr-FR" sz="800" dirty="0">
            <a:solidFill>
              <a:schemeClr val="tx1"/>
            </a:solidFill>
          </a:endParaRPr>
        </a:p>
        <a:p>
          <a:r>
            <a:rPr lang="fr-FR" sz="800" dirty="0">
              <a:solidFill>
                <a:schemeClr val="tx1"/>
              </a:solidFill>
            </a:rPr>
            <a:t>N=100 (99)</a:t>
          </a:r>
        </a:p>
      </dgm:t>
    </dgm:pt>
    <dgm:pt modelId="{2618976A-03BA-4082-BDE7-A6D1691F1DC4}" type="parTrans" cxnId="{96DFC50D-6458-49A7-ADDB-C1968CE0B4EB}">
      <dgm:prSet/>
      <dgm:spPr/>
      <dgm:t>
        <a:bodyPr/>
        <a:lstStyle/>
        <a:p>
          <a:endParaRPr lang="fr-FR" sz="800"/>
        </a:p>
      </dgm:t>
    </dgm:pt>
    <dgm:pt modelId="{34E5C5AC-793F-4CA8-BF07-6C7446E5CCFB}" type="sibTrans" cxnId="{96DFC50D-6458-49A7-ADDB-C1968CE0B4EB}">
      <dgm:prSet/>
      <dgm:spPr/>
      <dgm:t>
        <a:bodyPr/>
        <a:lstStyle/>
        <a:p>
          <a:endParaRPr lang="fr-FR" sz="800"/>
        </a:p>
      </dgm:t>
    </dgm:pt>
    <dgm:pt modelId="{179F4144-DCB3-481A-8760-AB47F499551C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3</a:t>
          </a:r>
        </a:p>
        <a:p>
          <a:r>
            <a:rPr lang="fr-FR" sz="800" b="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: N=2*</a:t>
          </a:r>
        </a:p>
        <a:p>
          <a:r>
            <a:rPr lang="fr-FR" sz="800" dirty="0">
              <a:solidFill>
                <a:schemeClr val="tx1"/>
              </a:solidFill>
            </a:rPr>
            <a:t>Protocol </a:t>
          </a:r>
          <a:r>
            <a:rPr lang="fr-FR" sz="800" dirty="0" err="1">
              <a:solidFill>
                <a:schemeClr val="tx1"/>
              </a:solidFill>
            </a:rPr>
            <a:t>deviation</a:t>
          </a:r>
          <a:r>
            <a:rPr lang="fr-FR" sz="800" dirty="0">
              <a:solidFill>
                <a:schemeClr val="tx1"/>
              </a:solidFill>
            </a:rPr>
            <a:t>: N=1 (NEUROMENINGEAL INVASION)</a:t>
          </a:r>
        </a:p>
      </dgm:t>
    </dgm:pt>
    <dgm:pt modelId="{F850A7DC-09B2-411D-953E-5B5E1A450098}" type="parTrans" cxnId="{2E956CCF-405A-4C28-854B-9AAB9F0981EB}">
      <dgm:prSet/>
      <dgm:spPr/>
      <dgm:t>
        <a:bodyPr/>
        <a:lstStyle/>
        <a:p>
          <a:endParaRPr lang="fr-FR" sz="800"/>
        </a:p>
      </dgm:t>
    </dgm:pt>
    <dgm:pt modelId="{E3BD84AB-3181-4A00-B649-D974B4FA8CCB}" type="sibTrans" cxnId="{2E956CCF-405A-4C28-854B-9AAB9F0981EB}">
      <dgm:prSet/>
      <dgm:spPr/>
      <dgm:t>
        <a:bodyPr/>
        <a:lstStyle/>
        <a:p>
          <a:endParaRPr lang="fr-FR" sz="800"/>
        </a:p>
      </dgm:t>
    </dgm:pt>
    <dgm:pt modelId="{21B9D424-B669-4390-8F72-BED741E11DDD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3</a:t>
          </a:r>
        </a:p>
        <a:p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: N=1*</a:t>
          </a:r>
        </a:p>
        <a:p>
          <a:r>
            <a:rPr lang="fr-FR" sz="800" dirty="0">
              <a:solidFill>
                <a:schemeClr val="tx1"/>
              </a:solidFill>
            </a:rPr>
            <a:t>Adverse </a:t>
          </a:r>
          <a:r>
            <a:rPr lang="fr-FR" sz="800" dirty="0" err="1">
              <a:solidFill>
                <a:schemeClr val="tx1"/>
              </a:solidFill>
            </a:rPr>
            <a:t>event</a:t>
          </a:r>
          <a:r>
            <a:rPr lang="fr-FR" sz="800" dirty="0">
              <a:solidFill>
                <a:schemeClr val="tx1"/>
              </a:solidFill>
            </a:rPr>
            <a:t>: N=1 (BONE MARROW FAILURE)</a:t>
          </a:r>
        </a:p>
        <a:p>
          <a:r>
            <a:rPr lang="fr-FR" sz="800" dirty="0">
              <a:solidFill>
                <a:schemeClr val="tx1"/>
              </a:solidFill>
            </a:rPr>
            <a:t>Protocol </a:t>
          </a:r>
          <a:r>
            <a:rPr lang="fr-FR" sz="800" dirty="0" err="1">
              <a:solidFill>
                <a:schemeClr val="tx1"/>
              </a:solidFill>
            </a:rPr>
            <a:t>deviation</a:t>
          </a:r>
          <a:r>
            <a:rPr lang="fr-FR" sz="800" dirty="0">
              <a:solidFill>
                <a:schemeClr val="tx1"/>
              </a:solidFill>
            </a:rPr>
            <a:t>: N=1 (NO DOXOROBUCINE GIVEN AT C3 DUE TO PICCLINE REMOVAL)</a:t>
          </a:r>
        </a:p>
      </dgm:t>
    </dgm:pt>
    <dgm:pt modelId="{C08D9A70-67FB-49D3-81B9-F4F99712157A}" type="parTrans" cxnId="{3415CA9C-F9BD-4FA4-80A0-561B1F5B64F8}">
      <dgm:prSet/>
      <dgm:spPr/>
      <dgm:t>
        <a:bodyPr/>
        <a:lstStyle/>
        <a:p>
          <a:endParaRPr lang="fr-FR" sz="800"/>
        </a:p>
      </dgm:t>
    </dgm:pt>
    <dgm:pt modelId="{2A8695D6-FBB1-40F7-A532-2138068A2D5D}" type="sibTrans" cxnId="{3415CA9C-F9BD-4FA4-80A0-561B1F5B64F8}">
      <dgm:prSet/>
      <dgm:spPr/>
      <dgm:t>
        <a:bodyPr/>
        <a:lstStyle/>
        <a:p>
          <a:endParaRPr lang="fr-FR" sz="800"/>
        </a:p>
      </dgm:t>
    </dgm:pt>
    <dgm:pt modelId="{23B57F58-1B31-4638-B024-3E49E0396E60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2</a:t>
          </a:r>
        </a:p>
        <a:p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: N=1*</a:t>
          </a:r>
        </a:p>
        <a:p>
          <a:r>
            <a:rPr lang="fr-FR" sz="800" dirty="0" err="1">
              <a:solidFill>
                <a:schemeClr val="tx1"/>
              </a:solidFill>
            </a:rPr>
            <a:t>Physician</a:t>
          </a:r>
          <a:r>
            <a:rPr lang="fr-FR" sz="800" dirty="0">
              <a:solidFill>
                <a:schemeClr val="tx1"/>
              </a:solidFill>
            </a:rPr>
            <a:t> </a:t>
          </a:r>
          <a:r>
            <a:rPr lang="fr-FR" sz="800" dirty="0" err="1">
              <a:solidFill>
                <a:schemeClr val="tx1"/>
              </a:solidFill>
            </a:rPr>
            <a:t>decision</a:t>
          </a:r>
          <a:r>
            <a:rPr lang="fr-FR" sz="800" dirty="0">
              <a:solidFill>
                <a:schemeClr val="tx1"/>
              </a:solidFill>
            </a:rPr>
            <a:t>: N=1</a:t>
          </a:r>
        </a:p>
      </dgm:t>
    </dgm:pt>
    <dgm:pt modelId="{4CB58116-E357-4A0D-A82A-1ABCCC14B2BB}" type="parTrans" cxnId="{350ED2C6-D70B-458A-946C-C801463D2EFA}">
      <dgm:prSet/>
      <dgm:spPr/>
      <dgm:t>
        <a:bodyPr/>
        <a:lstStyle/>
        <a:p>
          <a:endParaRPr lang="fr-FR" sz="800"/>
        </a:p>
      </dgm:t>
    </dgm:pt>
    <dgm:pt modelId="{D0E59E68-A7C6-4181-8B9B-48B68FECB871}" type="sibTrans" cxnId="{350ED2C6-D70B-458A-946C-C801463D2EFA}">
      <dgm:prSet/>
      <dgm:spPr/>
      <dgm:t>
        <a:bodyPr/>
        <a:lstStyle/>
        <a:p>
          <a:endParaRPr lang="fr-FR" sz="800"/>
        </a:p>
      </dgm:t>
    </dgm:pt>
    <dgm:pt modelId="{E72B805D-21CC-4B95-9B87-4852D37611F8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2</a:t>
          </a:r>
        </a:p>
        <a:p>
          <a:r>
            <a:rPr lang="fr-FR" sz="800" dirty="0">
              <a:solidFill>
                <a:schemeClr val="tx1"/>
              </a:solidFill>
            </a:rPr>
            <a:t>Adverse Event: N=1 (THROMBOPHLEBITIS SEPTIC)</a:t>
          </a:r>
        </a:p>
        <a:p>
          <a:r>
            <a:rPr lang="fr-FR" sz="800" dirty="0">
              <a:solidFill>
                <a:schemeClr val="tx1"/>
              </a:solidFill>
            </a:rPr>
            <a:t>Progressive </a:t>
          </a:r>
          <a:r>
            <a:rPr lang="fr-FR" sz="800" dirty="0" err="1">
              <a:solidFill>
                <a:schemeClr val="tx1"/>
              </a:solidFill>
            </a:rPr>
            <a:t>disease</a:t>
          </a:r>
          <a:r>
            <a:rPr lang="fr-FR" sz="800" dirty="0">
              <a:solidFill>
                <a:schemeClr val="tx1"/>
              </a:solidFill>
            </a:rPr>
            <a:t>: N=1</a:t>
          </a:r>
        </a:p>
      </dgm:t>
    </dgm:pt>
    <dgm:pt modelId="{99FAD591-0AF3-4E25-A938-6FA91DB3C1AA}" type="parTrans" cxnId="{A31D3996-2E19-4091-ACDC-B1BD22410A2A}">
      <dgm:prSet/>
      <dgm:spPr/>
      <dgm:t>
        <a:bodyPr/>
        <a:lstStyle/>
        <a:p>
          <a:endParaRPr lang="fr-FR" sz="800"/>
        </a:p>
      </dgm:t>
    </dgm:pt>
    <dgm:pt modelId="{21EF47E5-8310-487C-A8DA-D09EA220523F}" type="sibTrans" cxnId="{A31D3996-2E19-4091-ACDC-B1BD22410A2A}">
      <dgm:prSet/>
      <dgm:spPr/>
      <dgm:t>
        <a:bodyPr/>
        <a:lstStyle/>
        <a:p>
          <a:endParaRPr lang="fr-FR" sz="800"/>
        </a:p>
      </dgm:t>
    </dgm:pt>
    <dgm:pt modelId="{EEBEEE8C-07E1-4DFB-B65A-EF213958C368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1</a:t>
          </a:r>
        </a:p>
        <a:p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dirty="0">
              <a:solidFill>
                <a:schemeClr val="accent5">
                  <a:lumMod val="75000"/>
                </a:schemeClr>
              </a:solidFill>
            </a:rPr>
            <a:t>: N=1*</a:t>
          </a:r>
        </a:p>
      </dgm:t>
    </dgm:pt>
    <dgm:pt modelId="{2334274E-576C-4FB9-81DB-A95E48E77BB8}" type="parTrans" cxnId="{07EA22D5-DDF2-4E01-9BB0-CCC920AFB11F}">
      <dgm:prSet/>
      <dgm:spPr/>
      <dgm:t>
        <a:bodyPr/>
        <a:lstStyle/>
        <a:p>
          <a:endParaRPr lang="fr-FR" sz="800"/>
        </a:p>
      </dgm:t>
    </dgm:pt>
    <dgm:pt modelId="{AA0C43F0-25EF-4187-820A-E67419EFDCDB}" type="sibTrans" cxnId="{07EA22D5-DDF2-4E01-9BB0-CCC920AFB11F}">
      <dgm:prSet/>
      <dgm:spPr/>
      <dgm:t>
        <a:bodyPr/>
        <a:lstStyle/>
        <a:p>
          <a:endParaRPr lang="fr-FR" sz="800"/>
        </a:p>
      </dgm:t>
    </dgm:pt>
    <dgm:pt modelId="{1046AD8B-4D99-415B-9B14-74689DF64D90}" type="asst">
      <dgm:prSet custT="1"/>
      <dgm:spPr/>
      <dgm:t>
        <a:bodyPr/>
        <a:lstStyle/>
        <a:p>
          <a:r>
            <a:rPr lang="fr-FR" sz="800" b="1" dirty="0" err="1">
              <a:solidFill>
                <a:schemeClr val="tx1"/>
              </a:solidFill>
            </a:rPr>
            <a:t>Reasons</a:t>
          </a:r>
          <a:r>
            <a:rPr lang="fr-FR" sz="800" b="1" dirty="0">
              <a:solidFill>
                <a:schemeClr val="tx1"/>
              </a:solidFill>
            </a:rPr>
            <a:t> for permanent </a:t>
          </a:r>
          <a:r>
            <a:rPr lang="fr-FR" sz="800" b="1" dirty="0" err="1">
              <a:solidFill>
                <a:schemeClr val="tx1"/>
              </a:solidFill>
            </a:rPr>
            <a:t>treatment</a:t>
          </a:r>
          <a:r>
            <a:rPr lang="fr-FR" sz="800" b="1" dirty="0">
              <a:solidFill>
                <a:schemeClr val="tx1"/>
              </a:solidFill>
            </a:rPr>
            <a:t> discontinuation: N=2</a:t>
          </a:r>
        </a:p>
        <a:p>
          <a:r>
            <a:rPr lang="fr-FR" sz="800" dirty="0">
              <a:solidFill>
                <a:schemeClr val="tx1"/>
              </a:solidFill>
            </a:rPr>
            <a:t>Adverse </a:t>
          </a:r>
          <a:r>
            <a:rPr lang="fr-FR" sz="800" dirty="0" err="1">
              <a:solidFill>
                <a:schemeClr val="tx1"/>
              </a:solidFill>
            </a:rPr>
            <a:t>event</a:t>
          </a:r>
          <a:r>
            <a:rPr lang="fr-FR" sz="800" dirty="0">
              <a:solidFill>
                <a:schemeClr val="tx1"/>
              </a:solidFill>
            </a:rPr>
            <a:t>: N=2 (NEUTROPENIA ; GENERAL PHYSICAL HEALTH DETERIORATION and NAUSEA)</a:t>
          </a:r>
        </a:p>
      </dgm:t>
    </dgm:pt>
    <dgm:pt modelId="{4110C564-743C-45CA-9BDA-5595D5563902}" type="parTrans" cxnId="{71A098BC-AAB2-4B4E-BF80-65F7CD63974A}">
      <dgm:prSet/>
      <dgm:spPr/>
      <dgm:t>
        <a:bodyPr/>
        <a:lstStyle/>
        <a:p>
          <a:endParaRPr lang="fr-FR" sz="800"/>
        </a:p>
      </dgm:t>
    </dgm:pt>
    <dgm:pt modelId="{2FBFC805-B844-46F3-BD2A-1671E0E18282}" type="sibTrans" cxnId="{71A098BC-AAB2-4B4E-BF80-65F7CD63974A}">
      <dgm:prSet/>
      <dgm:spPr/>
      <dgm:t>
        <a:bodyPr/>
        <a:lstStyle/>
        <a:p>
          <a:endParaRPr lang="fr-FR" sz="800"/>
        </a:p>
      </dgm:t>
    </dgm:pt>
    <dgm:pt modelId="{D0AB1E91-B690-44C9-8300-34A34223F069}" type="pres">
      <dgm:prSet presAssocID="{4B9DD132-064E-4130-AA26-2A893CB3956B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US"/>
        </a:p>
      </dgm:t>
    </dgm:pt>
    <dgm:pt modelId="{E9C0A15B-08F5-45AB-AE40-50B104EF8824}" type="pres">
      <dgm:prSet presAssocID="{7E099C14-93D6-491F-9E8C-32DC4FC4F976}" presName="hierRoot1" presStyleCnt="0">
        <dgm:presLayoutVars>
          <dgm:hierBranch val="init"/>
        </dgm:presLayoutVars>
      </dgm:prSet>
      <dgm:spPr/>
    </dgm:pt>
    <dgm:pt modelId="{C2EC1000-34A7-42BD-B9EE-DC9FC5B3FC84}" type="pres">
      <dgm:prSet presAssocID="{7E099C14-93D6-491F-9E8C-32DC4FC4F976}" presName="rootComposite1" presStyleCnt="0"/>
      <dgm:spPr/>
    </dgm:pt>
    <dgm:pt modelId="{D0948DE4-96CE-40F4-ABC7-147E84CF7ECA}" type="pres">
      <dgm:prSet presAssocID="{7E099C14-93D6-491F-9E8C-32DC4FC4F976}" presName="rootText1" presStyleLbl="node0" presStyleIdx="0" presStyleCnt="1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2C47AC0-82CD-4F45-9AAE-F9F05AE84BD3}" type="pres">
      <dgm:prSet presAssocID="{7E099C14-93D6-491F-9E8C-32DC4FC4F976}" presName="rootConnector1" presStyleLbl="node1" presStyleIdx="0" presStyleCnt="0"/>
      <dgm:spPr/>
      <dgm:t>
        <a:bodyPr/>
        <a:lstStyle/>
        <a:p>
          <a:endParaRPr lang="en-US"/>
        </a:p>
      </dgm:t>
    </dgm:pt>
    <dgm:pt modelId="{6569A100-808C-420D-8846-DC101D1FCA94}" type="pres">
      <dgm:prSet presAssocID="{7E099C14-93D6-491F-9E8C-32DC4FC4F976}" presName="hierChild2" presStyleCnt="0"/>
      <dgm:spPr/>
    </dgm:pt>
    <dgm:pt modelId="{4C4E53C1-EB55-45A9-9A0C-9DA14B00D2F3}" type="pres">
      <dgm:prSet presAssocID="{7BD8408E-3F24-43D7-848B-4689ADD09AAC}" presName="Name37" presStyleLbl="parChTrans1D2" presStyleIdx="0" presStyleCnt="1"/>
      <dgm:spPr/>
      <dgm:t>
        <a:bodyPr/>
        <a:lstStyle/>
        <a:p>
          <a:endParaRPr lang="en-US"/>
        </a:p>
      </dgm:t>
    </dgm:pt>
    <dgm:pt modelId="{A7C27564-4010-422D-8733-D45402B36FD6}" type="pres">
      <dgm:prSet presAssocID="{30EBEB49-9185-4367-BE27-32CD5A0191D6}" presName="hierRoot2" presStyleCnt="0">
        <dgm:presLayoutVars>
          <dgm:hierBranch val="init"/>
        </dgm:presLayoutVars>
      </dgm:prSet>
      <dgm:spPr/>
    </dgm:pt>
    <dgm:pt modelId="{78023387-3D9B-437A-9E82-943D893DC85E}" type="pres">
      <dgm:prSet presAssocID="{30EBEB49-9185-4367-BE27-32CD5A0191D6}" presName="rootComposite" presStyleCnt="0"/>
      <dgm:spPr/>
    </dgm:pt>
    <dgm:pt modelId="{E38B95A6-6623-484F-AC67-3FA1AA07853B}" type="pres">
      <dgm:prSet presAssocID="{30EBEB49-9185-4367-BE27-32CD5A0191D6}" presName="rootText" presStyleLbl="node2" presStyleIdx="0" presStyleCnt="1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9945E00-3364-440F-9B4E-A582A727AB21}" type="pres">
      <dgm:prSet presAssocID="{30EBEB49-9185-4367-BE27-32CD5A0191D6}" presName="rootConnector" presStyleLbl="node2" presStyleIdx="0" presStyleCnt="1"/>
      <dgm:spPr/>
      <dgm:t>
        <a:bodyPr/>
        <a:lstStyle/>
        <a:p>
          <a:endParaRPr lang="en-US"/>
        </a:p>
      </dgm:t>
    </dgm:pt>
    <dgm:pt modelId="{153551BC-D4DE-4C18-B7A8-5127B716297E}" type="pres">
      <dgm:prSet presAssocID="{30EBEB49-9185-4367-BE27-32CD5A0191D6}" presName="hierChild4" presStyleCnt="0"/>
      <dgm:spPr/>
    </dgm:pt>
    <dgm:pt modelId="{6132DE44-9ECA-47B2-AD75-85A6A010FC4D}" type="pres">
      <dgm:prSet presAssocID="{6A6C0A6C-FA8B-4046-9A6E-BABB970C63BA}" presName="Name37" presStyleLbl="parChTrans1D3" presStyleIdx="0" presStyleCnt="2"/>
      <dgm:spPr/>
      <dgm:t>
        <a:bodyPr/>
        <a:lstStyle/>
        <a:p>
          <a:endParaRPr lang="en-US"/>
        </a:p>
      </dgm:t>
    </dgm:pt>
    <dgm:pt modelId="{62D2C5AE-FFB0-4BFA-B644-64EACE25F2B3}" type="pres">
      <dgm:prSet presAssocID="{AE26EAF7-5BF4-42EB-92F1-66A6F28C0D38}" presName="hierRoot2" presStyleCnt="0">
        <dgm:presLayoutVars>
          <dgm:hierBranch val="init"/>
        </dgm:presLayoutVars>
      </dgm:prSet>
      <dgm:spPr/>
    </dgm:pt>
    <dgm:pt modelId="{AF41D9D0-4667-46A5-896B-3811539CBE6B}" type="pres">
      <dgm:prSet presAssocID="{AE26EAF7-5BF4-42EB-92F1-66A6F28C0D38}" presName="rootComposite" presStyleCnt="0"/>
      <dgm:spPr/>
    </dgm:pt>
    <dgm:pt modelId="{12BD7DDA-D1BB-4FF4-8342-23B53D84EC6A}" type="pres">
      <dgm:prSet presAssocID="{AE26EAF7-5BF4-42EB-92F1-66A6F28C0D38}" presName="rootText" presStyleLbl="node3" presStyleIdx="0" presStyleCnt="1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08D7198-6022-44C2-869C-F31346916F48}" type="pres">
      <dgm:prSet presAssocID="{AE26EAF7-5BF4-42EB-92F1-66A6F28C0D38}" presName="rootConnector" presStyleLbl="node3" presStyleIdx="0" presStyleCnt="1"/>
      <dgm:spPr/>
      <dgm:t>
        <a:bodyPr/>
        <a:lstStyle/>
        <a:p>
          <a:endParaRPr lang="en-US"/>
        </a:p>
      </dgm:t>
    </dgm:pt>
    <dgm:pt modelId="{EB4F3260-6D99-4847-99BF-BBF0FE9BFDFD}" type="pres">
      <dgm:prSet presAssocID="{AE26EAF7-5BF4-42EB-92F1-66A6F28C0D38}" presName="hierChild4" presStyleCnt="0"/>
      <dgm:spPr/>
    </dgm:pt>
    <dgm:pt modelId="{5547A377-B232-4285-B4EE-75243809D23F}" type="pres">
      <dgm:prSet presAssocID="{26DFCC3E-2E77-4BA3-AB4A-4F23137359B1}" presName="Name37" presStyleLbl="parChTrans1D4" presStyleIdx="0" presStyleCnt="12"/>
      <dgm:spPr/>
      <dgm:t>
        <a:bodyPr/>
        <a:lstStyle/>
        <a:p>
          <a:endParaRPr lang="en-US"/>
        </a:p>
      </dgm:t>
    </dgm:pt>
    <dgm:pt modelId="{1183E0B9-5315-4455-8FA9-13A9719D8B62}" type="pres">
      <dgm:prSet presAssocID="{50E63AF7-6BBD-4A95-9588-2D4922A02307}" presName="hierRoot2" presStyleCnt="0">
        <dgm:presLayoutVars>
          <dgm:hierBranch val="init"/>
        </dgm:presLayoutVars>
      </dgm:prSet>
      <dgm:spPr/>
    </dgm:pt>
    <dgm:pt modelId="{112EC6FD-33FD-41B4-9495-A3412CC3CAA7}" type="pres">
      <dgm:prSet presAssocID="{50E63AF7-6BBD-4A95-9588-2D4922A02307}" presName="rootComposite" presStyleCnt="0"/>
      <dgm:spPr/>
    </dgm:pt>
    <dgm:pt modelId="{A1AB4BCC-C250-428E-A94F-1F38EC7E7CA4}" type="pres">
      <dgm:prSet presAssocID="{50E63AF7-6BBD-4A95-9588-2D4922A02307}" presName="rootText" presStyleLbl="node4" presStyleIdx="0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C6813EA7-DA57-4341-8D2A-524C42FEED56}" type="pres">
      <dgm:prSet presAssocID="{50E63AF7-6BBD-4A95-9588-2D4922A02307}" presName="rootConnector" presStyleLbl="node4" presStyleIdx="0" presStyleCnt="6"/>
      <dgm:spPr/>
      <dgm:t>
        <a:bodyPr/>
        <a:lstStyle/>
        <a:p>
          <a:endParaRPr lang="en-US"/>
        </a:p>
      </dgm:t>
    </dgm:pt>
    <dgm:pt modelId="{F37DC6BB-146C-4A92-842B-B863CC3F4B19}" type="pres">
      <dgm:prSet presAssocID="{50E63AF7-6BBD-4A95-9588-2D4922A02307}" presName="hierChild4" presStyleCnt="0"/>
      <dgm:spPr/>
    </dgm:pt>
    <dgm:pt modelId="{2F281A03-08F4-4C67-B904-7FB33A589950}" type="pres">
      <dgm:prSet presAssocID="{245A5A4E-8B59-454F-94D8-2EE5BB68F38D}" presName="Name37" presStyleLbl="parChTrans1D4" presStyleIdx="1" presStyleCnt="12"/>
      <dgm:spPr/>
      <dgm:t>
        <a:bodyPr/>
        <a:lstStyle/>
        <a:p>
          <a:endParaRPr lang="en-US"/>
        </a:p>
      </dgm:t>
    </dgm:pt>
    <dgm:pt modelId="{D18821A5-3DBF-4DA6-B1FC-A79892BF0B6F}" type="pres">
      <dgm:prSet presAssocID="{147877A7-848B-4D29-AC0B-0898B164DC79}" presName="hierRoot2" presStyleCnt="0">
        <dgm:presLayoutVars>
          <dgm:hierBranch val="init"/>
        </dgm:presLayoutVars>
      </dgm:prSet>
      <dgm:spPr/>
    </dgm:pt>
    <dgm:pt modelId="{9AEA714A-8B1D-47AA-B6CD-383039D4079D}" type="pres">
      <dgm:prSet presAssocID="{147877A7-848B-4D29-AC0B-0898B164DC79}" presName="rootComposite" presStyleCnt="0"/>
      <dgm:spPr/>
    </dgm:pt>
    <dgm:pt modelId="{E9B9B375-243B-43C0-AB17-CA88E082354E}" type="pres">
      <dgm:prSet presAssocID="{147877A7-848B-4D29-AC0B-0898B164DC79}" presName="rootText" presStyleLbl="node4" presStyleIdx="1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67BA1CE8-17EC-4C8B-A5BE-5D084E4A2EF0}" type="pres">
      <dgm:prSet presAssocID="{147877A7-848B-4D29-AC0B-0898B164DC79}" presName="rootConnector" presStyleLbl="node4" presStyleIdx="1" presStyleCnt="6"/>
      <dgm:spPr/>
      <dgm:t>
        <a:bodyPr/>
        <a:lstStyle/>
        <a:p>
          <a:endParaRPr lang="en-US"/>
        </a:p>
      </dgm:t>
    </dgm:pt>
    <dgm:pt modelId="{A3B38350-AEB8-41B7-B999-30E6A70D7454}" type="pres">
      <dgm:prSet presAssocID="{147877A7-848B-4D29-AC0B-0898B164DC79}" presName="hierChild4" presStyleCnt="0"/>
      <dgm:spPr/>
    </dgm:pt>
    <dgm:pt modelId="{5B55021B-F6A8-4994-8164-4336A664D621}" type="pres">
      <dgm:prSet presAssocID="{F57039EE-DEA8-472F-8BCA-F387F3C4A87F}" presName="Name37" presStyleLbl="parChTrans1D4" presStyleIdx="2" presStyleCnt="12"/>
      <dgm:spPr/>
      <dgm:t>
        <a:bodyPr/>
        <a:lstStyle/>
        <a:p>
          <a:endParaRPr lang="en-US"/>
        </a:p>
      </dgm:t>
    </dgm:pt>
    <dgm:pt modelId="{6DEB88B3-DF98-4F7C-BB45-98784BC6BE0A}" type="pres">
      <dgm:prSet presAssocID="{27568990-8594-43EE-BD59-20464603E34D}" presName="hierRoot2" presStyleCnt="0">
        <dgm:presLayoutVars>
          <dgm:hierBranch val="init"/>
        </dgm:presLayoutVars>
      </dgm:prSet>
      <dgm:spPr/>
    </dgm:pt>
    <dgm:pt modelId="{983D766E-4B96-4588-BF84-9B3181B089EA}" type="pres">
      <dgm:prSet presAssocID="{27568990-8594-43EE-BD59-20464603E34D}" presName="rootComposite" presStyleCnt="0"/>
      <dgm:spPr/>
    </dgm:pt>
    <dgm:pt modelId="{E0AC1C43-68C3-4F03-9C5C-C3BAD309D7B7}" type="pres">
      <dgm:prSet presAssocID="{27568990-8594-43EE-BD59-20464603E34D}" presName="rootText" presStyleLbl="node4" presStyleIdx="2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9B3A1275-CAC7-4AFD-ACDE-DEDCDE911F13}" type="pres">
      <dgm:prSet presAssocID="{27568990-8594-43EE-BD59-20464603E34D}" presName="rootConnector" presStyleLbl="node4" presStyleIdx="2" presStyleCnt="6"/>
      <dgm:spPr/>
      <dgm:t>
        <a:bodyPr/>
        <a:lstStyle/>
        <a:p>
          <a:endParaRPr lang="en-US"/>
        </a:p>
      </dgm:t>
    </dgm:pt>
    <dgm:pt modelId="{B50A1B66-654C-4815-A4F5-61A4860A8631}" type="pres">
      <dgm:prSet presAssocID="{27568990-8594-43EE-BD59-20464603E34D}" presName="hierChild4" presStyleCnt="0"/>
      <dgm:spPr/>
    </dgm:pt>
    <dgm:pt modelId="{FB7E3833-9C19-46A0-9A92-6F38FFC85039}" type="pres">
      <dgm:prSet presAssocID="{5309080B-6865-42C2-A2D7-0115F241DF00}" presName="Name37" presStyleLbl="parChTrans1D4" presStyleIdx="3" presStyleCnt="12"/>
      <dgm:spPr/>
      <dgm:t>
        <a:bodyPr/>
        <a:lstStyle/>
        <a:p>
          <a:endParaRPr lang="en-US"/>
        </a:p>
      </dgm:t>
    </dgm:pt>
    <dgm:pt modelId="{A806BAB3-CC6D-49EB-81C2-EA3A60D814A7}" type="pres">
      <dgm:prSet presAssocID="{06B64C62-2D1B-4B3C-B4CB-36776F767BF3}" presName="hierRoot2" presStyleCnt="0">
        <dgm:presLayoutVars>
          <dgm:hierBranch val="init"/>
        </dgm:presLayoutVars>
      </dgm:prSet>
      <dgm:spPr/>
    </dgm:pt>
    <dgm:pt modelId="{0F8BEC4F-1EAD-441F-A8C9-4EF7E38EDFF5}" type="pres">
      <dgm:prSet presAssocID="{06B64C62-2D1B-4B3C-B4CB-36776F767BF3}" presName="rootComposite" presStyleCnt="0"/>
      <dgm:spPr/>
    </dgm:pt>
    <dgm:pt modelId="{C4992308-3022-43C8-8EF5-550E2758FE43}" type="pres">
      <dgm:prSet presAssocID="{06B64C62-2D1B-4B3C-B4CB-36776F767BF3}" presName="rootText" presStyleLbl="node4" presStyleIdx="3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55B0D24A-FD7F-4D60-B5F9-C70D47E4349E}" type="pres">
      <dgm:prSet presAssocID="{06B64C62-2D1B-4B3C-B4CB-36776F767BF3}" presName="rootConnector" presStyleLbl="node4" presStyleIdx="3" presStyleCnt="6"/>
      <dgm:spPr/>
      <dgm:t>
        <a:bodyPr/>
        <a:lstStyle/>
        <a:p>
          <a:endParaRPr lang="en-US"/>
        </a:p>
      </dgm:t>
    </dgm:pt>
    <dgm:pt modelId="{ECD706E3-40E7-4F01-AF58-EF7A19699BA5}" type="pres">
      <dgm:prSet presAssocID="{06B64C62-2D1B-4B3C-B4CB-36776F767BF3}" presName="hierChild4" presStyleCnt="0"/>
      <dgm:spPr/>
    </dgm:pt>
    <dgm:pt modelId="{F0190C39-547E-4B89-B648-F08C6C2F66F2}" type="pres">
      <dgm:prSet presAssocID="{4A1A5591-00C8-4709-90E5-8E3779A0118D}" presName="Name37" presStyleLbl="parChTrans1D4" presStyleIdx="4" presStyleCnt="12"/>
      <dgm:spPr/>
      <dgm:t>
        <a:bodyPr/>
        <a:lstStyle/>
        <a:p>
          <a:endParaRPr lang="en-US"/>
        </a:p>
      </dgm:t>
    </dgm:pt>
    <dgm:pt modelId="{D9C7D02A-0F5C-49D0-8C51-702EA2A83559}" type="pres">
      <dgm:prSet presAssocID="{183F33F1-BA65-43CB-9836-95C4F58C2E5A}" presName="hierRoot2" presStyleCnt="0">
        <dgm:presLayoutVars>
          <dgm:hierBranch/>
        </dgm:presLayoutVars>
      </dgm:prSet>
      <dgm:spPr/>
    </dgm:pt>
    <dgm:pt modelId="{46A5B192-7700-4B2B-9F65-EF1F11E93386}" type="pres">
      <dgm:prSet presAssocID="{183F33F1-BA65-43CB-9836-95C4F58C2E5A}" presName="rootComposite" presStyleCnt="0"/>
      <dgm:spPr/>
    </dgm:pt>
    <dgm:pt modelId="{3E185FB1-90A9-437D-850B-C2C96FF3602F}" type="pres">
      <dgm:prSet presAssocID="{183F33F1-BA65-43CB-9836-95C4F58C2E5A}" presName="rootText" presStyleLbl="node4" presStyleIdx="4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355617B-E040-4542-A2D7-E7A3C5822DDF}" type="pres">
      <dgm:prSet presAssocID="{183F33F1-BA65-43CB-9836-95C4F58C2E5A}" presName="rootConnector" presStyleLbl="node4" presStyleIdx="4" presStyleCnt="6"/>
      <dgm:spPr/>
      <dgm:t>
        <a:bodyPr/>
        <a:lstStyle/>
        <a:p>
          <a:endParaRPr lang="en-US"/>
        </a:p>
      </dgm:t>
    </dgm:pt>
    <dgm:pt modelId="{E37592DD-442F-4E7D-A48D-F8386311B5EB}" type="pres">
      <dgm:prSet presAssocID="{183F33F1-BA65-43CB-9836-95C4F58C2E5A}" presName="hierChild4" presStyleCnt="0"/>
      <dgm:spPr/>
    </dgm:pt>
    <dgm:pt modelId="{29C21FE1-B6ED-4A37-B462-2AB3364F71D0}" type="pres">
      <dgm:prSet presAssocID="{2618976A-03BA-4082-BDE7-A6D1691F1DC4}" presName="Name35" presStyleLbl="parChTrans1D4" presStyleIdx="5" presStyleCnt="12"/>
      <dgm:spPr/>
      <dgm:t>
        <a:bodyPr/>
        <a:lstStyle/>
        <a:p>
          <a:endParaRPr lang="en-US"/>
        </a:p>
      </dgm:t>
    </dgm:pt>
    <dgm:pt modelId="{B5751F6B-2FC0-4461-9202-EC1FFC1BB83B}" type="pres">
      <dgm:prSet presAssocID="{CF684B7D-C5E1-4A50-988C-916E87CEAE83}" presName="hierRoot2" presStyleCnt="0">
        <dgm:presLayoutVars>
          <dgm:hierBranch val="init"/>
        </dgm:presLayoutVars>
      </dgm:prSet>
      <dgm:spPr/>
    </dgm:pt>
    <dgm:pt modelId="{9883E3ED-F315-45F3-886E-E6D8EA46A73A}" type="pres">
      <dgm:prSet presAssocID="{CF684B7D-C5E1-4A50-988C-916E87CEAE83}" presName="rootComposite" presStyleCnt="0"/>
      <dgm:spPr/>
    </dgm:pt>
    <dgm:pt modelId="{2971916A-BFEB-44DC-A717-D00C519E9A59}" type="pres">
      <dgm:prSet presAssocID="{CF684B7D-C5E1-4A50-988C-916E87CEAE83}" presName="rootText" presStyleLbl="node4" presStyleIdx="5" presStyleCnt="6" custScaleX="380800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DA2F4ACF-6C14-4DF7-A20F-96A538ED303C}" type="pres">
      <dgm:prSet presAssocID="{CF684B7D-C5E1-4A50-988C-916E87CEAE83}" presName="rootConnector" presStyleLbl="node4" presStyleIdx="5" presStyleCnt="6"/>
      <dgm:spPr/>
      <dgm:t>
        <a:bodyPr/>
        <a:lstStyle/>
        <a:p>
          <a:endParaRPr lang="en-US"/>
        </a:p>
      </dgm:t>
    </dgm:pt>
    <dgm:pt modelId="{E57B0BA7-3DE9-4E0F-B080-5233355F6BF6}" type="pres">
      <dgm:prSet presAssocID="{CF684B7D-C5E1-4A50-988C-916E87CEAE83}" presName="hierChild4" presStyleCnt="0"/>
      <dgm:spPr/>
    </dgm:pt>
    <dgm:pt modelId="{10307762-6315-424F-B934-8DE34AA04EAF}" type="pres">
      <dgm:prSet presAssocID="{CF684B7D-C5E1-4A50-988C-916E87CEAE83}" presName="hierChild5" presStyleCnt="0"/>
      <dgm:spPr/>
    </dgm:pt>
    <dgm:pt modelId="{120F3428-41E0-483B-935E-2377D00AA10F}" type="pres">
      <dgm:prSet presAssocID="{183F33F1-BA65-43CB-9836-95C4F58C2E5A}" presName="hierChild5" presStyleCnt="0"/>
      <dgm:spPr/>
    </dgm:pt>
    <dgm:pt modelId="{1C4607AE-9127-4C60-8192-99F85D2263E4}" type="pres">
      <dgm:prSet presAssocID="{4110C564-743C-45CA-9BDA-5595D5563902}" presName="Name111" presStyleLbl="parChTrans1D4" presStyleIdx="6" presStyleCnt="12"/>
      <dgm:spPr/>
      <dgm:t>
        <a:bodyPr/>
        <a:lstStyle/>
        <a:p>
          <a:endParaRPr lang="en-US"/>
        </a:p>
      </dgm:t>
    </dgm:pt>
    <dgm:pt modelId="{8C71EC6A-4A0B-41D4-B3D9-4B3E6422C3AD}" type="pres">
      <dgm:prSet presAssocID="{1046AD8B-4D99-415B-9B14-74689DF64D90}" presName="hierRoot3" presStyleCnt="0">
        <dgm:presLayoutVars>
          <dgm:hierBranch val="init"/>
        </dgm:presLayoutVars>
      </dgm:prSet>
      <dgm:spPr/>
    </dgm:pt>
    <dgm:pt modelId="{CA65F4BB-23DE-4248-91BD-833F84A21F69}" type="pres">
      <dgm:prSet presAssocID="{1046AD8B-4D99-415B-9B14-74689DF64D90}" presName="rootComposite3" presStyleCnt="0"/>
      <dgm:spPr/>
    </dgm:pt>
    <dgm:pt modelId="{6F252BDA-768A-4210-BE51-DC46B35854BC}" type="pres">
      <dgm:prSet presAssocID="{1046AD8B-4D99-415B-9B14-74689DF64D90}" presName="rootText3" presStyleLbl="asst4" presStyleIdx="0" presStyleCnt="5" custScaleX="681007" custScaleY="196858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A610353B-487B-4D3B-B549-9C8168ACE54B}" type="pres">
      <dgm:prSet presAssocID="{1046AD8B-4D99-415B-9B14-74689DF64D90}" presName="rootConnector3" presStyleLbl="asst4" presStyleIdx="0" presStyleCnt="5"/>
      <dgm:spPr/>
      <dgm:t>
        <a:bodyPr/>
        <a:lstStyle/>
        <a:p>
          <a:endParaRPr lang="en-US"/>
        </a:p>
      </dgm:t>
    </dgm:pt>
    <dgm:pt modelId="{3D4C655F-7C64-4A71-A4E4-FAD9DBD85574}" type="pres">
      <dgm:prSet presAssocID="{1046AD8B-4D99-415B-9B14-74689DF64D90}" presName="hierChild6" presStyleCnt="0"/>
      <dgm:spPr/>
    </dgm:pt>
    <dgm:pt modelId="{C808ECEC-9723-43EC-97D1-8D7C9FF97DCB}" type="pres">
      <dgm:prSet presAssocID="{1046AD8B-4D99-415B-9B14-74689DF64D90}" presName="hierChild7" presStyleCnt="0"/>
      <dgm:spPr/>
    </dgm:pt>
    <dgm:pt modelId="{F4FF0489-A853-4C7C-BB76-642DA87047B3}" type="pres">
      <dgm:prSet presAssocID="{06B64C62-2D1B-4B3C-B4CB-36776F767BF3}" presName="hierChild5" presStyleCnt="0"/>
      <dgm:spPr/>
    </dgm:pt>
    <dgm:pt modelId="{70601568-05B5-4DC1-BCD5-011FFBDC2219}" type="pres">
      <dgm:prSet presAssocID="{2334274E-576C-4FB9-81DB-A95E48E77BB8}" presName="Name111" presStyleLbl="parChTrans1D4" presStyleIdx="7" presStyleCnt="12"/>
      <dgm:spPr/>
      <dgm:t>
        <a:bodyPr/>
        <a:lstStyle/>
        <a:p>
          <a:endParaRPr lang="en-US"/>
        </a:p>
      </dgm:t>
    </dgm:pt>
    <dgm:pt modelId="{E8B61ACB-8814-4069-B5F9-A7584C60C613}" type="pres">
      <dgm:prSet presAssocID="{EEBEEE8C-07E1-4DFB-B65A-EF213958C368}" presName="hierRoot3" presStyleCnt="0">
        <dgm:presLayoutVars>
          <dgm:hierBranch val="init"/>
        </dgm:presLayoutVars>
      </dgm:prSet>
      <dgm:spPr/>
    </dgm:pt>
    <dgm:pt modelId="{3D6194E9-9011-4B54-8ACB-854EB94B004C}" type="pres">
      <dgm:prSet presAssocID="{EEBEEE8C-07E1-4DFB-B65A-EF213958C368}" presName="rootComposite3" presStyleCnt="0"/>
      <dgm:spPr/>
    </dgm:pt>
    <dgm:pt modelId="{A2D48AFA-835A-42D2-A17D-B4802F8A67A4}" type="pres">
      <dgm:prSet presAssocID="{EEBEEE8C-07E1-4DFB-B65A-EF213958C368}" presName="rootText3" presStyleLbl="asst4" presStyleIdx="1" presStyleCnt="5" custScaleX="681007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9BF4019-569B-4D46-B84E-1FD6F41C902C}" type="pres">
      <dgm:prSet presAssocID="{EEBEEE8C-07E1-4DFB-B65A-EF213958C368}" presName="rootConnector3" presStyleLbl="asst4" presStyleIdx="1" presStyleCnt="5"/>
      <dgm:spPr/>
      <dgm:t>
        <a:bodyPr/>
        <a:lstStyle/>
        <a:p>
          <a:endParaRPr lang="en-US"/>
        </a:p>
      </dgm:t>
    </dgm:pt>
    <dgm:pt modelId="{ABA74EE5-D1E7-42FA-867F-1C09F2DB57E6}" type="pres">
      <dgm:prSet presAssocID="{EEBEEE8C-07E1-4DFB-B65A-EF213958C368}" presName="hierChild6" presStyleCnt="0"/>
      <dgm:spPr/>
    </dgm:pt>
    <dgm:pt modelId="{57D0F040-5F27-429F-9336-E6F413B91F0D}" type="pres">
      <dgm:prSet presAssocID="{EEBEEE8C-07E1-4DFB-B65A-EF213958C368}" presName="hierChild7" presStyleCnt="0"/>
      <dgm:spPr/>
    </dgm:pt>
    <dgm:pt modelId="{BB4E68D0-E02F-45BB-B375-C4D5C8E54D00}" type="pres">
      <dgm:prSet presAssocID="{27568990-8594-43EE-BD59-20464603E34D}" presName="hierChild5" presStyleCnt="0"/>
      <dgm:spPr/>
    </dgm:pt>
    <dgm:pt modelId="{3B48D2C8-A1D2-4BBF-A64A-AAD6A8E75BDE}" type="pres">
      <dgm:prSet presAssocID="{99FAD591-0AF3-4E25-A938-6FA91DB3C1AA}" presName="Name111" presStyleLbl="parChTrans1D4" presStyleIdx="8" presStyleCnt="12"/>
      <dgm:spPr/>
      <dgm:t>
        <a:bodyPr/>
        <a:lstStyle/>
        <a:p>
          <a:endParaRPr lang="en-US"/>
        </a:p>
      </dgm:t>
    </dgm:pt>
    <dgm:pt modelId="{C9EB6748-715A-4326-B3CE-A948AA7F0ECE}" type="pres">
      <dgm:prSet presAssocID="{E72B805D-21CC-4B95-9B87-4852D37611F8}" presName="hierRoot3" presStyleCnt="0">
        <dgm:presLayoutVars>
          <dgm:hierBranch val="init"/>
        </dgm:presLayoutVars>
      </dgm:prSet>
      <dgm:spPr/>
    </dgm:pt>
    <dgm:pt modelId="{D9B9EAA8-849E-4146-B1F0-185A52035332}" type="pres">
      <dgm:prSet presAssocID="{E72B805D-21CC-4B95-9B87-4852D37611F8}" presName="rootComposite3" presStyleCnt="0"/>
      <dgm:spPr/>
    </dgm:pt>
    <dgm:pt modelId="{01264203-9E7F-4345-A1A4-0B833DE16E0D}" type="pres">
      <dgm:prSet presAssocID="{E72B805D-21CC-4B95-9B87-4852D37611F8}" presName="rootText3" presStyleLbl="asst4" presStyleIdx="2" presStyleCnt="5" custScaleX="681007" custScaleY="192624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00F1FCF2-CC58-42F1-87B1-8486ACB8A7A5}" type="pres">
      <dgm:prSet presAssocID="{E72B805D-21CC-4B95-9B87-4852D37611F8}" presName="rootConnector3" presStyleLbl="asst4" presStyleIdx="2" presStyleCnt="5"/>
      <dgm:spPr/>
      <dgm:t>
        <a:bodyPr/>
        <a:lstStyle/>
        <a:p>
          <a:endParaRPr lang="en-US"/>
        </a:p>
      </dgm:t>
    </dgm:pt>
    <dgm:pt modelId="{59F35C2F-8685-4EA9-B241-73AE7DEAD213}" type="pres">
      <dgm:prSet presAssocID="{E72B805D-21CC-4B95-9B87-4852D37611F8}" presName="hierChild6" presStyleCnt="0"/>
      <dgm:spPr/>
    </dgm:pt>
    <dgm:pt modelId="{7CC7969D-B908-42B0-BE45-E4F2112DF2BE}" type="pres">
      <dgm:prSet presAssocID="{E72B805D-21CC-4B95-9B87-4852D37611F8}" presName="hierChild7" presStyleCnt="0"/>
      <dgm:spPr/>
    </dgm:pt>
    <dgm:pt modelId="{F379C07C-1F43-4643-BCA5-6157A0598F7E}" type="pres">
      <dgm:prSet presAssocID="{147877A7-848B-4D29-AC0B-0898B164DC79}" presName="hierChild5" presStyleCnt="0"/>
      <dgm:spPr/>
    </dgm:pt>
    <dgm:pt modelId="{A4169EFE-EE22-41EC-86BA-2B250D2ECC2F}" type="pres">
      <dgm:prSet presAssocID="{4CB58116-E357-4A0D-A82A-1ABCCC14B2BB}" presName="Name111" presStyleLbl="parChTrans1D4" presStyleIdx="9" presStyleCnt="12"/>
      <dgm:spPr/>
      <dgm:t>
        <a:bodyPr/>
        <a:lstStyle/>
        <a:p>
          <a:endParaRPr lang="en-US"/>
        </a:p>
      </dgm:t>
    </dgm:pt>
    <dgm:pt modelId="{F83DA89D-DC51-4615-9508-5D192E33D116}" type="pres">
      <dgm:prSet presAssocID="{23B57F58-1B31-4638-B024-3E49E0396E60}" presName="hierRoot3" presStyleCnt="0">
        <dgm:presLayoutVars>
          <dgm:hierBranch val="init"/>
        </dgm:presLayoutVars>
      </dgm:prSet>
      <dgm:spPr/>
    </dgm:pt>
    <dgm:pt modelId="{8E21F11A-DF64-4C42-928F-AE9B122057DE}" type="pres">
      <dgm:prSet presAssocID="{23B57F58-1B31-4638-B024-3E49E0396E60}" presName="rootComposite3" presStyleCnt="0"/>
      <dgm:spPr/>
    </dgm:pt>
    <dgm:pt modelId="{B426F62F-390E-492D-BC1D-BD154468C3AD}" type="pres">
      <dgm:prSet presAssocID="{23B57F58-1B31-4638-B024-3E49E0396E60}" presName="rootText3" presStyleLbl="asst4" presStyleIdx="3" presStyleCnt="5" custScaleX="681007" custScaleY="151264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80719FF6-81F8-4854-A7E3-D4F8332219E6}" type="pres">
      <dgm:prSet presAssocID="{23B57F58-1B31-4638-B024-3E49E0396E60}" presName="rootConnector3" presStyleLbl="asst4" presStyleIdx="3" presStyleCnt="5"/>
      <dgm:spPr/>
      <dgm:t>
        <a:bodyPr/>
        <a:lstStyle/>
        <a:p>
          <a:endParaRPr lang="en-US"/>
        </a:p>
      </dgm:t>
    </dgm:pt>
    <dgm:pt modelId="{AA7A49F5-A3D4-4432-BDBF-D232F69097B8}" type="pres">
      <dgm:prSet presAssocID="{23B57F58-1B31-4638-B024-3E49E0396E60}" presName="hierChild6" presStyleCnt="0"/>
      <dgm:spPr/>
    </dgm:pt>
    <dgm:pt modelId="{4416E8AB-74E5-4756-A983-E7A4D5BBE377}" type="pres">
      <dgm:prSet presAssocID="{23B57F58-1B31-4638-B024-3E49E0396E60}" presName="hierChild7" presStyleCnt="0"/>
      <dgm:spPr/>
    </dgm:pt>
    <dgm:pt modelId="{8D2E6844-5B75-46B9-A1C3-BF09E5D4B7CC}" type="pres">
      <dgm:prSet presAssocID="{50E63AF7-6BBD-4A95-9588-2D4922A02307}" presName="hierChild5" presStyleCnt="0"/>
      <dgm:spPr/>
    </dgm:pt>
    <dgm:pt modelId="{C7AEA2F3-B44C-45DB-AE50-E08B980280F7}" type="pres">
      <dgm:prSet presAssocID="{C08D9A70-67FB-49D3-81B9-F4F99712157A}" presName="Name111" presStyleLbl="parChTrans1D4" presStyleIdx="10" presStyleCnt="12"/>
      <dgm:spPr/>
      <dgm:t>
        <a:bodyPr/>
        <a:lstStyle/>
        <a:p>
          <a:endParaRPr lang="en-US"/>
        </a:p>
      </dgm:t>
    </dgm:pt>
    <dgm:pt modelId="{E0598AAA-CAD0-4C19-AC08-9FCB9745A1E4}" type="pres">
      <dgm:prSet presAssocID="{21B9D424-B669-4390-8F72-BED741E11DDD}" presName="hierRoot3" presStyleCnt="0">
        <dgm:presLayoutVars>
          <dgm:hierBranch val="init"/>
        </dgm:presLayoutVars>
      </dgm:prSet>
      <dgm:spPr/>
    </dgm:pt>
    <dgm:pt modelId="{961DCD04-4CA5-4F19-BD84-FC044A1F5883}" type="pres">
      <dgm:prSet presAssocID="{21B9D424-B669-4390-8F72-BED741E11DDD}" presName="rootComposite3" presStyleCnt="0"/>
      <dgm:spPr/>
    </dgm:pt>
    <dgm:pt modelId="{06309ACB-14D0-4E5F-96AB-E1B92D1D10C1}" type="pres">
      <dgm:prSet presAssocID="{21B9D424-B669-4390-8F72-BED741E11DDD}" presName="rootText3" presStyleLbl="asst4" presStyleIdx="4" presStyleCnt="5" custScaleX="681007" custScaleY="266742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470EA609-7BFA-4E06-924F-F37F83EDE9C9}" type="pres">
      <dgm:prSet presAssocID="{21B9D424-B669-4390-8F72-BED741E11DDD}" presName="rootConnector3" presStyleLbl="asst4" presStyleIdx="4" presStyleCnt="5"/>
      <dgm:spPr/>
      <dgm:t>
        <a:bodyPr/>
        <a:lstStyle/>
        <a:p>
          <a:endParaRPr lang="en-US"/>
        </a:p>
      </dgm:t>
    </dgm:pt>
    <dgm:pt modelId="{29BF3374-7856-4A60-B406-EEF4933B102B}" type="pres">
      <dgm:prSet presAssocID="{21B9D424-B669-4390-8F72-BED741E11DDD}" presName="hierChild6" presStyleCnt="0"/>
      <dgm:spPr/>
    </dgm:pt>
    <dgm:pt modelId="{11B9C253-4CE2-45F2-B398-1B3240C0CA91}" type="pres">
      <dgm:prSet presAssocID="{21B9D424-B669-4390-8F72-BED741E11DDD}" presName="hierChild7" presStyleCnt="0"/>
      <dgm:spPr/>
    </dgm:pt>
    <dgm:pt modelId="{3EC7947E-707E-4518-93D2-AAEAC988AB35}" type="pres">
      <dgm:prSet presAssocID="{AE26EAF7-5BF4-42EB-92F1-66A6F28C0D38}" presName="hierChild5" presStyleCnt="0"/>
      <dgm:spPr/>
    </dgm:pt>
    <dgm:pt modelId="{A8F28E82-35A1-43F6-9BD3-9AA1AB5811B6}" type="pres">
      <dgm:prSet presAssocID="{F850A7DC-09B2-411D-953E-5B5E1A450098}" presName="Name111" presStyleLbl="parChTrans1D4" presStyleIdx="11" presStyleCnt="12"/>
      <dgm:spPr/>
      <dgm:t>
        <a:bodyPr/>
        <a:lstStyle/>
        <a:p>
          <a:endParaRPr lang="en-US"/>
        </a:p>
      </dgm:t>
    </dgm:pt>
    <dgm:pt modelId="{FE1ED44E-B2E2-4ED1-A95A-B790A51E6E8A}" type="pres">
      <dgm:prSet presAssocID="{179F4144-DCB3-481A-8760-AB47F499551C}" presName="hierRoot3" presStyleCnt="0">
        <dgm:presLayoutVars>
          <dgm:hierBranch val="init"/>
        </dgm:presLayoutVars>
      </dgm:prSet>
      <dgm:spPr/>
    </dgm:pt>
    <dgm:pt modelId="{11A1C705-AE8B-45C0-860C-BAEE60B19A45}" type="pres">
      <dgm:prSet presAssocID="{179F4144-DCB3-481A-8760-AB47F499551C}" presName="rootComposite3" presStyleCnt="0"/>
      <dgm:spPr/>
    </dgm:pt>
    <dgm:pt modelId="{7C84B838-1A68-4137-AC95-553678FAF3BB}" type="pres">
      <dgm:prSet presAssocID="{179F4144-DCB3-481A-8760-AB47F499551C}" presName="rootText3" presStyleLbl="asst3" presStyleIdx="0" presStyleCnt="1" custScaleX="681007" custScaleY="192997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27194D24-F300-452C-964A-9DA292AAB2EA}" type="pres">
      <dgm:prSet presAssocID="{179F4144-DCB3-481A-8760-AB47F499551C}" presName="rootConnector3" presStyleLbl="asst3" presStyleIdx="0" presStyleCnt="1"/>
      <dgm:spPr/>
      <dgm:t>
        <a:bodyPr/>
        <a:lstStyle/>
        <a:p>
          <a:endParaRPr lang="en-US"/>
        </a:p>
      </dgm:t>
    </dgm:pt>
    <dgm:pt modelId="{0800FE89-78F7-46F0-BB56-88B82F095810}" type="pres">
      <dgm:prSet presAssocID="{179F4144-DCB3-481A-8760-AB47F499551C}" presName="hierChild6" presStyleCnt="0"/>
      <dgm:spPr/>
    </dgm:pt>
    <dgm:pt modelId="{51DEF950-AB56-4BD7-88F3-D214E606176B}" type="pres">
      <dgm:prSet presAssocID="{179F4144-DCB3-481A-8760-AB47F499551C}" presName="hierChild7" presStyleCnt="0"/>
      <dgm:spPr/>
    </dgm:pt>
    <dgm:pt modelId="{B8AA073A-DF55-4886-806B-A19501B7D45D}" type="pres">
      <dgm:prSet presAssocID="{30EBEB49-9185-4367-BE27-32CD5A0191D6}" presName="hierChild5" presStyleCnt="0"/>
      <dgm:spPr/>
    </dgm:pt>
    <dgm:pt modelId="{65FCADAA-3F85-4C83-900C-D538276957EF}" type="pres">
      <dgm:prSet presAssocID="{F53E1CA3-B4B0-492B-9547-78FE4C905AE7}" presName="Name111" presStyleLbl="parChTrans1D3" presStyleIdx="1" presStyleCnt="2"/>
      <dgm:spPr/>
      <dgm:t>
        <a:bodyPr/>
        <a:lstStyle/>
        <a:p>
          <a:endParaRPr lang="en-US"/>
        </a:p>
      </dgm:t>
    </dgm:pt>
    <dgm:pt modelId="{1DD41069-EFB9-4C80-8DAB-D2B1CCEE8225}" type="pres">
      <dgm:prSet presAssocID="{63776243-3727-4304-80F7-AE3A96EBE3C4}" presName="hierRoot3" presStyleCnt="0">
        <dgm:presLayoutVars>
          <dgm:hierBranch val="init"/>
        </dgm:presLayoutVars>
      </dgm:prSet>
      <dgm:spPr/>
    </dgm:pt>
    <dgm:pt modelId="{E7DC0F47-CA63-42DD-8744-290626E39AE2}" type="pres">
      <dgm:prSet presAssocID="{63776243-3727-4304-80F7-AE3A96EBE3C4}" presName="rootComposite3" presStyleCnt="0"/>
      <dgm:spPr/>
    </dgm:pt>
    <dgm:pt modelId="{20AB0850-24A6-4544-9BC7-B0D14C292E39}" type="pres">
      <dgm:prSet presAssocID="{63776243-3727-4304-80F7-AE3A96EBE3C4}" presName="rootText3" presStyleLbl="asst2" presStyleIdx="0" presStyleCnt="1" custScaleX="681007" custScaleY="221727" custLinFactNeighborX="-96334">
        <dgm:presLayoutVars>
          <dgm:chPref val="3"/>
        </dgm:presLayoutVars>
      </dgm:prSet>
      <dgm:spPr/>
      <dgm:t>
        <a:bodyPr/>
        <a:lstStyle/>
        <a:p>
          <a:endParaRPr lang="en-US"/>
        </a:p>
      </dgm:t>
    </dgm:pt>
    <dgm:pt modelId="{E6257FB3-097F-40AE-B306-EC1E3394080B}" type="pres">
      <dgm:prSet presAssocID="{63776243-3727-4304-80F7-AE3A96EBE3C4}" presName="rootConnector3" presStyleLbl="asst2" presStyleIdx="0" presStyleCnt="1"/>
      <dgm:spPr/>
      <dgm:t>
        <a:bodyPr/>
        <a:lstStyle/>
        <a:p>
          <a:endParaRPr lang="en-US"/>
        </a:p>
      </dgm:t>
    </dgm:pt>
    <dgm:pt modelId="{93139419-E597-441B-AAD4-283F0B6CC2BB}" type="pres">
      <dgm:prSet presAssocID="{63776243-3727-4304-80F7-AE3A96EBE3C4}" presName="hierChild6" presStyleCnt="0"/>
      <dgm:spPr/>
    </dgm:pt>
    <dgm:pt modelId="{E03D1C91-8F0C-4E2F-8D40-57C6816E6773}" type="pres">
      <dgm:prSet presAssocID="{63776243-3727-4304-80F7-AE3A96EBE3C4}" presName="hierChild7" presStyleCnt="0"/>
      <dgm:spPr/>
    </dgm:pt>
    <dgm:pt modelId="{BD61099B-D08B-43BF-9287-6F344AF93E66}" type="pres">
      <dgm:prSet presAssocID="{7E099C14-93D6-491F-9E8C-32DC4FC4F976}" presName="hierChild3" presStyleCnt="0"/>
      <dgm:spPr/>
    </dgm:pt>
  </dgm:ptLst>
  <dgm:cxnLst>
    <dgm:cxn modelId="{A32114E8-AB11-4272-AB38-25837D8E496D}" type="presOf" srcId="{27568990-8594-43EE-BD59-20464603E34D}" destId="{9B3A1275-CAC7-4AFD-ACDE-DEDCDE911F13}" srcOrd="1" destOrd="0" presId="urn:microsoft.com/office/officeart/2005/8/layout/orgChart1"/>
    <dgm:cxn modelId="{C64CED89-90E6-43FA-9DD1-3D2933B9FDC4}" type="presOf" srcId="{147877A7-848B-4D29-AC0B-0898B164DC79}" destId="{E9B9B375-243B-43C0-AB17-CA88E082354E}" srcOrd="0" destOrd="0" presId="urn:microsoft.com/office/officeart/2005/8/layout/orgChart1"/>
    <dgm:cxn modelId="{86271EA6-6410-4C09-8B5A-B10FF9056E49}" type="presOf" srcId="{EEBEEE8C-07E1-4DFB-B65A-EF213958C368}" destId="{89BF4019-569B-4D46-B84E-1FD6F41C902C}" srcOrd="1" destOrd="0" presId="urn:microsoft.com/office/officeart/2005/8/layout/orgChart1"/>
    <dgm:cxn modelId="{3E0E25AC-1C0E-4B7F-A4FC-D1D58C816A48}" type="presOf" srcId="{5309080B-6865-42C2-A2D7-0115F241DF00}" destId="{FB7E3833-9C19-46A0-9A92-6F38FFC85039}" srcOrd="0" destOrd="0" presId="urn:microsoft.com/office/officeart/2005/8/layout/orgChart1"/>
    <dgm:cxn modelId="{3415CA9C-F9BD-4FA4-80A0-561B1F5B64F8}" srcId="{50E63AF7-6BBD-4A95-9588-2D4922A02307}" destId="{21B9D424-B669-4390-8F72-BED741E11DDD}" srcOrd="1" destOrd="0" parTransId="{C08D9A70-67FB-49D3-81B9-F4F99712157A}" sibTransId="{2A8695D6-FBB1-40F7-A532-2138068A2D5D}"/>
    <dgm:cxn modelId="{89C9B4DC-489A-4B11-8256-4F6937A34A35}" srcId="{30EBEB49-9185-4367-BE27-32CD5A0191D6}" destId="{63776243-3727-4304-80F7-AE3A96EBE3C4}" srcOrd="1" destOrd="0" parTransId="{F53E1CA3-B4B0-492B-9547-78FE4C905AE7}" sibTransId="{FBCD1DD2-4A7A-496A-9EED-389E0A1526FB}"/>
    <dgm:cxn modelId="{4A956295-D7AA-4465-96CD-BCAD910804C1}" srcId="{4B9DD132-064E-4130-AA26-2A893CB3956B}" destId="{7E099C14-93D6-491F-9E8C-32DC4FC4F976}" srcOrd="0" destOrd="0" parTransId="{02010345-7750-4E9D-9697-27CE4FEAF7D3}" sibTransId="{6781A97C-391C-467B-A9E0-6FA12238C1E7}"/>
    <dgm:cxn modelId="{96DFC50D-6458-49A7-ADDB-C1968CE0B4EB}" srcId="{183F33F1-BA65-43CB-9836-95C4F58C2E5A}" destId="{CF684B7D-C5E1-4A50-988C-916E87CEAE83}" srcOrd="0" destOrd="0" parTransId="{2618976A-03BA-4082-BDE7-A6D1691F1DC4}" sibTransId="{34E5C5AC-793F-4CA8-BF07-6C7446E5CCFB}"/>
    <dgm:cxn modelId="{EE81E33A-2291-403F-837A-5A3DB4FC1769}" type="presOf" srcId="{06B64C62-2D1B-4B3C-B4CB-36776F767BF3}" destId="{55B0D24A-FD7F-4D60-B5F9-C70D47E4349E}" srcOrd="1" destOrd="0" presId="urn:microsoft.com/office/officeart/2005/8/layout/orgChart1"/>
    <dgm:cxn modelId="{802E2728-B625-4B45-B37E-C0DA4816E409}" type="presOf" srcId="{6A6C0A6C-FA8B-4046-9A6E-BABB970C63BA}" destId="{6132DE44-9ECA-47B2-AD75-85A6A010FC4D}" srcOrd="0" destOrd="0" presId="urn:microsoft.com/office/officeart/2005/8/layout/orgChart1"/>
    <dgm:cxn modelId="{580E9EDD-6D23-4678-9B69-1030FD9473CC}" type="presOf" srcId="{30EBEB49-9185-4367-BE27-32CD5A0191D6}" destId="{E38B95A6-6623-484F-AC67-3FA1AA07853B}" srcOrd="0" destOrd="0" presId="urn:microsoft.com/office/officeart/2005/8/layout/orgChart1"/>
    <dgm:cxn modelId="{AF4F1FF6-7433-4EB1-A41A-D5265DAE3BA1}" type="presOf" srcId="{99FAD591-0AF3-4E25-A938-6FA91DB3C1AA}" destId="{3B48D2C8-A1D2-4BBF-A64A-AAD6A8E75BDE}" srcOrd="0" destOrd="0" presId="urn:microsoft.com/office/officeart/2005/8/layout/orgChart1"/>
    <dgm:cxn modelId="{7ECB9E36-BCEA-4070-9C02-F608B9BEA25E}" type="presOf" srcId="{27568990-8594-43EE-BD59-20464603E34D}" destId="{E0AC1C43-68C3-4F03-9C5C-C3BAD309D7B7}" srcOrd="0" destOrd="0" presId="urn:microsoft.com/office/officeart/2005/8/layout/orgChart1"/>
    <dgm:cxn modelId="{F9583132-DD35-46A5-B4EB-50B590FBB6BE}" type="presOf" srcId="{2334274E-576C-4FB9-81DB-A95E48E77BB8}" destId="{70601568-05B5-4DC1-BCD5-011FFBDC2219}" srcOrd="0" destOrd="0" presId="urn:microsoft.com/office/officeart/2005/8/layout/orgChart1"/>
    <dgm:cxn modelId="{718973D4-7CB2-4D01-AAD5-80D252C75949}" type="presOf" srcId="{245A5A4E-8B59-454F-94D8-2EE5BB68F38D}" destId="{2F281A03-08F4-4C67-B904-7FB33A589950}" srcOrd="0" destOrd="0" presId="urn:microsoft.com/office/officeart/2005/8/layout/orgChart1"/>
    <dgm:cxn modelId="{BF70B0FA-6D2A-42F1-9442-DEF141F278F9}" type="presOf" srcId="{06B64C62-2D1B-4B3C-B4CB-36776F767BF3}" destId="{C4992308-3022-43C8-8EF5-550E2758FE43}" srcOrd="0" destOrd="0" presId="urn:microsoft.com/office/officeart/2005/8/layout/orgChart1"/>
    <dgm:cxn modelId="{D759A640-8D4C-45A3-956F-A5EF1D3F72E3}" type="presOf" srcId="{1046AD8B-4D99-415B-9B14-74689DF64D90}" destId="{A610353B-487B-4D3B-B549-9C8168ACE54B}" srcOrd="1" destOrd="0" presId="urn:microsoft.com/office/officeart/2005/8/layout/orgChart1"/>
    <dgm:cxn modelId="{D9189DA9-2454-4F27-9673-C60880F1EB37}" type="presOf" srcId="{7BD8408E-3F24-43D7-848B-4689ADD09AAC}" destId="{4C4E53C1-EB55-45A9-9A0C-9DA14B00D2F3}" srcOrd="0" destOrd="0" presId="urn:microsoft.com/office/officeart/2005/8/layout/orgChart1"/>
    <dgm:cxn modelId="{7A7F578A-36CE-4848-AFC0-8C2DFD476B88}" type="presOf" srcId="{F850A7DC-09B2-411D-953E-5B5E1A450098}" destId="{A8F28E82-35A1-43F6-9BD3-9AA1AB5811B6}" srcOrd="0" destOrd="0" presId="urn:microsoft.com/office/officeart/2005/8/layout/orgChart1"/>
    <dgm:cxn modelId="{072F2B4B-364F-4F44-B9CF-5065521053A8}" type="presOf" srcId="{21B9D424-B669-4390-8F72-BED741E11DDD}" destId="{470EA609-7BFA-4E06-924F-F37F83EDE9C9}" srcOrd="1" destOrd="0" presId="urn:microsoft.com/office/officeart/2005/8/layout/orgChart1"/>
    <dgm:cxn modelId="{CB38F914-80A4-4D62-9E5F-7936363F142E}" type="presOf" srcId="{23B57F58-1B31-4638-B024-3E49E0396E60}" destId="{80719FF6-81F8-4854-A7E3-D4F8332219E6}" srcOrd="1" destOrd="0" presId="urn:microsoft.com/office/officeart/2005/8/layout/orgChart1"/>
    <dgm:cxn modelId="{1237DE29-FCAB-44DB-A516-CEF3AA01CED8}" type="presOf" srcId="{23B57F58-1B31-4638-B024-3E49E0396E60}" destId="{B426F62F-390E-492D-BC1D-BD154468C3AD}" srcOrd="0" destOrd="0" presId="urn:microsoft.com/office/officeart/2005/8/layout/orgChart1"/>
    <dgm:cxn modelId="{E999A008-5582-4623-A531-409975A799E2}" srcId="{50E63AF7-6BBD-4A95-9588-2D4922A02307}" destId="{147877A7-848B-4D29-AC0B-0898B164DC79}" srcOrd="0" destOrd="0" parTransId="{245A5A4E-8B59-454F-94D8-2EE5BB68F38D}" sibTransId="{D6324E60-7E32-4E08-A9C5-7005CCB9D9F3}"/>
    <dgm:cxn modelId="{63BE0ADB-62AC-4423-8CB2-9BC06EE1549F}" srcId="{147877A7-848B-4D29-AC0B-0898B164DC79}" destId="{27568990-8594-43EE-BD59-20464603E34D}" srcOrd="0" destOrd="0" parTransId="{F57039EE-DEA8-472F-8BCA-F387F3C4A87F}" sibTransId="{2C556C56-A559-4329-8B1F-C9DAFD91B46C}"/>
    <dgm:cxn modelId="{F67F0419-3548-4388-8901-175AD02D3BDC}" type="presOf" srcId="{2618976A-03BA-4082-BDE7-A6D1691F1DC4}" destId="{29C21FE1-B6ED-4A37-B462-2AB3364F71D0}" srcOrd="0" destOrd="0" presId="urn:microsoft.com/office/officeart/2005/8/layout/orgChart1"/>
    <dgm:cxn modelId="{9411AFCF-8145-4C44-8A0A-F32556A347CC}" type="presOf" srcId="{C08D9A70-67FB-49D3-81B9-F4F99712157A}" destId="{C7AEA2F3-B44C-45DB-AE50-E08B980280F7}" srcOrd="0" destOrd="0" presId="urn:microsoft.com/office/officeart/2005/8/layout/orgChart1"/>
    <dgm:cxn modelId="{350ED2C6-D70B-458A-946C-C801463D2EFA}" srcId="{147877A7-848B-4D29-AC0B-0898B164DC79}" destId="{23B57F58-1B31-4638-B024-3E49E0396E60}" srcOrd="1" destOrd="0" parTransId="{4CB58116-E357-4A0D-A82A-1ABCCC14B2BB}" sibTransId="{D0E59E68-A7C6-4181-8B9B-48B68FECB871}"/>
    <dgm:cxn modelId="{F8F42130-6F5E-4268-BD4C-3C11A63649C9}" type="presOf" srcId="{E72B805D-21CC-4B95-9B87-4852D37611F8}" destId="{00F1FCF2-CC58-42F1-87B1-8486ACB8A7A5}" srcOrd="1" destOrd="0" presId="urn:microsoft.com/office/officeart/2005/8/layout/orgChart1"/>
    <dgm:cxn modelId="{D2AD2B40-C909-4A3B-B1D1-CD56E08FE54F}" type="presOf" srcId="{1046AD8B-4D99-415B-9B14-74689DF64D90}" destId="{6F252BDA-768A-4210-BE51-DC46B35854BC}" srcOrd="0" destOrd="0" presId="urn:microsoft.com/office/officeart/2005/8/layout/orgChart1"/>
    <dgm:cxn modelId="{57E78D47-4125-49EA-970C-94BD085A3CCE}" type="presOf" srcId="{F57039EE-DEA8-472F-8BCA-F387F3C4A87F}" destId="{5B55021B-F6A8-4994-8164-4336A664D621}" srcOrd="0" destOrd="0" presId="urn:microsoft.com/office/officeart/2005/8/layout/orgChart1"/>
    <dgm:cxn modelId="{A96693CB-F8B2-405C-B77B-0DEBB745A39E}" type="presOf" srcId="{7E099C14-93D6-491F-9E8C-32DC4FC4F976}" destId="{82C47AC0-82CD-4F45-9AAE-F9F05AE84BD3}" srcOrd="1" destOrd="0" presId="urn:microsoft.com/office/officeart/2005/8/layout/orgChart1"/>
    <dgm:cxn modelId="{32C773F6-399A-4300-B90F-13AD77C89470}" type="presOf" srcId="{50E63AF7-6BBD-4A95-9588-2D4922A02307}" destId="{C6813EA7-DA57-4341-8D2A-524C42FEED56}" srcOrd="1" destOrd="0" presId="urn:microsoft.com/office/officeart/2005/8/layout/orgChart1"/>
    <dgm:cxn modelId="{2E956CCF-405A-4C28-854B-9AAB9F0981EB}" srcId="{AE26EAF7-5BF4-42EB-92F1-66A6F28C0D38}" destId="{179F4144-DCB3-481A-8760-AB47F499551C}" srcOrd="1" destOrd="0" parTransId="{F850A7DC-09B2-411D-953E-5B5E1A450098}" sibTransId="{E3BD84AB-3181-4A00-B649-D974B4FA8CCB}"/>
    <dgm:cxn modelId="{FDA3E19C-E7CB-42A7-B0A2-F9CC8BC74C68}" type="presOf" srcId="{EEBEEE8C-07E1-4DFB-B65A-EF213958C368}" destId="{A2D48AFA-835A-42D2-A17D-B4802F8A67A4}" srcOrd="0" destOrd="0" presId="urn:microsoft.com/office/officeart/2005/8/layout/orgChart1"/>
    <dgm:cxn modelId="{83FC4E63-D0FC-4C50-894A-A8828DB7C8FF}" type="presOf" srcId="{4110C564-743C-45CA-9BDA-5595D5563902}" destId="{1C4607AE-9127-4C60-8192-99F85D2263E4}" srcOrd="0" destOrd="0" presId="urn:microsoft.com/office/officeart/2005/8/layout/orgChart1"/>
    <dgm:cxn modelId="{A31D3996-2E19-4091-ACDC-B1BD22410A2A}" srcId="{27568990-8594-43EE-BD59-20464603E34D}" destId="{E72B805D-21CC-4B95-9B87-4852D37611F8}" srcOrd="1" destOrd="0" parTransId="{99FAD591-0AF3-4E25-A938-6FA91DB3C1AA}" sibTransId="{21EF47E5-8310-487C-A8DA-D09EA220523F}"/>
    <dgm:cxn modelId="{6DA1F2CE-7887-4517-B628-7EFD9FB05169}" type="presOf" srcId="{30EBEB49-9185-4367-BE27-32CD5A0191D6}" destId="{29945E00-3364-440F-9B4E-A582A727AB21}" srcOrd="1" destOrd="0" presId="urn:microsoft.com/office/officeart/2005/8/layout/orgChart1"/>
    <dgm:cxn modelId="{5A13204E-C9CF-4481-982B-823DAA2508A4}" type="presOf" srcId="{4CB58116-E357-4A0D-A82A-1ABCCC14B2BB}" destId="{A4169EFE-EE22-41EC-86BA-2B250D2ECC2F}" srcOrd="0" destOrd="0" presId="urn:microsoft.com/office/officeart/2005/8/layout/orgChart1"/>
    <dgm:cxn modelId="{7075A06C-D2ED-4312-B89B-DE781682419A}" type="presOf" srcId="{26DFCC3E-2E77-4BA3-AB4A-4F23137359B1}" destId="{5547A377-B232-4285-B4EE-75243809D23F}" srcOrd="0" destOrd="0" presId="urn:microsoft.com/office/officeart/2005/8/layout/orgChart1"/>
    <dgm:cxn modelId="{4F2DC056-AEC4-4DA4-A705-BE912CBA111A}" type="presOf" srcId="{AE26EAF7-5BF4-42EB-92F1-66A6F28C0D38}" destId="{12BD7DDA-D1BB-4FF4-8342-23B53D84EC6A}" srcOrd="0" destOrd="0" presId="urn:microsoft.com/office/officeart/2005/8/layout/orgChart1"/>
    <dgm:cxn modelId="{ABAA48A4-6BD8-4ADA-91A4-E4327573BAF8}" srcId="{30EBEB49-9185-4367-BE27-32CD5A0191D6}" destId="{AE26EAF7-5BF4-42EB-92F1-66A6F28C0D38}" srcOrd="0" destOrd="0" parTransId="{6A6C0A6C-FA8B-4046-9A6E-BABB970C63BA}" sibTransId="{3F07C414-3533-4813-BE51-98FFBCE7D3E6}"/>
    <dgm:cxn modelId="{AD72E676-E70C-4CAF-B42D-96EE68EE48F0}" type="presOf" srcId="{50E63AF7-6BBD-4A95-9588-2D4922A02307}" destId="{A1AB4BCC-C250-428E-A94F-1F38EC7E7CA4}" srcOrd="0" destOrd="0" presId="urn:microsoft.com/office/officeart/2005/8/layout/orgChart1"/>
    <dgm:cxn modelId="{63AB7EBD-8B1F-4F9E-A3FB-C3BF6AC4506B}" type="presOf" srcId="{183F33F1-BA65-43CB-9836-95C4F58C2E5A}" destId="{2355617B-E040-4542-A2D7-E7A3C5822DDF}" srcOrd="1" destOrd="0" presId="urn:microsoft.com/office/officeart/2005/8/layout/orgChart1"/>
    <dgm:cxn modelId="{F797817B-3707-4915-ACC8-9A66A7B2FC07}" srcId="{06B64C62-2D1B-4B3C-B4CB-36776F767BF3}" destId="{183F33F1-BA65-43CB-9836-95C4F58C2E5A}" srcOrd="0" destOrd="0" parTransId="{4A1A5591-00C8-4709-90E5-8E3779A0118D}" sibTransId="{45066345-0372-4BBB-A758-65897650D2EB}"/>
    <dgm:cxn modelId="{AC42A925-EDA7-43C0-86BE-0327FA0DD658}" type="presOf" srcId="{CF684B7D-C5E1-4A50-988C-916E87CEAE83}" destId="{DA2F4ACF-6C14-4DF7-A20F-96A538ED303C}" srcOrd="1" destOrd="0" presId="urn:microsoft.com/office/officeart/2005/8/layout/orgChart1"/>
    <dgm:cxn modelId="{598D5BFB-E3D2-4D1D-8A70-CCBB19ED73BE}" type="presOf" srcId="{147877A7-848B-4D29-AC0B-0898B164DC79}" destId="{67BA1CE8-17EC-4C8B-A5BE-5D084E4A2EF0}" srcOrd="1" destOrd="0" presId="urn:microsoft.com/office/officeart/2005/8/layout/orgChart1"/>
    <dgm:cxn modelId="{E4C0216B-C7C9-44FD-ACA6-A7EC32337064}" srcId="{AE26EAF7-5BF4-42EB-92F1-66A6F28C0D38}" destId="{50E63AF7-6BBD-4A95-9588-2D4922A02307}" srcOrd="0" destOrd="0" parTransId="{26DFCC3E-2E77-4BA3-AB4A-4F23137359B1}" sibTransId="{E07CEB10-DE2D-456F-9026-98DD7D7BFE09}"/>
    <dgm:cxn modelId="{C617135E-A3DE-44C9-A4D7-D7DCA24D80B6}" type="presOf" srcId="{183F33F1-BA65-43CB-9836-95C4F58C2E5A}" destId="{3E185FB1-90A9-437D-850B-C2C96FF3602F}" srcOrd="0" destOrd="0" presId="urn:microsoft.com/office/officeart/2005/8/layout/orgChart1"/>
    <dgm:cxn modelId="{92243400-0252-448F-9A69-E56C990AA457}" type="presOf" srcId="{179F4144-DCB3-481A-8760-AB47F499551C}" destId="{27194D24-F300-452C-964A-9DA292AAB2EA}" srcOrd="1" destOrd="0" presId="urn:microsoft.com/office/officeart/2005/8/layout/orgChart1"/>
    <dgm:cxn modelId="{D39766F6-C16F-4D9E-957A-62C96D74A064}" srcId="{27568990-8594-43EE-BD59-20464603E34D}" destId="{06B64C62-2D1B-4B3C-B4CB-36776F767BF3}" srcOrd="0" destOrd="0" parTransId="{5309080B-6865-42C2-A2D7-0115F241DF00}" sibTransId="{2C2F0A77-968D-479D-A430-E87F57F8BE2D}"/>
    <dgm:cxn modelId="{07EA22D5-DDF2-4E01-9BB0-CCC920AFB11F}" srcId="{06B64C62-2D1B-4B3C-B4CB-36776F767BF3}" destId="{EEBEEE8C-07E1-4DFB-B65A-EF213958C368}" srcOrd="1" destOrd="0" parTransId="{2334274E-576C-4FB9-81DB-A95E48E77BB8}" sibTransId="{AA0C43F0-25EF-4187-820A-E67419EFDCDB}"/>
    <dgm:cxn modelId="{6302D2C3-145C-45F3-95B1-ED7280DC58A9}" type="presOf" srcId="{63776243-3727-4304-80F7-AE3A96EBE3C4}" destId="{20AB0850-24A6-4544-9BC7-B0D14C292E39}" srcOrd="0" destOrd="0" presId="urn:microsoft.com/office/officeart/2005/8/layout/orgChart1"/>
    <dgm:cxn modelId="{A033BF16-DC6B-4651-A45A-9CA3E6DB1771}" type="presOf" srcId="{63776243-3727-4304-80F7-AE3A96EBE3C4}" destId="{E6257FB3-097F-40AE-B306-EC1E3394080B}" srcOrd="1" destOrd="0" presId="urn:microsoft.com/office/officeart/2005/8/layout/orgChart1"/>
    <dgm:cxn modelId="{26934BEF-0BF7-4F9D-A16B-258C85C0FC1F}" type="presOf" srcId="{7E099C14-93D6-491F-9E8C-32DC4FC4F976}" destId="{D0948DE4-96CE-40F4-ABC7-147E84CF7ECA}" srcOrd="0" destOrd="0" presId="urn:microsoft.com/office/officeart/2005/8/layout/orgChart1"/>
    <dgm:cxn modelId="{F64358F7-6FDA-4D3A-BB6A-9CBCCB5F8F60}" type="presOf" srcId="{E72B805D-21CC-4B95-9B87-4852D37611F8}" destId="{01264203-9E7F-4345-A1A4-0B833DE16E0D}" srcOrd="0" destOrd="0" presId="urn:microsoft.com/office/officeart/2005/8/layout/orgChart1"/>
    <dgm:cxn modelId="{96458D1F-AA00-4076-B95A-F5F682307DD8}" type="presOf" srcId="{AE26EAF7-5BF4-42EB-92F1-66A6F28C0D38}" destId="{408D7198-6022-44C2-869C-F31346916F48}" srcOrd="1" destOrd="0" presId="urn:microsoft.com/office/officeart/2005/8/layout/orgChart1"/>
    <dgm:cxn modelId="{306C5D5A-12D1-4AA6-BB81-3BD18AD93FFE}" srcId="{7E099C14-93D6-491F-9E8C-32DC4FC4F976}" destId="{30EBEB49-9185-4367-BE27-32CD5A0191D6}" srcOrd="0" destOrd="0" parTransId="{7BD8408E-3F24-43D7-848B-4689ADD09AAC}" sibTransId="{03E277A8-220D-456E-A1D5-D0CAC015AB9F}"/>
    <dgm:cxn modelId="{514484D1-31DA-4A92-9A5E-BA5E858E2F48}" type="presOf" srcId="{4B9DD132-064E-4130-AA26-2A893CB3956B}" destId="{D0AB1E91-B690-44C9-8300-34A34223F069}" srcOrd="0" destOrd="0" presId="urn:microsoft.com/office/officeart/2005/8/layout/orgChart1"/>
    <dgm:cxn modelId="{469D2EA3-A281-4B12-9774-D197B7FA6246}" type="presOf" srcId="{21B9D424-B669-4390-8F72-BED741E11DDD}" destId="{06309ACB-14D0-4E5F-96AB-E1B92D1D10C1}" srcOrd="0" destOrd="0" presId="urn:microsoft.com/office/officeart/2005/8/layout/orgChart1"/>
    <dgm:cxn modelId="{71A098BC-AAB2-4B4E-BF80-65F7CD63974A}" srcId="{183F33F1-BA65-43CB-9836-95C4F58C2E5A}" destId="{1046AD8B-4D99-415B-9B14-74689DF64D90}" srcOrd="1" destOrd="0" parTransId="{4110C564-743C-45CA-9BDA-5595D5563902}" sibTransId="{2FBFC805-B844-46F3-BD2A-1671E0E18282}"/>
    <dgm:cxn modelId="{DBF6A855-936E-4B66-8FB7-A936C8943802}" type="presOf" srcId="{4A1A5591-00C8-4709-90E5-8E3779A0118D}" destId="{F0190C39-547E-4B89-B648-F08C6C2F66F2}" srcOrd="0" destOrd="0" presId="urn:microsoft.com/office/officeart/2005/8/layout/orgChart1"/>
    <dgm:cxn modelId="{B3229663-33DA-4CEF-BE02-1861FEBD1376}" type="presOf" srcId="{CF684B7D-C5E1-4A50-988C-916E87CEAE83}" destId="{2971916A-BFEB-44DC-A717-D00C519E9A59}" srcOrd="0" destOrd="0" presId="urn:microsoft.com/office/officeart/2005/8/layout/orgChart1"/>
    <dgm:cxn modelId="{68D78AA9-B906-413F-84D5-D963B783716E}" type="presOf" srcId="{F53E1CA3-B4B0-492B-9547-78FE4C905AE7}" destId="{65FCADAA-3F85-4C83-900C-D538276957EF}" srcOrd="0" destOrd="0" presId="urn:microsoft.com/office/officeart/2005/8/layout/orgChart1"/>
    <dgm:cxn modelId="{D2243547-FBB9-4B98-B698-D16EA2FD04B2}" type="presOf" srcId="{179F4144-DCB3-481A-8760-AB47F499551C}" destId="{7C84B838-1A68-4137-AC95-553678FAF3BB}" srcOrd="0" destOrd="0" presId="urn:microsoft.com/office/officeart/2005/8/layout/orgChart1"/>
    <dgm:cxn modelId="{3D6FCCD9-D0C5-406B-B60E-0AC4EC760A88}" type="presParOf" srcId="{D0AB1E91-B690-44C9-8300-34A34223F069}" destId="{E9C0A15B-08F5-45AB-AE40-50B104EF8824}" srcOrd="0" destOrd="0" presId="urn:microsoft.com/office/officeart/2005/8/layout/orgChart1"/>
    <dgm:cxn modelId="{136DE420-5D20-468E-BB88-B8BB47891F5E}" type="presParOf" srcId="{E9C0A15B-08F5-45AB-AE40-50B104EF8824}" destId="{C2EC1000-34A7-42BD-B9EE-DC9FC5B3FC84}" srcOrd="0" destOrd="0" presId="urn:microsoft.com/office/officeart/2005/8/layout/orgChart1"/>
    <dgm:cxn modelId="{F04736EF-ECA1-4D1E-A9E6-7D9C4F982929}" type="presParOf" srcId="{C2EC1000-34A7-42BD-B9EE-DC9FC5B3FC84}" destId="{D0948DE4-96CE-40F4-ABC7-147E84CF7ECA}" srcOrd="0" destOrd="0" presId="urn:microsoft.com/office/officeart/2005/8/layout/orgChart1"/>
    <dgm:cxn modelId="{CC9B53FA-5389-4917-A6D9-6927D1250200}" type="presParOf" srcId="{C2EC1000-34A7-42BD-B9EE-DC9FC5B3FC84}" destId="{82C47AC0-82CD-4F45-9AAE-F9F05AE84BD3}" srcOrd="1" destOrd="0" presId="urn:microsoft.com/office/officeart/2005/8/layout/orgChart1"/>
    <dgm:cxn modelId="{8C781B36-5C62-4ED5-B46A-C336BD1F664C}" type="presParOf" srcId="{E9C0A15B-08F5-45AB-AE40-50B104EF8824}" destId="{6569A100-808C-420D-8846-DC101D1FCA94}" srcOrd="1" destOrd="0" presId="urn:microsoft.com/office/officeart/2005/8/layout/orgChart1"/>
    <dgm:cxn modelId="{3B49C057-05EF-4DED-9DA3-42E2B175C164}" type="presParOf" srcId="{6569A100-808C-420D-8846-DC101D1FCA94}" destId="{4C4E53C1-EB55-45A9-9A0C-9DA14B00D2F3}" srcOrd="0" destOrd="0" presId="urn:microsoft.com/office/officeart/2005/8/layout/orgChart1"/>
    <dgm:cxn modelId="{EFD5B057-4046-46C6-90AC-CC4E60C51017}" type="presParOf" srcId="{6569A100-808C-420D-8846-DC101D1FCA94}" destId="{A7C27564-4010-422D-8733-D45402B36FD6}" srcOrd="1" destOrd="0" presId="urn:microsoft.com/office/officeart/2005/8/layout/orgChart1"/>
    <dgm:cxn modelId="{247DE621-6DBC-4141-885D-379FA5CCBDFC}" type="presParOf" srcId="{A7C27564-4010-422D-8733-D45402B36FD6}" destId="{78023387-3D9B-437A-9E82-943D893DC85E}" srcOrd="0" destOrd="0" presId="urn:microsoft.com/office/officeart/2005/8/layout/orgChart1"/>
    <dgm:cxn modelId="{8C977363-7D3B-46BF-8DCD-D4E3BDB9B275}" type="presParOf" srcId="{78023387-3D9B-437A-9E82-943D893DC85E}" destId="{E38B95A6-6623-484F-AC67-3FA1AA07853B}" srcOrd="0" destOrd="0" presId="urn:microsoft.com/office/officeart/2005/8/layout/orgChart1"/>
    <dgm:cxn modelId="{DF645BE4-B2D2-4DD3-B9A8-F140F4C8A2BE}" type="presParOf" srcId="{78023387-3D9B-437A-9E82-943D893DC85E}" destId="{29945E00-3364-440F-9B4E-A582A727AB21}" srcOrd="1" destOrd="0" presId="urn:microsoft.com/office/officeart/2005/8/layout/orgChart1"/>
    <dgm:cxn modelId="{292F9B53-7DCA-46DC-8E4F-F65E76B6083B}" type="presParOf" srcId="{A7C27564-4010-422D-8733-D45402B36FD6}" destId="{153551BC-D4DE-4C18-B7A8-5127B716297E}" srcOrd="1" destOrd="0" presId="urn:microsoft.com/office/officeart/2005/8/layout/orgChart1"/>
    <dgm:cxn modelId="{C388A10E-C3E1-4FB1-81B1-6C5B8F317438}" type="presParOf" srcId="{153551BC-D4DE-4C18-B7A8-5127B716297E}" destId="{6132DE44-9ECA-47B2-AD75-85A6A010FC4D}" srcOrd="0" destOrd="0" presId="urn:microsoft.com/office/officeart/2005/8/layout/orgChart1"/>
    <dgm:cxn modelId="{3A8F6E79-E1D0-4EDF-93F8-BF42DFAC9265}" type="presParOf" srcId="{153551BC-D4DE-4C18-B7A8-5127B716297E}" destId="{62D2C5AE-FFB0-4BFA-B644-64EACE25F2B3}" srcOrd="1" destOrd="0" presId="urn:microsoft.com/office/officeart/2005/8/layout/orgChart1"/>
    <dgm:cxn modelId="{7D7BAC13-EE6C-4E6A-AA04-9013B2848580}" type="presParOf" srcId="{62D2C5AE-FFB0-4BFA-B644-64EACE25F2B3}" destId="{AF41D9D0-4667-46A5-896B-3811539CBE6B}" srcOrd="0" destOrd="0" presId="urn:microsoft.com/office/officeart/2005/8/layout/orgChart1"/>
    <dgm:cxn modelId="{E6E840AE-8B29-4755-A4B7-58A540FC6424}" type="presParOf" srcId="{AF41D9D0-4667-46A5-896B-3811539CBE6B}" destId="{12BD7DDA-D1BB-4FF4-8342-23B53D84EC6A}" srcOrd="0" destOrd="0" presId="urn:microsoft.com/office/officeart/2005/8/layout/orgChart1"/>
    <dgm:cxn modelId="{3FDD8807-923A-4C87-BA0A-41C8B6025FFD}" type="presParOf" srcId="{AF41D9D0-4667-46A5-896B-3811539CBE6B}" destId="{408D7198-6022-44C2-869C-F31346916F48}" srcOrd="1" destOrd="0" presId="urn:microsoft.com/office/officeart/2005/8/layout/orgChart1"/>
    <dgm:cxn modelId="{1BC63B57-95D9-4ABD-A21D-372DF82E4E92}" type="presParOf" srcId="{62D2C5AE-FFB0-4BFA-B644-64EACE25F2B3}" destId="{EB4F3260-6D99-4847-99BF-BBF0FE9BFDFD}" srcOrd="1" destOrd="0" presId="urn:microsoft.com/office/officeart/2005/8/layout/orgChart1"/>
    <dgm:cxn modelId="{ED5FA9D8-279E-4C5B-A585-F2733BB89FEF}" type="presParOf" srcId="{EB4F3260-6D99-4847-99BF-BBF0FE9BFDFD}" destId="{5547A377-B232-4285-B4EE-75243809D23F}" srcOrd="0" destOrd="0" presId="urn:microsoft.com/office/officeart/2005/8/layout/orgChart1"/>
    <dgm:cxn modelId="{2E4BF0CC-67E2-4245-B287-7FF2E5742EB2}" type="presParOf" srcId="{EB4F3260-6D99-4847-99BF-BBF0FE9BFDFD}" destId="{1183E0B9-5315-4455-8FA9-13A9719D8B62}" srcOrd="1" destOrd="0" presId="urn:microsoft.com/office/officeart/2005/8/layout/orgChart1"/>
    <dgm:cxn modelId="{09152D47-26D1-4B53-B5D3-13C5A9388EE6}" type="presParOf" srcId="{1183E0B9-5315-4455-8FA9-13A9719D8B62}" destId="{112EC6FD-33FD-41B4-9495-A3412CC3CAA7}" srcOrd="0" destOrd="0" presId="urn:microsoft.com/office/officeart/2005/8/layout/orgChart1"/>
    <dgm:cxn modelId="{578D8FD0-3E50-4B5C-BB3D-B782030F729A}" type="presParOf" srcId="{112EC6FD-33FD-41B4-9495-A3412CC3CAA7}" destId="{A1AB4BCC-C250-428E-A94F-1F38EC7E7CA4}" srcOrd="0" destOrd="0" presId="urn:microsoft.com/office/officeart/2005/8/layout/orgChart1"/>
    <dgm:cxn modelId="{8174C7E4-A865-4DB3-9319-BE82BA1B08FB}" type="presParOf" srcId="{112EC6FD-33FD-41B4-9495-A3412CC3CAA7}" destId="{C6813EA7-DA57-4341-8D2A-524C42FEED56}" srcOrd="1" destOrd="0" presId="urn:microsoft.com/office/officeart/2005/8/layout/orgChart1"/>
    <dgm:cxn modelId="{68F52543-35C2-4571-87E1-B5788B7527A4}" type="presParOf" srcId="{1183E0B9-5315-4455-8FA9-13A9719D8B62}" destId="{F37DC6BB-146C-4A92-842B-B863CC3F4B19}" srcOrd="1" destOrd="0" presId="urn:microsoft.com/office/officeart/2005/8/layout/orgChart1"/>
    <dgm:cxn modelId="{190F219F-828B-4F07-96DF-220A0EA2D0BF}" type="presParOf" srcId="{F37DC6BB-146C-4A92-842B-B863CC3F4B19}" destId="{2F281A03-08F4-4C67-B904-7FB33A589950}" srcOrd="0" destOrd="0" presId="urn:microsoft.com/office/officeart/2005/8/layout/orgChart1"/>
    <dgm:cxn modelId="{796FF4BA-98F5-4AE7-AA86-C64BCE1A846E}" type="presParOf" srcId="{F37DC6BB-146C-4A92-842B-B863CC3F4B19}" destId="{D18821A5-3DBF-4DA6-B1FC-A79892BF0B6F}" srcOrd="1" destOrd="0" presId="urn:microsoft.com/office/officeart/2005/8/layout/orgChart1"/>
    <dgm:cxn modelId="{70F2ADA0-5444-4184-8053-67CD4A6E2EEC}" type="presParOf" srcId="{D18821A5-3DBF-4DA6-B1FC-A79892BF0B6F}" destId="{9AEA714A-8B1D-47AA-B6CD-383039D4079D}" srcOrd="0" destOrd="0" presId="urn:microsoft.com/office/officeart/2005/8/layout/orgChart1"/>
    <dgm:cxn modelId="{58991070-CB22-46D6-B1EB-22D7040C7226}" type="presParOf" srcId="{9AEA714A-8B1D-47AA-B6CD-383039D4079D}" destId="{E9B9B375-243B-43C0-AB17-CA88E082354E}" srcOrd="0" destOrd="0" presId="urn:microsoft.com/office/officeart/2005/8/layout/orgChart1"/>
    <dgm:cxn modelId="{E1123C8E-BA8E-4A6F-8BC9-4ECE60FDA579}" type="presParOf" srcId="{9AEA714A-8B1D-47AA-B6CD-383039D4079D}" destId="{67BA1CE8-17EC-4C8B-A5BE-5D084E4A2EF0}" srcOrd="1" destOrd="0" presId="urn:microsoft.com/office/officeart/2005/8/layout/orgChart1"/>
    <dgm:cxn modelId="{1E7BE4D9-92E6-4E36-82B6-E25B27602D06}" type="presParOf" srcId="{D18821A5-3DBF-4DA6-B1FC-A79892BF0B6F}" destId="{A3B38350-AEB8-41B7-B999-30E6A70D7454}" srcOrd="1" destOrd="0" presId="urn:microsoft.com/office/officeart/2005/8/layout/orgChart1"/>
    <dgm:cxn modelId="{790D1FD5-CFC0-478A-8F57-4F9983BDCE58}" type="presParOf" srcId="{A3B38350-AEB8-41B7-B999-30E6A70D7454}" destId="{5B55021B-F6A8-4994-8164-4336A664D621}" srcOrd="0" destOrd="0" presId="urn:microsoft.com/office/officeart/2005/8/layout/orgChart1"/>
    <dgm:cxn modelId="{F177C1AB-C0B1-4FBD-A041-8CBEE052D56E}" type="presParOf" srcId="{A3B38350-AEB8-41B7-B999-30E6A70D7454}" destId="{6DEB88B3-DF98-4F7C-BB45-98784BC6BE0A}" srcOrd="1" destOrd="0" presId="urn:microsoft.com/office/officeart/2005/8/layout/orgChart1"/>
    <dgm:cxn modelId="{E51C740F-E9C5-4415-A4B2-0663F2CABF7C}" type="presParOf" srcId="{6DEB88B3-DF98-4F7C-BB45-98784BC6BE0A}" destId="{983D766E-4B96-4588-BF84-9B3181B089EA}" srcOrd="0" destOrd="0" presId="urn:microsoft.com/office/officeart/2005/8/layout/orgChart1"/>
    <dgm:cxn modelId="{799EEC5D-F53B-4112-9238-AC08033E8F3A}" type="presParOf" srcId="{983D766E-4B96-4588-BF84-9B3181B089EA}" destId="{E0AC1C43-68C3-4F03-9C5C-C3BAD309D7B7}" srcOrd="0" destOrd="0" presId="urn:microsoft.com/office/officeart/2005/8/layout/orgChart1"/>
    <dgm:cxn modelId="{916569B6-CBB1-4579-99BD-095AA3AC9EC2}" type="presParOf" srcId="{983D766E-4B96-4588-BF84-9B3181B089EA}" destId="{9B3A1275-CAC7-4AFD-ACDE-DEDCDE911F13}" srcOrd="1" destOrd="0" presId="urn:microsoft.com/office/officeart/2005/8/layout/orgChart1"/>
    <dgm:cxn modelId="{92CB9636-3462-4969-9C55-B10F67CE9C9A}" type="presParOf" srcId="{6DEB88B3-DF98-4F7C-BB45-98784BC6BE0A}" destId="{B50A1B66-654C-4815-A4F5-61A4860A8631}" srcOrd="1" destOrd="0" presId="urn:microsoft.com/office/officeart/2005/8/layout/orgChart1"/>
    <dgm:cxn modelId="{D698F323-DDFC-4A65-B0BB-91B28AE6F54B}" type="presParOf" srcId="{B50A1B66-654C-4815-A4F5-61A4860A8631}" destId="{FB7E3833-9C19-46A0-9A92-6F38FFC85039}" srcOrd="0" destOrd="0" presId="urn:microsoft.com/office/officeart/2005/8/layout/orgChart1"/>
    <dgm:cxn modelId="{47E0E812-479A-464A-99EE-F2A5ECD72283}" type="presParOf" srcId="{B50A1B66-654C-4815-A4F5-61A4860A8631}" destId="{A806BAB3-CC6D-49EB-81C2-EA3A60D814A7}" srcOrd="1" destOrd="0" presId="urn:microsoft.com/office/officeart/2005/8/layout/orgChart1"/>
    <dgm:cxn modelId="{CAED15D2-7F0D-47C8-B2C0-9882BE7531DE}" type="presParOf" srcId="{A806BAB3-CC6D-49EB-81C2-EA3A60D814A7}" destId="{0F8BEC4F-1EAD-441F-A8C9-4EF7E38EDFF5}" srcOrd="0" destOrd="0" presId="urn:microsoft.com/office/officeart/2005/8/layout/orgChart1"/>
    <dgm:cxn modelId="{6E0065F6-8BEC-4D46-A8F6-78FD0E3D1A0A}" type="presParOf" srcId="{0F8BEC4F-1EAD-441F-A8C9-4EF7E38EDFF5}" destId="{C4992308-3022-43C8-8EF5-550E2758FE43}" srcOrd="0" destOrd="0" presId="urn:microsoft.com/office/officeart/2005/8/layout/orgChart1"/>
    <dgm:cxn modelId="{E58FAEC2-60DD-4F0B-BE7D-17AFC27C2F71}" type="presParOf" srcId="{0F8BEC4F-1EAD-441F-A8C9-4EF7E38EDFF5}" destId="{55B0D24A-FD7F-4D60-B5F9-C70D47E4349E}" srcOrd="1" destOrd="0" presId="urn:microsoft.com/office/officeart/2005/8/layout/orgChart1"/>
    <dgm:cxn modelId="{1FE5713B-7659-4071-B813-AA0EC59CFD43}" type="presParOf" srcId="{A806BAB3-CC6D-49EB-81C2-EA3A60D814A7}" destId="{ECD706E3-40E7-4F01-AF58-EF7A19699BA5}" srcOrd="1" destOrd="0" presId="urn:microsoft.com/office/officeart/2005/8/layout/orgChart1"/>
    <dgm:cxn modelId="{D81955D5-4224-4217-BB4A-4B42C8CF70F7}" type="presParOf" srcId="{ECD706E3-40E7-4F01-AF58-EF7A19699BA5}" destId="{F0190C39-547E-4B89-B648-F08C6C2F66F2}" srcOrd="0" destOrd="0" presId="urn:microsoft.com/office/officeart/2005/8/layout/orgChart1"/>
    <dgm:cxn modelId="{7D208B32-141E-4DB5-8727-D6F9ACB1DD41}" type="presParOf" srcId="{ECD706E3-40E7-4F01-AF58-EF7A19699BA5}" destId="{D9C7D02A-0F5C-49D0-8C51-702EA2A83559}" srcOrd="1" destOrd="0" presId="urn:microsoft.com/office/officeart/2005/8/layout/orgChart1"/>
    <dgm:cxn modelId="{4F0A6DAB-C0CC-477D-BD41-51D33D770AEB}" type="presParOf" srcId="{D9C7D02A-0F5C-49D0-8C51-702EA2A83559}" destId="{46A5B192-7700-4B2B-9F65-EF1F11E93386}" srcOrd="0" destOrd="0" presId="urn:microsoft.com/office/officeart/2005/8/layout/orgChart1"/>
    <dgm:cxn modelId="{2235EC3D-A91D-4506-824C-1165A76D6B47}" type="presParOf" srcId="{46A5B192-7700-4B2B-9F65-EF1F11E93386}" destId="{3E185FB1-90A9-437D-850B-C2C96FF3602F}" srcOrd="0" destOrd="0" presId="urn:microsoft.com/office/officeart/2005/8/layout/orgChart1"/>
    <dgm:cxn modelId="{73367B2B-4493-405E-92DB-F7CEC0EEB477}" type="presParOf" srcId="{46A5B192-7700-4B2B-9F65-EF1F11E93386}" destId="{2355617B-E040-4542-A2D7-E7A3C5822DDF}" srcOrd="1" destOrd="0" presId="urn:microsoft.com/office/officeart/2005/8/layout/orgChart1"/>
    <dgm:cxn modelId="{E0125D61-1134-4EB8-AF5E-1F4906FD39E0}" type="presParOf" srcId="{D9C7D02A-0F5C-49D0-8C51-702EA2A83559}" destId="{E37592DD-442F-4E7D-A48D-F8386311B5EB}" srcOrd="1" destOrd="0" presId="urn:microsoft.com/office/officeart/2005/8/layout/orgChart1"/>
    <dgm:cxn modelId="{AF4C424A-9C07-4E9E-BE98-CA13168C9233}" type="presParOf" srcId="{E37592DD-442F-4E7D-A48D-F8386311B5EB}" destId="{29C21FE1-B6ED-4A37-B462-2AB3364F71D0}" srcOrd="0" destOrd="0" presId="urn:microsoft.com/office/officeart/2005/8/layout/orgChart1"/>
    <dgm:cxn modelId="{6813CD65-FE9C-478D-9311-250AFC7D894F}" type="presParOf" srcId="{E37592DD-442F-4E7D-A48D-F8386311B5EB}" destId="{B5751F6B-2FC0-4461-9202-EC1FFC1BB83B}" srcOrd="1" destOrd="0" presId="urn:microsoft.com/office/officeart/2005/8/layout/orgChart1"/>
    <dgm:cxn modelId="{8A65713A-4A86-40BE-A15E-52DEDAB6BE50}" type="presParOf" srcId="{B5751F6B-2FC0-4461-9202-EC1FFC1BB83B}" destId="{9883E3ED-F315-45F3-886E-E6D8EA46A73A}" srcOrd="0" destOrd="0" presId="urn:microsoft.com/office/officeart/2005/8/layout/orgChart1"/>
    <dgm:cxn modelId="{05E38C6F-530A-46E2-ABBE-FD099EF9C844}" type="presParOf" srcId="{9883E3ED-F315-45F3-886E-E6D8EA46A73A}" destId="{2971916A-BFEB-44DC-A717-D00C519E9A59}" srcOrd="0" destOrd="0" presId="urn:microsoft.com/office/officeart/2005/8/layout/orgChart1"/>
    <dgm:cxn modelId="{14A0948E-CA33-4D50-AF68-E73F36839F1B}" type="presParOf" srcId="{9883E3ED-F315-45F3-886E-E6D8EA46A73A}" destId="{DA2F4ACF-6C14-4DF7-A20F-96A538ED303C}" srcOrd="1" destOrd="0" presId="urn:microsoft.com/office/officeart/2005/8/layout/orgChart1"/>
    <dgm:cxn modelId="{3CAB9222-65C9-482E-B429-A542683BE046}" type="presParOf" srcId="{B5751F6B-2FC0-4461-9202-EC1FFC1BB83B}" destId="{E57B0BA7-3DE9-4E0F-B080-5233355F6BF6}" srcOrd="1" destOrd="0" presId="urn:microsoft.com/office/officeart/2005/8/layout/orgChart1"/>
    <dgm:cxn modelId="{97074D79-2C19-445C-AD2E-2F52EF504793}" type="presParOf" srcId="{B5751F6B-2FC0-4461-9202-EC1FFC1BB83B}" destId="{10307762-6315-424F-B934-8DE34AA04EAF}" srcOrd="2" destOrd="0" presId="urn:microsoft.com/office/officeart/2005/8/layout/orgChart1"/>
    <dgm:cxn modelId="{0D18353F-9402-4022-B0AE-57F3C575EF24}" type="presParOf" srcId="{D9C7D02A-0F5C-49D0-8C51-702EA2A83559}" destId="{120F3428-41E0-483B-935E-2377D00AA10F}" srcOrd="2" destOrd="0" presId="urn:microsoft.com/office/officeart/2005/8/layout/orgChart1"/>
    <dgm:cxn modelId="{CD31F205-0FBF-45A2-844F-5A5D45A3645F}" type="presParOf" srcId="{120F3428-41E0-483B-935E-2377D00AA10F}" destId="{1C4607AE-9127-4C60-8192-99F85D2263E4}" srcOrd="0" destOrd="0" presId="urn:microsoft.com/office/officeart/2005/8/layout/orgChart1"/>
    <dgm:cxn modelId="{3196DFB0-2130-4E2A-935A-4FCBABE9044E}" type="presParOf" srcId="{120F3428-41E0-483B-935E-2377D00AA10F}" destId="{8C71EC6A-4A0B-41D4-B3D9-4B3E6422C3AD}" srcOrd="1" destOrd="0" presId="urn:microsoft.com/office/officeart/2005/8/layout/orgChart1"/>
    <dgm:cxn modelId="{4E0B12DF-9651-4C01-9501-DB46CB673764}" type="presParOf" srcId="{8C71EC6A-4A0B-41D4-B3D9-4B3E6422C3AD}" destId="{CA65F4BB-23DE-4248-91BD-833F84A21F69}" srcOrd="0" destOrd="0" presId="urn:microsoft.com/office/officeart/2005/8/layout/orgChart1"/>
    <dgm:cxn modelId="{0401CF93-9D61-4AC5-98E9-0794D37BE99D}" type="presParOf" srcId="{CA65F4BB-23DE-4248-91BD-833F84A21F69}" destId="{6F252BDA-768A-4210-BE51-DC46B35854BC}" srcOrd="0" destOrd="0" presId="urn:microsoft.com/office/officeart/2005/8/layout/orgChart1"/>
    <dgm:cxn modelId="{15746710-BDDE-4478-A2F4-905657D41A65}" type="presParOf" srcId="{CA65F4BB-23DE-4248-91BD-833F84A21F69}" destId="{A610353B-487B-4D3B-B549-9C8168ACE54B}" srcOrd="1" destOrd="0" presId="urn:microsoft.com/office/officeart/2005/8/layout/orgChart1"/>
    <dgm:cxn modelId="{65AE447C-4B98-4D73-B42D-D7885D86885B}" type="presParOf" srcId="{8C71EC6A-4A0B-41D4-B3D9-4B3E6422C3AD}" destId="{3D4C655F-7C64-4A71-A4E4-FAD9DBD85574}" srcOrd="1" destOrd="0" presId="urn:microsoft.com/office/officeart/2005/8/layout/orgChart1"/>
    <dgm:cxn modelId="{28096985-DD9D-4E1B-98D3-868897BD9D98}" type="presParOf" srcId="{8C71EC6A-4A0B-41D4-B3D9-4B3E6422C3AD}" destId="{C808ECEC-9723-43EC-97D1-8D7C9FF97DCB}" srcOrd="2" destOrd="0" presId="urn:microsoft.com/office/officeart/2005/8/layout/orgChart1"/>
    <dgm:cxn modelId="{F57C48E8-B954-429C-87E0-788EB0DD8917}" type="presParOf" srcId="{A806BAB3-CC6D-49EB-81C2-EA3A60D814A7}" destId="{F4FF0489-A853-4C7C-BB76-642DA87047B3}" srcOrd="2" destOrd="0" presId="urn:microsoft.com/office/officeart/2005/8/layout/orgChart1"/>
    <dgm:cxn modelId="{F994DC86-54FC-4F99-BC0F-B60835FC9DE5}" type="presParOf" srcId="{F4FF0489-A853-4C7C-BB76-642DA87047B3}" destId="{70601568-05B5-4DC1-BCD5-011FFBDC2219}" srcOrd="0" destOrd="0" presId="urn:microsoft.com/office/officeart/2005/8/layout/orgChart1"/>
    <dgm:cxn modelId="{CBBF26E7-2A1E-4DB1-A10E-1474C54D16B0}" type="presParOf" srcId="{F4FF0489-A853-4C7C-BB76-642DA87047B3}" destId="{E8B61ACB-8814-4069-B5F9-A7584C60C613}" srcOrd="1" destOrd="0" presId="urn:microsoft.com/office/officeart/2005/8/layout/orgChart1"/>
    <dgm:cxn modelId="{831E1293-61E5-4862-B8B2-C7CE5845EAD4}" type="presParOf" srcId="{E8B61ACB-8814-4069-B5F9-A7584C60C613}" destId="{3D6194E9-9011-4B54-8ACB-854EB94B004C}" srcOrd="0" destOrd="0" presId="urn:microsoft.com/office/officeart/2005/8/layout/orgChart1"/>
    <dgm:cxn modelId="{74F31238-88DB-4585-A5E2-2AC278A1CAAA}" type="presParOf" srcId="{3D6194E9-9011-4B54-8ACB-854EB94B004C}" destId="{A2D48AFA-835A-42D2-A17D-B4802F8A67A4}" srcOrd="0" destOrd="0" presId="urn:microsoft.com/office/officeart/2005/8/layout/orgChart1"/>
    <dgm:cxn modelId="{9CB2B576-F2E7-4F79-A643-34D6FA22DB9B}" type="presParOf" srcId="{3D6194E9-9011-4B54-8ACB-854EB94B004C}" destId="{89BF4019-569B-4D46-B84E-1FD6F41C902C}" srcOrd="1" destOrd="0" presId="urn:microsoft.com/office/officeart/2005/8/layout/orgChart1"/>
    <dgm:cxn modelId="{504847C2-DF3D-4A63-B4D0-9A43CEEC7654}" type="presParOf" srcId="{E8B61ACB-8814-4069-B5F9-A7584C60C613}" destId="{ABA74EE5-D1E7-42FA-867F-1C09F2DB57E6}" srcOrd="1" destOrd="0" presId="urn:microsoft.com/office/officeart/2005/8/layout/orgChart1"/>
    <dgm:cxn modelId="{924F36DB-9444-4A1C-966D-F063B0E2BD2D}" type="presParOf" srcId="{E8B61ACB-8814-4069-B5F9-A7584C60C613}" destId="{57D0F040-5F27-429F-9336-E6F413B91F0D}" srcOrd="2" destOrd="0" presId="urn:microsoft.com/office/officeart/2005/8/layout/orgChart1"/>
    <dgm:cxn modelId="{358A82E2-BD5A-4B0F-A8E7-C201D9683714}" type="presParOf" srcId="{6DEB88B3-DF98-4F7C-BB45-98784BC6BE0A}" destId="{BB4E68D0-E02F-45BB-B375-C4D5C8E54D00}" srcOrd="2" destOrd="0" presId="urn:microsoft.com/office/officeart/2005/8/layout/orgChart1"/>
    <dgm:cxn modelId="{0529EC4C-688C-4FD9-B051-4B128ACCD400}" type="presParOf" srcId="{BB4E68D0-E02F-45BB-B375-C4D5C8E54D00}" destId="{3B48D2C8-A1D2-4BBF-A64A-AAD6A8E75BDE}" srcOrd="0" destOrd="0" presId="urn:microsoft.com/office/officeart/2005/8/layout/orgChart1"/>
    <dgm:cxn modelId="{50F83348-905A-4240-BBB0-703E4D8F819B}" type="presParOf" srcId="{BB4E68D0-E02F-45BB-B375-C4D5C8E54D00}" destId="{C9EB6748-715A-4326-B3CE-A948AA7F0ECE}" srcOrd="1" destOrd="0" presId="urn:microsoft.com/office/officeart/2005/8/layout/orgChart1"/>
    <dgm:cxn modelId="{2AEE9A6D-F356-4DBF-BCF2-53FFA3516D49}" type="presParOf" srcId="{C9EB6748-715A-4326-B3CE-A948AA7F0ECE}" destId="{D9B9EAA8-849E-4146-B1F0-185A52035332}" srcOrd="0" destOrd="0" presId="urn:microsoft.com/office/officeart/2005/8/layout/orgChart1"/>
    <dgm:cxn modelId="{DE955C2B-2C2A-43F3-8CBF-6EF302E2FB10}" type="presParOf" srcId="{D9B9EAA8-849E-4146-B1F0-185A52035332}" destId="{01264203-9E7F-4345-A1A4-0B833DE16E0D}" srcOrd="0" destOrd="0" presId="urn:microsoft.com/office/officeart/2005/8/layout/orgChart1"/>
    <dgm:cxn modelId="{931C2D16-B231-414A-A3EA-90BA8A87B5B3}" type="presParOf" srcId="{D9B9EAA8-849E-4146-B1F0-185A52035332}" destId="{00F1FCF2-CC58-42F1-87B1-8486ACB8A7A5}" srcOrd="1" destOrd="0" presId="urn:microsoft.com/office/officeart/2005/8/layout/orgChart1"/>
    <dgm:cxn modelId="{70957C45-F5D4-4319-9D09-209175BA2F3E}" type="presParOf" srcId="{C9EB6748-715A-4326-B3CE-A948AA7F0ECE}" destId="{59F35C2F-8685-4EA9-B241-73AE7DEAD213}" srcOrd="1" destOrd="0" presId="urn:microsoft.com/office/officeart/2005/8/layout/orgChart1"/>
    <dgm:cxn modelId="{BB5E0E87-6024-416C-A285-D2EB30FA7F9D}" type="presParOf" srcId="{C9EB6748-715A-4326-B3CE-A948AA7F0ECE}" destId="{7CC7969D-B908-42B0-BE45-E4F2112DF2BE}" srcOrd="2" destOrd="0" presId="urn:microsoft.com/office/officeart/2005/8/layout/orgChart1"/>
    <dgm:cxn modelId="{01BD28AD-E8E5-432A-ADDC-1F15BFDFAC10}" type="presParOf" srcId="{D18821A5-3DBF-4DA6-B1FC-A79892BF0B6F}" destId="{F379C07C-1F43-4643-BCA5-6157A0598F7E}" srcOrd="2" destOrd="0" presId="urn:microsoft.com/office/officeart/2005/8/layout/orgChart1"/>
    <dgm:cxn modelId="{4126AA9E-122E-43D2-BBBB-F222A454B5EF}" type="presParOf" srcId="{F379C07C-1F43-4643-BCA5-6157A0598F7E}" destId="{A4169EFE-EE22-41EC-86BA-2B250D2ECC2F}" srcOrd="0" destOrd="0" presId="urn:microsoft.com/office/officeart/2005/8/layout/orgChart1"/>
    <dgm:cxn modelId="{D429FE33-0BBC-40B7-B782-2EE00F50EB4D}" type="presParOf" srcId="{F379C07C-1F43-4643-BCA5-6157A0598F7E}" destId="{F83DA89D-DC51-4615-9508-5D192E33D116}" srcOrd="1" destOrd="0" presId="urn:microsoft.com/office/officeart/2005/8/layout/orgChart1"/>
    <dgm:cxn modelId="{0C5148CE-A987-4AF4-B047-C895A8718881}" type="presParOf" srcId="{F83DA89D-DC51-4615-9508-5D192E33D116}" destId="{8E21F11A-DF64-4C42-928F-AE9B122057DE}" srcOrd="0" destOrd="0" presId="urn:microsoft.com/office/officeart/2005/8/layout/orgChart1"/>
    <dgm:cxn modelId="{D0E7721D-2CD4-467C-982F-91AE906DDCA2}" type="presParOf" srcId="{8E21F11A-DF64-4C42-928F-AE9B122057DE}" destId="{B426F62F-390E-492D-BC1D-BD154468C3AD}" srcOrd="0" destOrd="0" presId="urn:microsoft.com/office/officeart/2005/8/layout/orgChart1"/>
    <dgm:cxn modelId="{5F49E6EA-8D43-4075-AC8A-132D157D8AB9}" type="presParOf" srcId="{8E21F11A-DF64-4C42-928F-AE9B122057DE}" destId="{80719FF6-81F8-4854-A7E3-D4F8332219E6}" srcOrd="1" destOrd="0" presId="urn:microsoft.com/office/officeart/2005/8/layout/orgChart1"/>
    <dgm:cxn modelId="{08DE1BB9-D501-40E4-A45B-6EB4DC7B2C17}" type="presParOf" srcId="{F83DA89D-DC51-4615-9508-5D192E33D116}" destId="{AA7A49F5-A3D4-4432-BDBF-D232F69097B8}" srcOrd="1" destOrd="0" presId="urn:microsoft.com/office/officeart/2005/8/layout/orgChart1"/>
    <dgm:cxn modelId="{331A95BF-EC7D-4FA6-AD73-B7B55EACCB46}" type="presParOf" srcId="{F83DA89D-DC51-4615-9508-5D192E33D116}" destId="{4416E8AB-74E5-4756-A983-E7A4D5BBE377}" srcOrd="2" destOrd="0" presId="urn:microsoft.com/office/officeart/2005/8/layout/orgChart1"/>
    <dgm:cxn modelId="{7587F63A-D274-46AD-AC4E-53FEBC4A6E99}" type="presParOf" srcId="{1183E0B9-5315-4455-8FA9-13A9719D8B62}" destId="{8D2E6844-5B75-46B9-A1C3-BF09E5D4B7CC}" srcOrd="2" destOrd="0" presId="urn:microsoft.com/office/officeart/2005/8/layout/orgChart1"/>
    <dgm:cxn modelId="{7152746E-7B09-43D3-B2F0-E614167986BB}" type="presParOf" srcId="{8D2E6844-5B75-46B9-A1C3-BF09E5D4B7CC}" destId="{C7AEA2F3-B44C-45DB-AE50-E08B980280F7}" srcOrd="0" destOrd="0" presId="urn:microsoft.com/office/officeart/2005/8/layout/orgChart1"/>
    <dgm:cxn modelId="{AEF53581-8C6B-461D-8414-91166B93B0F1}" type="presParOf" srcId="{8D2E6844-5B75-46B9-A1C3-BF09E5D4B7CC}" destId="{E0598AAA-CAD0-4C19-AC08-9FCB9745A1E4}" srcOrd="1" destOrd="0" presId="urn:microsoft.com/office/officeart/2005/8/layout/orgChart1"/>
    <dgm:cxn modelId="{E7CF567D-DD2B-45DA-8A27-52FD7DFF5A06}" type="presParOf" srcId="{E0598AAA-CAD0-4C19-AC08-9FCB9745A1E4}" destId="{961DCD04-4CA5-4F19-BD84-FC044A1F5883}" srcOrd="0" destOrd="0" presId="urn:microsoft.com/office/officeart/2005/8/layout/orgChart1"/>
    <dgm:cxn modelId="{3E38EC9F-1976-42F8-9A73-D0DA5B6C4336}" type="presParOf" srcId="{961DCD04-4CA5-4F19-BD84-FC044A1F5883}" destId="{06309ACB-14D0-4E5F-96AB-E1B92D1D10C1}" srcOrd="0" destOrd="0" presId="urn:microsoft.com/office/officeart/2005/8/layout/orgChart1"/>
    <dgm:cxn modelId="{ABAD6497-501B-45B2-856B-C4E805D858EB}" type="presParOf" srcId="{961DCD04-4CA5-4F19-BD84-FC044A1F5883}" destId="{470EA609-7BFA-4E06-924F-F37F83EDE9C9}" srcOrd="1" destOrd="0" presId="urn:microsoft.com/office/officeart/2005/8/layout/orgChart1"/>
    <dgm:cxn modelId="{60299ECE-D05A-47E4-9735-926E61EFD775}" type="presParOf" srcId="{E0598AAA-CAD0-4C19-AC08-9FCB9745A1E4}" destId="{29BF3374-7856-4A60-B406-EEF4933B102B}" srcOrd="1" destOrd="0" presId="urn:microsoft.com/office/officeart/2005/8/layout/orgChart1"/>
    <dgm:cxn modelId="{C9F6D063-11F9-40C5-ADE4-570DAE75A49B}" type="presParOf" srcId="{E0598AAA-CAD0-4C19-AC08-9FCB9745A1E4}" destId="{11B9C253-4CE2-45F2-B398-1B3240C0CA91}" srcOrd="2" destOrd="0" presId="urn:microsoft.com/office/officeart/2005/8/layout/orgChart1"/>
    <dgm:cxn modelId="{1A6F1669-50E3-4CCF-95DD-0A33A257E255}" type="presParOf" srcId="{62D2C5AE-FFB0-4BFA-B644-64EACE25F2B3}" destId="{3EC7947E-707E-4518-93D2-AAEAC988AB35}" srcOrd="2" destOrd="0" presId="urn:microsoft.com/office/officeart/2005/8/layout/orgChart1"/>
    <dgm:cxn modelId="{38323C8E-078E-4FD9-A7A0-14571EC90D7A}" type="presParOf" srcId="{3EC7947E-707E-4518-93D2-AAEAC988AB35}" destId="{A8F28E82-35A1-43F6-9BD3-9AA1AB5811B6}" srcOrd="0" destOrd="0" presId="urn:microsoft.com/office/officeart/2005/8/layout/orgChart1"/>
    <dgm:cxn modelId="{A1BEA5E9-B54C-4E90-B7D6-A964A334A915}" type="presParOf" srcId="{3EC7947E-707E-4518-93D2-AAEAC988AB35}" destId="{FE1ED44E-B2E2-4ED1-A95A-B790A51E6E8A}" srcOrd="1" destOrd="0" presId="urn:microsoft.com/office/officeart/2005/8/layout/orgChart1"/>
    <dgm:cxn modelId="{FD9D3B2F-D936-479A-8A36-AB2186787D51}" type="presParOf" srcId="{FE1ED44E-B2E2-4ED1-A95A-B790A51E6E8A}" destId="{11A1C705-AE8B-45C0-860C-BAEE60B19A45}" srcOrd="0" destOrd="0" presId="urn:microsoft.com/office/officeart/2005/8/layout/orgChart1"/>
    <dgm:cxn modelId="{164E8C5D-CD3E-456F-AB8D-3E42DFF8B7E5}" type="presParOf" srcId="{11A1C705-AE8B-45C0-860C-BAEE60B19A45}" destId="{7C84B838-1A68-4137-AC95-553678FAF3BB}" srcOrd="0" destOrd="0" presId="urn:microsoft.com/office/officeart/2005/8/layout/orgChart1"/>
    <dgm:cxn modelId="{6B484F34-67B0-46DB-8356-6BFD1AD724A7}" type="presParOf" srcId="{11A1C705-AE8B-45C0-860C-BAEE60B19A45}" destId="{27194D24-F300-452C-964A-9DA292AAB2EA}" srcOrd="1" destOrd="0" presId="urn:microsoft.com/office/officeart/2005/8/layout/orgChart1"/>
    <dgm:cxn modelId="{08C9F1A6-A946-4194-985E-486EA2CE515F}" type="presParOf" srcId="{FE1ED44E-B2E2-4ED1-A95A-B790A51E6E8A}" destId="{0800FE89-78F7-46F0-BB56-88B82F095810}" srcOrd="1" destOrd="0" presId="urn:microsoft.com/office/officeart/2005/8/layout/orgChart1"/>
    <dgm:cxn modelId="{7F7211AC-F14B-4C3A-86C7-CFFC8B16AAB8}" type="presParOf" srcId="{FE1ED44E-B2E2-4ED1-A95A-B790A51E6E8A}" destId="{51DEF950-AB56-4BD7-88F3-D214E606176B}" srcOrd="2" destOrd="0" presId="urn:microsoft.com/office/officeart/2005/8/layout/orgChart1"/>
    <dgm:cxn modelId="{CD78F4A7-8D24-478F-A3ED-508088A912E4}" type="presParOf" srcId="{A7C27564-4010-422D-8733-D45402B36FD6}" destId="{B8AA073A-DF55-4886-806B-A19501B7D45D}" srcOrd="2" destOrd="0" presId="urn:microsoft.com/office/officeart/2005/8/layout/orgChart1"/>
    <dgm:cxn modelId="{F48DAEA9-FBAF-4C70-B3C1-D9A350E4902E}" type="presParOf" srcId="{B8AA073A-DF55-4886-806B-A19501B7D45D}" destId="{65FCADAA-3F85-4C83-900C-D538276957EF}" srcOrd="0" destOrd="0" presId="urn:microsoft.com/office/officeart/2005/8/layout/orgChart1"/>
    <dgm:cxn modelId="{228F5707-80CA-44D8-B4FB-AA7DD96A7F39}" type="presParOf" srcId="{B8AA073A-DF55-4886-806B-A19501B7D45D}" destId="{1DD41069-EFB9-4C80-8DAB-D2B1CCEE8225}" srcOrd="1" destOrd="0" presId="urn:microsoft.com/office/officeart/2005/8/layout/orgChart1"/>
    <dgm:cxn modelId="{B5DB3EC9-D54B-4ADE-8763-37D83925BC9A}" type="presParOf" srcId="{1DD41069-EFB9-4C80-8DAB-D2B1CCEE8225}" destId="{E7DC0F47-CA63-42DD-8744-290626E39AE2}" srcOrd="0" destOrd="0" presId="urn:microsoft.com/office/officeart/2005/8/layout/orgChart1"/>
    <dgm:cxn modelId="{47DFC9C7-F57E-453F-8303-7639825987A7}" type="presParOf" srcId="{E7DC0F47-CA63-42DD-8744-290626E39AE2}" destId="{20AB0850-24A6-4544-9BC7-B0D14C292E39}" srcOrd="0" destOrd="0" presId="urn:microsoft.com/office/officeart/2005/8/layout/orgChart1"/>
    <dgm:cxn modelId="{4D9E118C-7BE1-4DDE-9051-A54984E11303}" type="presParOf" srcId="{E7DC0F47-CA63-42DD-8744-290626E39AE2}" destId="{E6257FB3-097F-40AE-B306-EC1E3394080B}" srcOrd="1" destOrd="0" presId="urn:microsoft.com/office/officeart/2005/8/layout/orgChart1"/>
    <dgm:cxn modelId="{505E1848-64E1-4B5F-AB65-F1A8920E6C75}" type="presParOf" srcId="{1DD41069-EFB9-4C80-8DAB-D2B1CCEE8225}" destId="{93139419-E597-441B-AAD4-283F0B6CC2BB}" srcOrd="1" destOrd="0" presId="urn:microsoft.com/office/officeart/2005/8/layout/orgChart1"/>
    <dgm:cxn modelId="{1FE06B17-F089-463A-9108-8D3B7A97EF7E}" type="presParOf" srcId="{1DD41069-EFB9-4C80-8DAB-D2B1CCEE8225}" destId="{E03D1C91-8F0C-4E2F-8D40-57C6816E6773}" srcOrd="2" destOrd="0" presId="urn:microsoft.com/office/officeart/2005/8/layout/orgChart1"/>
    <dgm:cxn modelId="{60737EB5-409E-48CD-AF76-8D171DAC1090}" type="presParOf" srcId="{E9C0A15B-08F5-45AB-AE40-50B104EF8824}" destId="{BD61099B-D08B-43BF-9287-6F344AF93E66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5FCADAA-3F85-4C83-900C-D538276957EF}">
      <dsp:nvSpPr>
        <dsp:cNvPr id="0" name=""/>
        <dsp:cNvSpPr/>
      </dsp:nvSpPr>
      <dsp:spPr>
        <a:xfrm>
          <a:off x="6320859" y="579781"/>
          <a:ext cx="510639" cy="365324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365324"/>
              </a:lnTo>
              <a:lnTo>
                <a:pt x="0" y="365324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8F28E82-35A1-43F6-9BD3-9AA1AB5811B6}">
      <dsp:nvSpPr>
        <dsp:cNvPr id="0" name=""/>
        <dsp:cNvSpPr/>
      </dsp:nvSpPr>
      <dsp:spPr>
        <a:xfrm>
          <a:off x="6320859" y="1549418"/>
          <a:ext cx="510639" cy="330994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330994"/>
              </a:lnTo>
              <a:lnTo>
                <a:pt x="0" y="330994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C7AEA2F3-B44C-45DB-AE50-E08B980280F7}">
      <dsp:nvSpPr>
        <dsp:cNvPr id="0" name=""/>
        <dsp:cNvSpPr/>
      </dsp:nvSpPr>
      <dsp:spPr>
        <a:xfrm>
          <a:off x="6320859" y="2450394"/>
          <a:ext cx="510639" cy="419114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419114"/>
              </a:lnTo>
              <a:lnTo>
                <a:pt x="0" y="419114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4169EFE-EE22-41EC-86BA-2B250D2ECC2F}">
      <dsp:nvSpPr>
        <dsp:cNvPr id="0" name=""/>
        <dsp:cNvSpPr/>
      </dsp:nvSpPr>
      <dsp:spPr>
        <a:xfrm>
          <a:off x="6320859" y="3527611"/>
          <a:ext cx="510639" cy="281125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281125"/>
              </a:lnTo>
              <a:lnTo>
                <a:pt x="0" y="28112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B48D2C8-A1D2-4BBF-A64A-AAD6A8E75BDE}">
      <dsp:nvSpPr>
        <dsp:cNvPr id="0" name=""/>
        <dsp:cNvSpPr/>
      </dsp:nvSpPr>
      <dsp:spPr>
        <a:xfrm>
          <a:off x="6320859" y="4328850"/>
          <a:ext cx="510639" cy="330548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330548"/>
              </a:lnTo>
              <a:lnTo>
                <a:pt x="0" y="330548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0601568-05B5-4DC1-BCD5-011FFBDC2219}">
      <dsp:nvSpPr>
        <dsp:cNvPr id="0" name=""/>
        <dsp:cNvSpPr/>
      </dsp:nvSpPr>
      <dsp:spPr>
        <a:xfrm>
          <a:off x="6320859" y="5228935"/>
          <a:ext cx="510639" cy="219868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219868"/>
              </a:lnTo>
              <a:lnTo>
                <a:pt x="0" y="219868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C4607AE-9127-4C60-8192-99F85D2263E4}">
      <dsp:nvSpPr>
        <dsp:cNvPr id="0" name=""/>
        <dsp:cNvSpPr/>
      </dsp:nvSpPr>
      <dsp:spPr>
        <a:xfrm>
          <a:off x="6320859" y="5907660"/>
          <a:ext cx="510639" cy="335607"/>
        </a:xfrm>
        <a:custGeom>
          <a:avLst/>
          <a:gdLst/>
          <a:ahLst/>
          <a:cxnLst/>
          <a:rect l="0" t="0" r="0" b="0"/>
          <a:pathLst>
            <a:path>
              <a:moveTo>
                <a:pt x="510639" y="0"/>
              </a:moveTo>
              <a:lnTo>
                <a:pt x="510639" y="335607"/>
              </a:lnTo>
              <a:lnTo>
                <a:pt x="0" y="33560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9C21FE1-B6ED-4A37-B462-2AB3364F71D0}">
      <dsp:nvSpPr>
        <dsp:cNvPr id="0" name=""/>
        <dsp:cNvSpPr/>
      </dsp:nvSpPr>
      <dsp:spPr>
        <a:xfrm>
          <a:off x="6785779" y="5907660"/>
          <a:ext cx="91440" cy="67121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671215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0190C39-547E-4B89-B648-F08C6C2F66F2}">
      <dsp:nvSpPr>
        <dsp:cNvPr id="0" name=""/>
        <dsp:cNvSpPr/>
      </dsp:nvSpPr>
      <dsp:spPr>
        <a:xfrm>
          <a:off x="6785779" y="5228935"/>
          <a:ext cx="91440" cy="439737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439737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B7E3833-9C19-46A0-9A92-6F38FFC85039}">
      <dsp:nvSpPr>
        <dsp:cNvPr id="0" name=""/>
        <dsp:cNvSpPr/>
      </dsp:nvSpPr>
      <dsp:spPr>
        <a:xfrm>
          <a:off x="6785779" y="4328850"/>
          <a:ext cx="91440" cy="661096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661096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B55021B-F6A8-4994-8164-4336A664D621}">
      <dsp:nvSpPr>
        <dsp:cNvPr id="0" name=""/>
        <dsp:cNvSpPr/>
      </dsp:nvSpPr>
      <dsp:spPr>
        <a:xfrm>
          <a:off x="6785779" y="3527611"/>
          <a:ext cx="91440" cy="562251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562251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F281A03-08F4-4C67-B904-7FB33A589950}">
      <dsp:nvSpPr>
        <dsp:cNvPr id="0" name=""/>
        <dsp:cNvSpPr/>
      </dsp:nvSpPr>
      <dsp:spPr>
        <a:xfrm>
          <a:off x="6785779" y="2450394"/>
          <a:ext cx="91440" cy="838229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838229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547A377-B232-4285-B4EE-75243809D23F}">
      <dsp:nvSpPr>
        <dsp:cNvPr id="0" name=""/>
        <dsp:cNvSpPr/>
      </dsp:nvSpPr>
      <dsp:spPr>
        <a:xfrm>
          <a:off x="6785779" y="1549418"/>
          <a:ext cx="91440" cy="661988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661988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132DE44-9ECA-47B2-AD75-85A6A010FC4D}">
      <dsp:nvSpPr>
        <dsp:cNvPr id="0" name=""/>
        <dsp:cNvSpPr/>
      </dsp:nvSpPr>
      <dsp:spPr>
        <a:xfrm>
          <a:off x="6785779" y="579781"/>
          <a:ext cx="91440" cy="730649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730649"/>
              </a:lnTo>
            </a:path>
          </a:pathLst>
        </a:custGeom>
        <a:noFill/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4C4E53C1-EB55-45A9-9A0C-9DA14B00D2F3}">
      <dsp:nvSpPr>
        <dsp:cNvPr id="0" name=""/>
        <dsp:cNvSpPr/>
      </dsp:nvSpPr>
      <dsp:spPr>
        <a:xfrm>
          <a:off x="6785779" y="240419"/>
          <a:ext cx="91440" cy="100374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100374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0948DE4-96CE-40F4-ABC7-147E84CF7ECA}">
      <dsp:nvSpPr>
        <dsp:cNvPr id="0" name=""/>
        <dsp:cNvSpPr/>
      </dsp:nvSpPr>
      <dsp:spPr>
        <a:xfrm>
          <a:off x="5921435" y="1431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/>
            <a:t>Safety</a:t>
          </a:r>
          <a:r>
            <a:rPr lang="fr-FR" sz="800" kern="1200" dirty="0"/>
            <a:t>  and </a:t>
          </a:r>
          <a:r>
            <a:rPr lang="fr-FR" sz="800" kern="1200" dirty="0" err="1"/>
            <a:t>efficacy</a:t>
          </a:r>
          <a:r>
            <a:rPr lang="fr-FR" sz="800" kern="1200" dirty="0"/>
            <a:t> set 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/>
            <a:t>N=122</a:t>
          </a:r>
        </a:p>
      </dsp:txBody>
      <dsp:txXfrm>
        <a:off x="5921435" y="1431"/>
        <a:ext cx="1820129" cy="238987"/>
      </dsp:txXfrm>
    </dsp:sp>
    <dsp:sp modelId="{E38B95A6-6623-484F-AC67-3FA1AA07853B}">
      <dsp:nvSpPr>
        <dsp:cNvPr id="0" name=""/>
        <dsp:cNvSpPr/>
      </dsp:nvSpPr>
      <dsp:spPr>
        <a:xfrm>
          <a:off x="5921435" y="340794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1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22</a:t>
          </a:r>
        </a:p>
      </dsp:txBody>
      <dsp:txXfrm>
        <a:off x="5921435" y="340794"/>
        <a:ext cx="1820129" cy="238987"/>
      </dsp:txXfrm>
    </dsp:sp>
    <dsp:sp modelId="{12BD7DDA-D1BB-4FF4-8342-23B53D84EC6A}">
      <dsp:nvSpPr>
        <dsp:cNvPr id="0" name=""/>
        <dsp:cNvSpPr/>
      </dsp:nvSpPr>
      <dsp:spPr>
        <a:xfrm>
          <a:off x="5921435" y="1310431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2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13</a:t>
          </a:r>
        </a:p>
      </dsp:txBody>
      <dsp:txXfrm>
        <a:off x="5921435" y="1310431"/>
        <a:ext cx="1820129" cy="238987"/>
      </dsp:txXfrm>
    </dsp:sp>
    <dsp:sp modelId="{A1AB4BCC-C250-428E-A94F-1F38EC7E7CA4}">
      <dsp:nvSpPr>
        <dsp:cNvPr id="0" name=""/>
        <dsp:cNvSpPr/>
      </dsp:nvSpPr>
      <dsp:spPr>
        <a:xfrm>
          <a:off x="5921435" y="2211406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3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10</a:t>
          </a:r>
        </a:p>
      </dsp:txBody>
      <dsp:txXfrm>
        <a:off x="5921435" y="2211406"/>
        <a:ext cx="1820129" cy="238987"/>
      </dsp:txXfrm>
    </dsp:sp>
    <dsp:sp modelId="{E9B9B375-243B-43C0-AB17-CA88E082354E}">
      <dsp:nvSpPr>
        <dsp:cNvPr id="0" name=""/>
        <dsp:cNvSpPr/>
      </dsp:nvSpPr>
      <dsp:spPr>
        <a:xfrm>
          <a:off x="5921435" y="3288624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4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07</a:t>
          </a:r>
        </a:p>
      </dsp:txBody>
      <dsp:txXfrm>
        <a:off x="5921435" y="3288624"/>
        <a:ext cx="1820129" cy="238987"/>
      </dsp:txXfrm>
    </dsp:sp>
    <dsp:sp modelId="{E0AC1C43-68C3-4F03-9C5C-C3BAD309D7B7}">
      <dsp:nvSpPr>
        <dsp:cNvPr id="0" name=""/>
        <dsp:cNvSpPr/>
      </dsp:nvSpPr>
      <dsp:spPr>
        <a:xfrm>
          <a:off x="5921435" y="4089863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5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05</a:t>
          </a:r>
        </a:p>
      </dsp:txBody>
      <dsp:txXfrm>
        <a:off x="5921435" y="4089863"/>
        <a:ext cx="1820129" cy="238987"/>
      </dsp:txXfrm>
    </dsp:sp>
    <dsp:sp modelId="{C4992308-3022-43C8-8EF5-550E2758FE43}">
      <dsp:nvSpPr>
        <dsp:cNvPr id="0" name=""/>
        <dsp:cNvSpPr/>
      </dsp:nvSpPr>
      <dsp:spPr>
        <a:xfrm>
          <a:off x="5921435" y="4989947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6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03</a:t>
          </a:r>
        </a:p>
      </dsp:txBody>
      <dsp:txXfrm>
        <a:off x="5921435" y="4989947"/>
        <a:ext cx="1820129" cy="238987"/>
      </dsp:txXfrm>
    </dsp:sp>
    <dsp:sp modelId="{3E185FB1-90A9-437D-850B-C2C96FF3602F}">
      <dsp:nvSpPr>
        <dsp:cNvPr id="0" name=""/>
        <dsp:cNvSpPr/>
      </dsp:nvSpPr>
      <dsp:spPr>
        <a:xfrm>
          <a:off x="5921435" y="5668672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Cycle 7 done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/>
            <a:t>N=102</a:t>
          </a:r>
        </a:p>
      </dsp:txBody>
      <dsp:txXfrm>
        <a:off x="5921435" y="5668672"/>
        <a:ext cx="1820129" cy="238987"/>
      </dsp:txXfrm>
    </dsp:sp>
    <dsp:sp modelId="{2971916A-BFEB-44DC-A717-D00C519E9A59}">
      <dsp:nvSpPr>
        <dsp:cNvPr id="0" name=""/>
        <dsp:cNvSpPr/>
      </dsp:nvSpPr>
      <dsp:spPr>
        <a:xfrm>
          <a:off x="5921435" y="6578875"/>
          <a:ext cx="1820129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Cycle 8 </a:t>
          </a:r>
          <a:r>
            <a:rPr lang="fr-FR" sz="800" kern="1200" dirty="0" err="1">
              <a:solidFill>
                <a:schemeClr val="tx1"/>
              </a:solidFill>
            </a:rPr>
            <a:t>done</a:t>
          </a:r>
          <a:endParaRPr lang="fr-FR" sz="800" kern="1200" dirty="0">
            <a:solidFill>
              <a:schemeClr val="tx1"/>
            </a:solidFill>
          </a:endParaRP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N=100 (99)</a:t>
          </a:r>
        </a:p>
      </dsp:txBody>
      <dsp:txXfrm>
        <a:off x="5921435" y="6578875"/>
        <a:ext cx="1820129" cy="238987"/>
      </dsp:txXfrm>
    </dsp:sp>
    <dsp:sp modelId="{6F252BDA-768A-4210-BE51-DC46B35854BC}">
      <dsp:nvSpPr>
        <dsp:cNvPr id="0" name=""/>
        <dsp:cNvSpPr/>
      </dsp:nvSpPr>
      <dsp:spPr>
        <a:xfrm>
          <a:off x="3065816" y="6008034"/>
          <a:ext cx="3255043" cy="470466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2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Adverse </a:t>
          </a:r>
          <a:r>
            <a:rPr lang="fr-FR" sz="800" kern="1200" dirty="0" err="1">
              <a:solidFill>
                <a:schemeClr val="tx1"/>
              </a:solidFill>
            </a:rPr>
            <a:t>event</a:t>
          </a:r>
          <a:r>
            <a:rPr lang="fr-FR" sz="800" kern="1200" dirty="0">
              <a:solidFill>
                <a:schemeClr val="tx1"/>
              </a:solidFill>
            </a:rPr>
            <a:t>: N=2 (NEUTROPENIA ; GENERAL PHYSICAL HEALTH DETERIORATION and NAUSEA)</a:t>
          </a:r>
        </a:p>
      </dsp:txBody>
      <dsp:txXfrm>
        <a:off x="3065816" y="6008034"/>
        <a:ext cx="3255043" cy="470466"/>
      </dsp:txXfrm>
    </dsp:sp>
    <dsp:sp modelId="{A2D48AFA-835A-42D2-A17D-B4802F8A67A4}">
      <dsp:nvSpPr>
        <dsp:cNvPr id="0" name=""/>
        <dsp:cNvSpPr/>
      </dsp:nvSpPr>
      <dsp:spPr>
        <a:xfrm>
          <a:off x="3065816" y="5329310"/>
          <a:ext cx="3255043" cy="23898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1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: N=1*</a:t>
          </a:r>
        </a:p>
      </dsp:txBody>
      <dsp:txXfrm>
        <a:off x="3065816" y="5329310"/>
        <a:ext cx="3255043" cy="238987"/>
      </dsp:txXfrm>
    </dsp:sp>
    <dsp:sp modelId="{01264203-9E7F-4345-A1A4-0B833DE16E0D}">
      <dsp:nvSpPr>
        <dsp:cNvPr id="0" name=""/>
        <dsp:cNvSpPr/>
      </dsp:nvSpPr>
      <dsp:spPr>
        <a:xfrm>
          <a:off x="3065816" y="4429225"/>
          <a:ext cx="3255043" cy="460347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2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Adverse Event: N=1 (THROMBOPHLEBITIS SEPTIC)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Progressive </a:t>
          </a:r>
          <a:r>
            <a:rPr lang="fr-FR" sz="800" kern="1200" dirty="0" err="1">
              <a:solidFill>
                <a:schemeClr val="tx1"/>
              </a:solidFill>
            </a:rPr>
            <a:t>disease</a:t>
          </a:r>
          <a:r>
            <a:rPr lang="fr-FR" sz="800" kern="1200" dirty="0">
              <a:solidFill>
                <a:schemeClr val="tx1"/>
              </a:solidFill>
            </a:rPr>
            <a:t>: N=1</a:t>
          </a:r>
        </a:p>
      </dsp:txBody>
      <dsp:txXfrm>
        <a:off x="3065816" y="4429225"/>
        <a:ext cx="3255043" cy="460347"/>
      </dsp:txXfrm>
    </dsp:sp>
    <dsp:sp modelId="{B426F62F-390E-492D-BC1D-BD154468C3AD}">
      <dsp:nvSpPr>
        <dsp:cNvPr id="0" name=""/>
        <dsp:cNvSpPr/>
      </dsp:nvSpPr>
      <dsp:spPr>
        <a:xfrm>
          <a:off x="3065816" y="3627986"/>
          <a:ext cx="3255043" cy="361502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2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: N=1*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tx1"/>
              </a:solidFill>
            </a:rPr>
            <a:t>Physician</a:t>
          </a:r>
          <a:r>
            <a:rPr lang="fr-FR" sz="800" kern="1200" dirty="0">
              <a:solidFill>
                <a:schemeClr val="tx1"/>
              </a:solidFill>
            </a:rPr>
            <a:t> </a:t>
          </a:r>
          <a:r>
            <a:rPr lang="fr-FR" sz="800" kern="1200" dirty="0" err="1">
              <a:solidFill>
                <a:schemeClr val="tx1"/>
              </a:solidFill>
            </a:rPr>
            <a:t>decision</a:t>
          </a:r>
          <a:r>
            <a:rPr lang="fr-FR" sz="800" kern="1200" dirty="0">
              <a:solidFill>
                <a:schemeClr val="tx1"/>
              </a:solidFill>
            </a:rPr>
            <a:t>: N=1</a:t>
          </a:r>
        </a:p>
      </dsp:txBody>
      <dsp:txXfrm>
        <a:off x="3065816" y="3627986"/>
        <a:ext cx="3255043" cy="361502"/>
      </dsp:txXfrm>
    </dsp:sp>
    <dsp:sp modelId="{06309ACB-14D0-4E5F-96AB-E1B92D1D10C1}">
      <dsp:nvSpPr>
        <dsp:cNvPr id="0" name=""/>
        <dsp:cNvSpPr/>
      </dsp:nvSpPr>
      <dsp:spPr>
        <a:xfrm>
          <a:off x="3065816" y="2550769"/>
          <a:ext cx="3255043" cy="637480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3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: N=1*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Adverse </a:t>
          </a:r>
          <a:r>
            <a:rPr lang="fr-FR" sz="800" kern="1200" dirty="0" err="1">
              <a:solidFill>
                <a:schemeClr val="tx1"/>
              </a:solidFill>
            </a:rPr>
            <a:t>event</a:t>
          </a:r>
          <a:r>
            <a:rPr lang="fr-FR" sz="800" kern="1200" dirty="0">
              <a:solidFill>
                <a:schemeClr val="tx1"/>
              </a:solidFill>
            </a:rPr>
            <a:t>: N=1 (BONE MARROW FAILURE)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Protocol </a:t>
          </a:r>
          <a:r>
            <a:rPr lang="fr-FR" sz="800" kern="1200" dirty="0" err="1">
              <a:solidFill>
                <a:schemeClr val="tx1"/>
              </a:solidFill>
            </a:rPr>
            <a:t>deviation</a:t>
          </a:r>
          <a:r>
            <a:rPr lang="fr-FR" sz="800" kern="1200" dirty="0">
              <a:solidFill>
                <a:schemeClr val="tx1"/>
              </a:solidFill>
            </a:rPr>
            <a:t>: N=1 (NO DOXOROBUCINE GIVEN AT C3 DUE TO PICCLINE REMOVAL)</a:t>
          </a:r>
        </a:p>
      </dsp:txBody>
      <dsp:txXfrm>
        <a:off x="3065816" y="2550769"/>
        <a:ext cx="3255043" cy="637480"/>
      </dsp:txXfrm>
    </dsp:sp>
    <dsp:sp modelId="{7C84B838-1A68-4137-AC95-553678FAF3BB}">
      <dsp:nvSpPr>
        <dsp:cNvPr id="0" name=""/>
        <dsp:cNvSpPr/>
      </dsp:nvSpPr>
      <dsp:spPr>
        <a:xfrm>
          <a:off x="3065816" y="1649793"/>
          <a:ext cx="3255043" cy="461238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3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0" kern="12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: N=2*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Protocol </a:t>
          </a:r>
          <a:r>
            <a:rPr lang="fr-FR" sz="800" kern="1200" dirty="0" err="1">
              <a:solidFill>
                <a:schemeClr val="tx1"/>
              </a:solidFill>
            </a:rPr>
            <a:t>deviation</a:t>
          </a:r>
          <a:r>
            <a:rPr lang="fr-FR" sz="800" kern="1200" dirty="0">
              <a:solidFill>
                <a:schemeClr val="tx1"/>
              </a:solidFill>
            </a:rPr>
            <a:t>: N=1 (NEUROMENINGEAL INVASION)</a:t>
          </a:r>
        </a:p>
      </dsp:txBody>
      <dsp:txXfrm>
        <a:off x="3065816" y="1649793"/>
        <a:ext cx="3255043" cy="461238"/>
      </dsp:txXfrm>
    </dsp:sp>
    <dsp:sp modelId="{20AB0850-24A6-4544-9BC7-B0D14C292E39}">
      <dsp:nvSpPr>
        <dsp:cNvPr id="0" name=""/>
        <dsp:cNvSpPr/>
      </dsp:nvSpPr>
      <dsp:spPr>
        <a:xfrm>
          <a:off x="3065816" y="680156"/>
          <a:ext cx="3255043" cy="529899"/>
        </a:xfrm>
        <a:prstGeom prst="rect">
          <a:avLst/>
        </a:prstGeom>
        <a:solidFill>
          <a:schemeClr val="l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b="1" kern="1200" dirty="0" err="1">
              <a:solidFill>
                <a:schemeClr val="tx1"/>
              </a:solidFill>
            </a:rPr>
            <a:t>Reasons</a:t>
          </a:r>
          <a:r>
            <a:rPr lang="fr-FR" sz="800" b="1" kern="1200" dirty="0">
              <a:solidFill>
                <a:schemeClr val="tx1"/>
              </a:solidFill>
            </a:rPr>
            <a:t> for permanent </a:t>
          </a:r>
          <a:r>
            <a:rPr lang="fr-FR" sz="800" b="1" kern="1200" dirty="0" err="1">
              <a:solidFill>
                <a:schemeClr val="tx1"/>
              </a:solidFill>
            </a:rPr>
            <a:t>treatment</a:t>
          </a:r>
          <a:r>
            <a:rPr lang="fr-FR" sz="800" b="1" kern="1200" dirty="0">
              <a:solidFill>
                <a:schemeClr val="tx1"/>
              </a:solidFill>
            </a:rPr>
            <a:t> discontinuation: N=9: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Withdrawal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 by </a:t>
          </a:r>
          <a:r>
            <a:rPr lang="fr-FR" sz="800" kern="1200" dirty="0" err="1">
              <a:solidFill>
                <a:schemeClr val="accent5">
                  <a:lumMod val="75000"/>
                </a:schemeClr>
              </a:solidFill>
            </a:rPr>
            <a:t>subject</a:t>
          </a:r>
          <a:r>
            <a:rPr lang="fr-FR" sz="800" kern="1200" dirty="0">
              <a:solidFill>
                <a:schemeClr val="accent5">
                  <a:lumMod val="75000"/>
                </a:schemeClr>
              </a:solidFill>
            </a:rPr>
            <a:t>: N=5*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 err="1">
              <a:solidFill>
                <a:schemeClr val="tx1"/>
              </a:solidFill>
            </a:rPr>
            <a:t>Death</a:t>
          </a:r>
          <a:r>
            <a:rPr lang="fr-FR" sz="800" kern="1200" dirty="0">
              <a:solidFill>
                <a:schemeClr val="tx1"/>
              </a:solidFill>
            </a:rPr>
            <a:t>: N=2 (SEPTIC SHOCK TO KLEBSIELLA PNEUMONIA; SEPTIC SHOCK)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fr-FR" sz="800" kern="1200" dirty="0">
              <a:solidFill>
                <a:schemeClr val="tx1"/>
              </a:solidFill>
            </a:rPr>
            <a:t>Adverse </a:t>
          </a:r>
          <a:r>
            <a:rPr lang="fr-FR" sz="800" kern="1200" dirty="0" err="1">
              <a:solidFill>
                <a:schemeClr val="tx1"/>
              </a:solidFill>
            </a:rPr>
            <a:t>event</a:t>
          </a:r>
          <a:r>
            <a:rPr lang="fr-FR" sz="800" kern="1200" dirty="0">
              <a:solidFill>
                <a:schemeClr val="tx1"/>
              </a:solidFill>
            </a:rPr>
            <a:t>: N=2 (CEREBROVASCULAR ACCIDENT; DEPRESSION)</a:t>
          </a:r>
        </a:p>
      </dsp:txBody>
      <dsp:txXfrm>
        <a:off x="3065816" y="680156"/>
        <a:ext cx="3255043" cy="52989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9E4B76-53B9-F249-87B4-123D4E157DCB}" type="datetimeFigureOut">
              <a:rPr lang="fr-FR" smtClean="0"/>
              <a:t>05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</p:spTree>
    <p:extLst>
      <p:ext uri="{BB962C8B-B14F-4D97-AF65-F5344CB8AC3E}">
        <p14:creationId xmlns:p14="http://schemas.microsoft.com/office/powerpoint/2010/main" val="29274112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ouver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xmlns="" id="{0A84C310-193F-BB42-8C74-19AEDA188BA5}"/>
              </a:ext>
            </a:extLst>
          </p:cNvPr>
          <p:cNvCxnSpPr>
            <a:cxnSpLocks/>
          </p:cNvCxnSpPr>
          <p:nvPr userDrawn="1"/>
        </p:nvCxnSpPr>
        <p:spPr>
          <a:xfrm>
            <a:off x="3330981" y="2907608"/>
            <a:ext cx="2773680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3330466" y="1673844"/>
            <a:ext cx="6769417" cy="830424"/>
          </a:xfrm>
        </p:spPr>
        <p:txBody>
          <a:bodyPr lIns="0" tIns="0" rIns="0" bIns="0" anchor="t" anchorCtr="0">
            <a:noAutofit/>
          </a:bodyPr>
          <a:lstStyle>
            <a:lvl1pPr algn="l">
              <a:defRPr sz="4000" b="1" i="0">
                <a:solidFill>
                  <a:srgbClr val="20285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330466" y="3117162"/>
            <a:ext cx="6769417" cy="1908164"/>
          </a:xfrm>
          <a:prstGeom prst="rect">
            <a:avLst/>
          </a:prstGeom>
        </p:spPr>
        <p:txBody>
          <a:bodyPr lIns="0" tIns="0" rIns="0" bIns="0">
            <a:noAutofit/>
          </a:bodyPr>
          <a:lstStyle>
            <a:lvl1pPr marL="0" indent="0" algn="l">
              <a:buNone/>
              <a:defRPr sz="2933" b="1" i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fr-FR" dirty="0"/>
              <a:t>Sous-titre</a:t>
            </a:r>
            <a:endParaRPr lang="en-US" dirty="0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E3EF2900-FC25-E449-BE4A-BDCCD2A6D93B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0447041" y="674030"/>
            <a:ext cx="1449916" cy="1273097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xmlns="" id="{69AE16BB-AB1D-F64D-B8F7-24EEFC47C2A3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A6BFD832-3F39-AB4E-AB4C-0FD73DF9BAB4}"/>
              </a:ext>
            </a:extLst>
          </p:cNvPr>
          <p:cNvPicPr/>
          <p:nvPr userDrawn="1"/>
        </p:nvPicPr>
        <p:blipFill rotWithShape="1">
          <a:blip r:embed="rId4"/>
          <a:srcRect l="20334" r="-6210"/>
          <a:stretch/>
        </p:blipFill>
        <p:spPr>
          <a:xfrm>
            <a:off x="0" y="844249"/>
            <a:ext cx="2640000" cy="2804969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xmlns="" id="{38987AA8-EDF2-C447-85C0-4836088530F1}"/>
              </a:ext>
            </a:extLst>
          </p:cNvPr>
          <p:cNvPicPr/>
          <p:nvPr userDrawn="1"/>
        </p:nvPicPr>
        <p:blipFill rotWithShape="1">
          <a:blip r:embed="rId5"/>
          <a:srcRect l="45290" t="25267" r="-10845" b="-11484"/>
          <a:stretch/>
        </p:blipFill>
        <p:spPr>
          <a:xfrm>
            <a:off x="0" y="0"/>
            <a:ext cx="2160000" cy="25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3531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3 blocs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Espace réservé du contenu 12">
            <a:extLst>
              <a:ext uri="{FF2B5EF4-FFF2-40B4-BE49-F238E27FC236}">
                <a16:creationId xmlns:a16="http://schemas.microsoft.com/office/drawing/2014/main" xmlns="" id="{5DECD958-28FA-403B-87CB-AC00433F4669}"/>
              </a:ext>
            </a:extLst>
          </p:cNvPr>
          <p:cNvSpPr>
            <a:spLocks noGrp="1"/>
          </p:cNvSpPr>
          <p:nvPr>
            <p:ph sz="quarter" idx="23"/>
          </p:nvPr>
        </p:nvSpPr>
        <p:spPr>
          <a:xfrm>
            <a:off x="8155518" y="1475318"/>
            <a:ext cx="3854449" cy="444076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0" name="Espace réservé du contenu 9">
            <a:extLst>
              <a:ext uri="{FF2B5EF4-FFF2-40B4-BE49-F238E27FC236}">
                <a16:creationId xmlns:a16="http://schemas.microsoft.com/office/drawing/2014/main" xmlns="" id="{E52FEB95-A419-4E72-BC58-5F390EAEF80E}"/>
              </a:ext>
            </a:extLst>
          </p:cNvPr>
          <p:cNvSpPr>
            <a:spLocks noGrp="1"/>
          </p:cNvSpPr>
          <p:nvPr>
            <p:ph sz="quarter" idx="22"/>
          </p:nvPr>
        </p:nvSpPr>
        <p:spPr>
          <a:xfrm>
            <a:off x="4167718" y="1475318"/>
            <a:ext cx="3839633" cy="444076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u contenu 6">
            <a:extLst>
              <a:ext uri="{FF2B5EF4-FFF2-40B4-BE49-F238E27FC236}">
                <a16:creationId xmlns:a16="http://schemas.microsoft.com/office/drawing/2014/main" xmlns="" id="{45327EEF-AA1D-4B74-B018-323F22B2F133}"/>
              </a:ext>
            </a:extLst>
          </p:cNvPr>
          <p:cNvSpPr>
            <a:spLocks noGrp="1"/>
          </p:cNvSpPr>
          <p:nvPr>
            <p:ph sz="quarter" idx="21"/>
          </p:nvPr>
        </p:nvSpPr>
        <p:spPr>
          <a:xfrm>
            <a:off x="182034" y="1475318"/>
            <a:ext cx="3839633" cy="444076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80B0E92B-0813-43F2-8EBF-8D5767515939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712331CB-8CA2-447D-8A3A-905040CCAA4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664FF74F-1EB4-4830-BFAB-D3E27633A44A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FBFB711C-2E44-4DED-BEBB-0D83617C81C3}"/>
              </a:ext>
            </a:extLst>
          </p:cNvPr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fld id="{9D646D9A-C821-426A-9619-1C1360A59AE6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51DD6014-C801-4361-9A0B-D0842EB9FB17}"/>
              </a:ext>
            </a:extLst>
          </p:cNvPr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xmlns="" id="{0F00A6DF-43D6-F049-9B55-EF13C955764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F281B3FC-CC88-BE48-B1AA-AC191A52D2F0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xmlns="" id="{68BC7F2F-AB14-0346-9CC2-43174C9250FC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9896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us sans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contenu 6">
            <a:extLst>
              <a:ext uri="{FF2B5EF4-FFF2-40B4-BE49-F238E27FC236}">
                <a16:creationId xmlns:a16="http://schemas.microsoft.com/office/drawing/2014/main" xmlns="" id="{00BF50EC-2AE1-44FC-824A-6DFB20BBB7C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139700" y="495300"/>
            <a:ext cx="11912600" cy="58610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xmlns="" id="{F7A1ECDF-A4A4-4F0E-9CA7-83AC0616BD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218E2A0F-4D25-412A-85CC-E4C4136DE452}"/>
              </a:ext>
            </a:extLst>
          </p:cNvPr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77994F79-B4EB-4FD0-A468-EF072C12E07B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59320D1-B8BD-4BF9-BC4C-8FDA1DDB7204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65EFCE28-F26C-3F45-BDCD-8D3E3131F494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BCEEB14C-BFD2-6C4E-B352-48958F0B623A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366866070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xmlns="" id="{F7A1ECDF-A4A4-4F0E-9CA7-83AC0616BD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218E2A0F-4D25-412A-85CC-E4C4136DE452}"/>
              </a:ext>
            </a:extLst>
          </p:cNvPr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fld id="{EFA5AA93-002F-4135-8763-874203BBC88E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59320D1-B8BD-4BF9-BC4C-8FDA1DDB7204}"/>
              </a:ext>
            </a:extLst>
          </p:cNvPr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65EFCE28-F26C-3F45-BDCD-8D3E3131F494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xmlns="" id="{BCEEB14C-BFD2-6C4E-B352-48958F0B623A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</p:spTree>
    <p:extLst>
      <p:ext uri="{BB962C8B-B14F-4D97-AF65-F5344CB8AC3E}">
        <p14:creationId xmlns:p14="http://schemas.microsoft.com/office/powerpoint/2010/main" val="317603371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xmlns="" id="{0A84C310-193F-BB42-8C74-19AEDA188BA5}"/>
              </a:ext>
            </a:extLst>
          </p:cNvPr>
          <p:cNvCxnSpPr>
            <a:cxnSpLocks/>
          </p:cNvCxnSpPr>
          <p:nvPr userDrawn="1"/>
        </p:nvCxnSpPr>
        <p:spPr>
          <a:xfrm>
            <a:off x="3330981" y="4656461"/>
            <a:ext cx="2773680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3330466" y="3602573"/>
            <a:ext cx="7682308" cy="830424"/>
          </a:xfrm>
        </p:spPr>
        <p:txBody>
          <a:bodyPr lIns="0" tIns="0" rIns="0" bIns="0" anchor="t" anchorCtr="0">
            <a:noAutofit/>
          </a:bodyPr>
          <a:lstStyle>
            <a:lvl1pPr algn="l">
              <a:defRPr sz="40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Merci</a:t>
            </a:r>
            <a:endParaRPr lang="en-US" dirty="0"/>
          </a:p>
        </p:txBody>
      </p:sp>
      <p:pic>
        <p:nvPicPr>
          <p:cNvPr id="9" name="Image 8">
            <a:extLst>
              <a:ext uri="{FF2B5EF4-FFF2-40B4-BE49-F238E27FC236}">
                <a16:creationId xmlns:a16="http://schemas.microsoft.com/office/drawing/2014/main" xmlns="" id="{EAFC366C-D880-5445-86A5-BEC9AD5CC6D0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0447041" y="674030"/>
            <a:ext cx="1449916" cy="1273097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xmlns="" id="{337B1E6D-42B0-3143-9D96-4B909A4229CA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xmlns="" id="{C24460B1-E920-FF44-AFE4-1BC79C798376}"/>
              </a:ext>
            </a:extLst>
          </p:cNvPr>
          <p:cNvPicPr/>
          <p:nvPr userDrawn="1"/>
        </p:nvPicPr>
        <p:blipFill rotWithShape="1">
          <a:blip r:embed="rId4"/>
          <a:srcRect l="20334" r="-6210"/>
          <a:stretch/>
        </p:blipFill>
        <p:spPr>
          <a:xfrm>
            <a:off x="0" y="844249"/>
            <a:ext cx="2640000" cy="2804969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xmlns="" id="{231B34D2-3924-9845-B341-2593A0255656}"/>
              </a:ext>
            </a:extLst>
          </p:cNvPr>
          <p:cNvPicPr/>
          <p:nvPr userDrawn="1"/>
        </p:nvPicPr>
        <p:blipFill rotWithShape="1">
          <a:blip r:embed="rId5"/>
          <a:srcRect l="45290" t="25267" r="-10845" b="-11484"/>
          <a:stretch/>
        </p:blipFill>
        <p:spPr>
          <a:xfrm>
            <a:off x="0" y="0"/>
            <a:ext cx="2160000" cy="259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799925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dirty="0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dirty="0"/>
              <a:t>Modifiez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5AB8B9-1AF4-4CDC-852F-6ADCB31EA5BE}" type="slidenum">
              <a:rPr lang="fr-FR" smtClean="0">
                <a:solidFill>
                  <a:srgbClr val="1F497D">
                    <a:lumMod val="50000"/>
                  </a:srgbClr>
                </a:solidFill>
              </a:rPr>
              <a:pPr/>
              <a:t>‹#›</a:t>
            </a:fld>
            <a:endParaRPr lang="fr-FR">
              <a:solidFill>
                <a:srgbClr val="1F497D">
                  <a:lumMod val="50000"/>
                </a:srgbClr>
              </a:solidFill>
            </a:endParaRPr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13" hasCustomPrompt="1"/>
          </p:nvPr>
        </p:nvSpPr>
        <p:spPr>
          <a:xfrm>
            <a:off x="9264651" y="6524629"/>
            <a:ext cx="1727200" cy="333375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</a:lstStyle>
          <a:p>
            <a:pPr lvl="0"/>
            <a:r>
              <a:rPr lang="fr-FR" dirty="0"/>
              <a:t>date</a:t>
            </a:r>
          </a:p>
        </p:txBody>
      </p:sp>
      <p:sp>
        <p:nvSpPr>
          <p:cNvPr id="13" name="Espace réservé du contenu 12"/>
          <p:cNvSpPr>
            <a:spLocks noGrp="1"/>
          </p:cNvSpPr>
          <p:nvPr>
            <p:ph sz="quarter" idx="14" hasCustomPrompt="1"/>
          </p:nvPr>
        </p:nvSpPr>
        <p:spPr>
          <a:xfrm>
            <a:off x="3407835" y="6524629"/>
            <a:ext cx="5376333" cy="333375"/>
          </a:xfrm>
        </p:spPr>
        <p:txBody>
          <a:bodyPr>
            <a:normAutofit/>
          </a:bodyPr>
          <a:lstStyle>
            <a:lvl1pPr marL="0" indent="0" algn="ctr">
              <a:buNone/>
              <a:defRPr sz="1600">
                <a:solidFill>
                  <a:schemeClr val="bg1"/>
                </a:solidFill>
              </a:defRPr>
            </a:lvl1pPr>
          </a:lstStyle>
          <a:p>
            <a:r>
              <a:rPr lang="fr-FR" dirty="0"/>
              <a:t>Oral </a:t>
            </a:r>
            <a:r>
              <a:rPr lang="fr-FR" dirty="0" err="1"/>
              <a:t>presentation</a:t>
            </a:r>
            <a:r>
              <a:rPr lang="fr-FR" dirty="0"/>
              <a:t> xxx</a:t>
            </a:r>
          </a:p>
        </p:txBody>
      </p:sp>
      <p:sp>
        <p:nvSpPr>
          <p:cNvPr id="15" name="Espace réservé du contenu 14"/>
          <p:cNvSpPr>
            <a:spLocks noGrp="1"/>
          </p:cNvSpPr>
          <p:nvPr>
            <p:ph sz="quarter" idx="15" hasCustomPrompt="1"/>
          </p:nvPr>
        </p:nvSpPr>
        <p:spPr>
          <a:xfrm>
            <a:off x="143933" y="6524629"/>
            <a:ext cx="3168651" cy="333375"/>
          </a:xfrm>
        </p:spPr>
        <p:txBody>
          <a:bodyPr>
            <a:normAutofit/>
          </a:bodyPr>
          <a:lstStyle>
            <a:lvl1pPr marL="0" indent="0" algn="ctr">
              <a:buNone/>
              <a:defRPr sz="1600">
                <a:solidFill>
                  <a:schemeClr val="bg1"/>
                </a:solidFill>
              </a:defRPr>
            </a:lvl1pPr>
          </a:lstStyle>
          <a:p>
            <a:r>
              <a:rPr lang="fr-FR" dirty="0" err="1"/>
              <a:t>Study</a:t>
            </a:r>
            <a:r>
              <a:rPr lang="fr-FR" dirty="0"/>
              <a:t> xxx / </a:t>
            </a:r>
            <a:r>
              <a:rPr lang="fr-FR" dirty="0" err="1"/>
              <a:t>Author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0204109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re multiblocs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xmlns="" id="{8F85B892-4C5B-4008-B1CC-AB7CACF3365A}"/>
              </a:ext>
            </a:extLst>
          </p:cNvPr>
          <p:cNvSpPr>
            <a:spLocks noGrp="1"/>
          </p:cNvSpPr>
          <p:nvPr>
            <p:ph sz="quarter" idx="22"/>
          </p:nvPr>
        </p:nvSpPr>
        <p:spPr>
          <a:xfrm>
            <a:off x="9057218" y="1390651"/>
            <a:ext cx="2315633" cy="4442883"/>
          </a:xfrm>
        </p:spPr>
        <p:txBody>
          <a:bodyPr>
            <a:noAutofit/>
          </a:bodyPr>
          <a:lstStyle>
            <a:lvl1pPr>
              <a:lnSpc>
                <a:spcPct val="150000"/>
              </a:lnSpc>
              <a:defRPr sz="2133"/>
            </a:lvl1pPr>
            <a:lvl2pPr>
              <a:lnSpc>
                <a:spcPct val="150000"/>
              </a:lnSpc>
              <a:defRPr sz="2133"/>
            </a:lvl2pPr>
            <a:lvl3pPr>
              <a:lnSpc>
                <a:spcPct val="150000"/>
              </a:lnSpc>
              <a:defRPr sz="2133"/>
            </a:lvl3pPr>
            <a:lvl4pPr>
              <a:lnSpc>
                <a:spcPct val="150000"/>
              </a:lnSpc>
              <a:defRPr sz="2133"/>
            </a:lvl4pPr>
            <a:lvl5pPr>
              <a:lnSpc>
                <a:spcPct val="150000"/>
              </a:lnSpc>
              <a:defRPr sz="2133"/>
            </a:lvl5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xmlns="" id="{424B101E-A15D-4BF1-BECD-9FC14D1B2665}"/>
              </a:ext>
            </a:extLst>
          </p:cNvPr>
          <p:cNvSpPr>
            <a:spLocks noGrp="1"/>
          </p:cNvSpPr>
          <p:nvPr>
            <p:ph sz="quarter" idx="21"/>
          </p:nvPr>
        </p:nvSpPr>
        <p:spPr>
          <a:xfrm>
            <a:off x="385233" y="1390651"/>
            <a:ext cx="7808384" cy="2696633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133"/>
            </a:lvl1pPr>
            <a:lvl2pPr>
              <a:lnSpc>
                <a:spcPct val="150000"/>
              </a:lnSpc>
              <a:defRPr sz="2133"/>
            </a:lvl2pPr>
            <a:lvl3pPr>
              <a:lnSpc>
                <a:spcPct val="150000"/>
              </a:lnSpc>
              <a:defRPr sz="2133"/>
            </a:lvl3pPr>
            <a:lvl4pPr>
              <a:lnSpc>
                <a:spcPct val="150000"/>
              </a:lnSpc>
              <a:defRPr sz="2133"/>
            </a:lvl4pPr>
            <a:lvl5pPr>
              <a:lnSpc>
                <a:spcPct val="150000"/>
              </a:lnSpc>
              <a:defRPr sz="2133"/>
            </a:lvl5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C579B05C-D95E-4EF1-B353-7756486CC6F7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BF7E20D9-7432-49BE-BA25-D88AAE534277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rgbClr val="20285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xmlns="" id="{44956D93-F414-4DB4-83E1-618CE9B839EC}"/>
              </a:ext>
            </a:extLst>
          </p:cNvPr>
          <p:cNvPicPr/>
          <p:nvPr userDrawn="1"/>
        </p:nvPicPr>
        <p:blipFill>
          <a:blip r:embed="rId2"/>
          <a:stretch>
            <a:fillRect/>
          </a:stretch>
        </p:blipFill>
        <p:spPr>
          <a:xfrm>
            <a:off x="8263467" y="6749799"/>
            <a:ext cx="3928533" cy="118533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xmlns="" id="{52177A66-0A9A-47AF-88F1-904A05B7AE6D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11078258" y="381914"/>
            <a:ext cx="847749" cy="847749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D6C75A88-FDDA-4E67-9600-4CE3E7166AD2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rgbClr val="E5316C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D73ED002-F570-4FC2-BAA0-2256C9D5F764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rgbClr val="A758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027E0880-EAAC-4815-8F3D-AA6BA506E876}"/>
              </a:ext>
            </a:extLst>
          </p:cNvPr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E7C840D7-38D2-4013-92AF-57F98FC7A37F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2D7ECFD-6B45-4D23-99D8-F11D45C989DB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sp>
        <p:nvSpPr>
          <p:cNvPr id="8" name="Espace réservé du texte 7">
            <a:extLst>
              <a:ext uri="{FF2B5EF4-FFF2-40B4-BE49-F238E27FC236}">
                <a16:creationId xmlns:a16="http://schemas.microsoft.com/office/drawing/2014/main" xmlns="" id="{2FCE1639-42F1-4AF8-8799-9017F5C88526}"/>
              </a:ext>
            </a:extLst>
          </p:cNvPr>
          <p:cNvSpPr>
            <a:spLocks noGrp="1"/>
          </p:cNvSpPr>
          <p:nvPr>
            <p:ph type="body" sz="quarter" idx="20"/>
          </p:nvPr>
        </p:nvSpPr>
        <p:spPr>
          <a:xfrm>
            <a:off x="393700" y="4421717"/>
            <a:ext cx="7799917" cy="1411816"/>
          </a:xfrm>
          <a:prstGeom prst="rect">
            <a:avLst/>
          </a:prstGeom>
        </p:spPr>
        <p:txBody>
          <a:bodyPr>
            <a:noAutofit/>
          </a:bodyPr>
          <a:lstStyle>
            <a:lvl1pPr>
              <a:lnSpc>
                <a:spcPct val="150000"/>
              </a:lnSpc>
              <a:defRPr sz="2133"/>
            </a:lvl1pPr>
            <a:lvl2pPr>
              <a:lnSpc>
                <a:spcPct val="150000"/>
              </a:lnSpc>
              <a:defRPr sz="2133"/>
            </a:lvl2pPr>
            <a:lvl3pPr>
              <a:lnSpc>
                <a:spcPct val="150000"/>
              </a:lnSpc>
              <a:defRPr sz="2133"/>
            </a:lvl3pPr>
            <a:lvl4pPr>
              <a:lnSpc>
                <a:spcPct val="150000"/>
              </a:lnSpc>
              <a:defRPr sz="2133"/>
            </a:lvl4pPr>
            <a:lvl5pPr>
              <a:lnSpc>
                <a:spcPct val="150000"/>
              </a:lnSpc>
              <a:defRPr sz="2133"/>
            </a:lvl5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0354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ommaire 2 colonn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1523360" y="84713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32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Sommaire </a:t>
            </a:r>
            <a:br>
              <a:rPr lang="fr-FR" dirty="0"/>
            </a:br>
            <a:endParaRPr lang="en-US" dirty="0"/>
          </a:p>
        </p:txBody>
      </p:sp>
      <p:sp>
        <p:nvSpPr>
          <p:cNvPr id="9" name="Espace réservé du texte 8">
            <a:extLst>
              <a:ext uri="{FF2B5EF4-FFF2-40B4-BE49-F238E27FC236}">
                <a16:creationId xmlns:a16="http://schemas.microsoft.com/office/drawing/2014/main" xmlns="" id="{A7E6831F-894B-4F4E-90C1-F5836C3C602C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1523358" y="1971565"/>
            <a:ext cx="9201636" cy="4002996"/>
          </a:xfrm>
          <a:prstGeom prst="rect">
            <a:avLst/>
          </a:prstGeom>
        </p:spPr>
        <p:txBody>
          <a:bodyPr lIns="0" tIns="0" rIns="0" bIns="0" numCol="2" spcCol="540000"/>
          <a:lstStyle>
            <a:lvl1pPr marL="479988" marR="0" indent="-479988" algn="l" defTabSz="914377" rtl="0" eaLnBrk="1" fontAlgn="auto" latinLnBrk="0" hangingPunct="1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 sz="1600" b="1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85783" marR="0" indent="-228594" algn="l" defTabSz="914377" rtl="0" eaLnBrk="1" fontAlgn="auto" latinLnBrk="0" hangingPunct="1">
              <a:lnSpc>
                <a:spcPct val="15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 sz="1333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479988" indent="-479988">
              <a:buFont typeface="+mj-lt"/>
              <a:buNone/>
              <a:defRPr sz="1333" b="1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buFont typeface="+mj-lt"/>
              <a:buAutoNum type="arabicPeriod"/>
              <a:defRPr sz="1333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buFont typeface="+mj-lt"/>
              <a:buAutoNum type="arabicPeriod"/>
              <a:defRPr sz="1333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endParaRPr lang="fr-FR" dirty="0"/>
          </a:p>
          <a:p>
            <a:pPr lvl="0"/>
            <a:endParaRPr lang="fr-FR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398C9BBB-D998-49C8-824E-6CDEEC70DB6F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xmlns="" id="{F613A7DF-9BDA-4849-A9AE-DFD6F16E594D}"/>
              </a:ext>
            </a:extLst>
          </p:cNvPr>
          <p:cNvCxnSpPr>
            <a:cxnSpLocks/>
          </p:cNvCxnSpPr>
          <p:nvPr userDrawn="1"/>
        </p:nvCxnSpPr>
        <p:spPr>
          <a:xfrm>
            <a:off x="1523358" y="1393165"/>
            <a:ext cx="1960071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B469B7A1-C57F-412C-B047-CCA7BB821A0C}"/>
              </a:ext>
            </a:extLst>
          </p:cNvPr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fld id="{8C5B1E6C-CC5E-4EF5-9A06-75FA14A14C54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8CD3CB5-7AB7-4682-9461-ABCABE44BF00}"/>
              </a:ext>
            </a:extLst>
          </p:cNvPr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B9925CFB-7874-446D-99CB-4BD7B5FFE335}"/>
              </a:ext>
            </a:extLst>
          </p:cNvPr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xmlns="" id="{C70FCF85-14F0-3C45-AA8D-4BE95F45ACC0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xmlns="" id="{69AD4294-09B5-784C-B8C7-570D4CE352D5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56155F68-9CCC-9645-A5A0-1EA08F8BFDDC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4"/>
          <a:srcRect l="72386" r="-3371"/>
          <a:stretch/>
        </p:blipFill>
        <p:spPr>
          <a:xfrm>
            <a:off x="0" y="2065092"/>
            <a:ext cx="1296000" cy="381593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46548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ommaire 1 colon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1523360" y="84713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32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Sommaire</a:t>
            </a:r>
            <a:br>
              <a:rPr lang="fr-FR" dirty="0"/>
            </a:br>
            <a:endParaRPr lang="en-US" dirty="0"/>
          </a:p>
        </p:txBody>
      </p:sp>
      <p:sp>
        <p:nvSpPr>
          <p:cNvPr id="9" name="Espace réservé du texte 8">
            <a:extLst>
              <a:ext uri="{FF2B5EF4-FFF2-40B4-BE49-F238E27FC236}">
                <a16:creationId xmlns:a16="http://schemas.microsoft.com/office/drawing/2014/main" xmlns="" id="{A7E6831F-894B-4F4E-90C1-F5836C3C602C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1523358" y="1971565"/>
            <a:ext cx="9201636" cy="4002996"/>
          </a:xfrm>
          <a:prstGeom prst="rect">
            <a:avLst/>
          </a:prstGeom>
        </p:spPr>
        <p:txBody>
          <a:bodyPr lIns="0" tIns="0" rIns="0" bIns="0" numCol="1" spcCol="540000">
            <a:normAutofit/>
          </a:bodyPr>
          <a:lstStyle>
            <a:lvl1pPr marL="479988" marR="0" indent="-479988" algn="l" defTabSz="914377" rtl="0" eaLnBrk="1" fontAlgn="auto" latinLnBrk="0" hangingPunct="1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 sz="1867" b="1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685783" marR="0" indent="-228594" algn="l" defTabSz="914377" rtl="0" eaLnBrk="1" fontAlgn="auto" latinLnBrk="0" hangingPunct="1">
              <a:lnSpc>
                <a:spcPct val="15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 sz="1867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479988" indent="-479988">
              <a:buFont typeface="+mj-lt"/>
              <a:buNone/>
              <a:defRPr sz="1333" b="1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buFont typeface="+mj-lt"/>
              <a:buAutoNum type="arabicPeriod"/>
              <a:defRPr sz="1333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buFont typeface="+mj-lt"/>
              <a:buAutoNum type="arabicPeriod"/>
              <a:defRPr sz="1333"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lvl="0"/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dolor</a:t>
            </a:r>
            <a:r>
              <a:rPr lang="fr-FR" dirty="0"/>
              <a:t> </a:t>
            </a:r>
            <a:r>
              <a:rPr lang="fr-FR" dirty="0" err="1"/>
              <a:t>sit</a:t>
            </a:r>
            <a:r>
              <a:rPr lang="fr-FR" dirty="0"/>
              <a:t> </a:t>
            </a:r>
            <a:r>
              <a:rPr lang="fr-FR" dirty="0" err="1"/>
              <a:t>amet</a:t>
            </a:r>
            <a:r>
              <a:rPr lang="fr-FR" dirty="0"/>
              <a:t>, </a:t>
            </a:r>
            <a:r>
              <a:rPr lang="fr-FR" dirty="0" err="1"/>
              <a:t>consectetur</a:t>
            </a:r>
            <a:r>
              <a:rPr lang="fr-FR" dirty="0"/>
              <a:t> </a:t>
            </a:r>
            <a:r>
              <a:rPr lang="fr-FR" dirty="0" err="1"/>
              <a:t>adipiscing</a:t>
            </a:r>
            <a:r>
              <a:rPr lang="fr-FR" dirty="0"/>
              <a:t> </a:t>
            </a:r>
            <a:r>
              <a:rPr lang="fr-FR" dirty="0" err="1"/>
              <a:t>elit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685783" marR="0" lvl="1" indent="-228594" algn="l" defTabSz="914377" rtl="0" eaLnBrk="1" fontAlgn="auto" latinLnBrk="0" hangingPunct="1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r>
              <a:rPr lang="fr-FR" dirty="0" err="1"/>
              <a:t>Lorem</a:t>
            </a:r>
            <a:r>
              <a:rPr lang="fr-FR" dirty="0"/>
              <a:t> </a:t>
            </a:r>
            <a:r>
              <a:rPr lang="fr-FR" dirty="0" err="1"/>
              <a:t>ipsum</a:t>
            </a:r>
            <a:r>
              <a:rPr lang="fr-FR" dirty="0"/>
              <a:t> </a:t>
            </a:r>
            <a:r>
              <a:rPr lang="fr-FR" dirty="0" err="1"/>
              <a:t>sed</a:t>
            </a:r>
            <a:r>
              <a:rPr lang="fr-FR" dirty="0"/>
              <a:t> do </a:t>
            </a:r>
            <a:r>
              <a:rPr lang="fr-FR" dirty="0" err="1"/>
              <a:t>eiusmod</a:t>
            </a:r>
            <a:r>
              <a:rPr lang="fr-FR" dirty="0"/>
              <a:t> </a:t>
            </a:r>
            <a:r>
              <a:rPr lang="fr-FR" dirty="0" err="1"/>
              <a:t>tempor</a:t>
            </a:r>
            <a:endParaRPr lang="fr-FR" dirty="0"/>
          </a:p>
          <a:p>
            <a:pPr marL="479988" marR="0" lvl="0" indent="-479988" algn="l" defTabSz="914377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+mj-lt"/>
              <a:buAutoNum type="arabicPeriod"/>
              <a:tabLst/>
              <a:defRPr/>
            </a:pPr>
            <a:endParaRPr lang="fr-FR" dirty="0"/>
          </a:p>
          <a:p>
            <a:pPr lvl="0"/>
            <a:endParaRPr lang="fr-FR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1307779F-7D14-4AFB-B855-7ECE2CE4225D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xmlns="" id="{6B8C9BE3-CEEA-4B1D-9985-168A3FA3D7A5}"/>
              </a:ext>
            </a:extLst>
          </p:cNvPr>
          <p:cNvCxnSpPr>
            <a:cxnSpLocks/>
          </p:cNvCxnSpPr>
          <p:nvPr userDrawn="1"/>
        </p:nvCxnSpPr>
        <p:spPr>
          <a:xfrm>
            <a:off x="1523358" y="1393165"/>
            <a:ext cx="1960071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B9FDB7E4-EF10-44D7-8800-D45BDD8FC129}"/>
              </a:ext>
            </a:extLst>
          </p:cNvPr>
          <p:cNvSpPr>
            <a:spLocks noGrp="1"/>
          </p:cNvSpPr>
          <p:nvPr>
            <p:ph type="dt" sz="half" idx="16"/>
          </p:nvPr>
        </p:nvSpPr>
        <p:spPr/>
        <p:txBody>
          <a:bodyPr/>
          <a:lstStyle/>
          <a:p>
            <a:fld id="{0C19A82A-D7D9-4E4A-8468-5C99142B2D7D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5AECEBD-191F-43A6-A77C-9A5298FF5154}"/>
              </a:ext>
            </a:extLst>
          </p:cNvPr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xmlns="" id="{FF3C9C1D-6DF7-7047-A599-6B2528BE0EAC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xmlns="" id="{8FC69F46-F0A0-0146-9A31-522A3769C9CD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28229F32-0B1A-AC47-84EE-380849D17985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4"/>
          <a:srcRect l="72386" r="-3371"/>
          <a:stretch/>
        </p:blipFill>
        <p:spPr>
          <a:xfrm>
            <a:off x="0" y="2065092"/>
            <a:ext cx="1296000" cy="381593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352748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contenus texte + illustra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Espace réservé du contenu 8">
            <a:extLst>
              <a:ext uri="{FF2B5EF4-FFF2-40B4-BE49-F238E27FC236}">
                <a16:creationId xmlns:a16="http://schemas.microsoft.com/office/drawing/2014/main" xmlns="" id="{97A05FBE-E543-4D5C-8346-155EEABE3C03}"/>
              </a:ext>
            </a:extLst>
          </p:cNvPr>
          <p:cNvSpPr>
            <a:spLocks noGrp="1"/>
          </p:cNvSpPr>
          <p:nvPr>
            <p:ph sz="quarter" idx="23"/>
          </p:nvPr>
        </p:nvSpPr>
        <p:spPr>
          <a:xfrm>
            <a:off x="9201151" y="1447801"/>
            <a:ext cx="2438400" cy="4298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7" name="Espace réservé du texte 6">
            <a:extLst>
              <a:ext uri="{FF2B5EF4-FFF2-40B4-BE49-F238E27FC236}">
                <a16:creationId xmlns:a16="http://schemas.microsoft.com/office/drawing/2014/main" xmlns="" id="{4A9CB552-4E56-434A-9E6F-AFB9E8183D64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5234" y="1447801"/>
            <a:ext cx="8500533" cy="4298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BDA3B5FB-8DCC-4050-A95D-F08D83D8CE63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sp>
        <p:nvSpPr>
          <p:cNvPr id="20" name="Espace réservé de la date 19">
            <a:extLst>
              <a:ext uri="{FF2B5EF4-FFF2-40B4-BE49-F238E27FC236}">
                <a16:creationId xmlns:a16="http://schemas.microsoft.com/office/drawing/2014/main" xmlns="" id="{DDC5018F-F495-4DA6-895B-7CF47583BE5A}"/>
              </a:ext>
            </a:extLst>
          </p:cNvPr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fld id="{D12D9B45-9918-4004-9160-80AC99E3F7D8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22" name="Espace réservé du numéro de diapositive 21">
            <a:extLst>
              <a:ext uri="{FF2B5EF4-FFF2-40B4-BE49-F238E27FC236}">
                <a16:creationId xmlns:a16="http://schemas.microsoft.com/office/drawing/2014/main" xmlns="" id="{39FE3F3E-C676-441A-8F4D-5DF70CADB54A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xmlns="" id="{B35FD3BD-53EA-2E4A-8FDA-5F6696E1631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xmlns="" id="{F544DEA5-A6E0-4843-A4D2-F993C9045525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74487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et tex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texte 6">
            <a:extLst>
              <a:ext uri="{FF2B5EF4-FFF2-40B4-BE49-F238E27FC236}">
                <a16:creationId xmlns:a16="http://schemas.microsoft.com/office/drawing/2014/main" xmlns="" id="{4A9CB552-4E56-434A-9E6F-AFB9E8183D64}"/>
              </a:ext>
            </a:extLst>
          </p:cNvPr>
          <p:cNvSpPr>
            <a:spLocks noGrp="1"/>
          </p:cNvSpPr>
          <p:nvPr>
            <p:ph type="body" sz="quarter" idx="22"/>
          </p:nvPr>
        </p:nvSpPr>
        <p:spPr>
          <a:xfrm>
            <a:off x="385234" y="1447801"/>
            <a:ext cx="11254317" cy="429895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93084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contenu 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B2F5B00E-19FA-4F18-89C2-2373449B3CDD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0394208A-96E1-4855-89C0-3606DF548C78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rgbClr val="202856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BAC948FC-A77F-4EBB-9BED-D4A27533F4AD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AE4E7EF-10F2-4886-A5AC-150494A2EEC4}"/>
              </a:ext>
            </a:extLst>
          </p:cNvPr>
          <p:cNvSpPr>
            <a:spLocks noGrp="1"/>
          </p:cNvSpPr>
          <p:nvPr>
            <p:ph type="dt" sz="half" idx="16"/>
          </p:nvPr>
        </p:nvSpPr>
        <p:spPr/>
        <p:txBody>
          <a:bodyPr/>
          <a:lstStyle/>
          <a:p>
            <a:fld id="{8D09B461-C267-4819-B415-A82A77C04EB4}" type="datetime4">
              <a:rPr lang="fr-FR" smtClean="0"/>
              <a:t>5 mars 2025</a:t>
            </a:fld>
            <a:endParaRPr lang="fr-FR" dirty="0"/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xmlns="" id="{E34228D9-0FAE-844E-9931-695E59A9AE70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xmlns="" id="{AE7ACD6B-D302-8047-8CBA-576FC84AFFCA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5064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multiblocs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Espace réservé du texte 12">
            <a:extLst>
              <a:ext uri="{FF2B5EF4-FFF2-40B4-BE49-F238E27FC236}">
                <a16:creationId xmlns:a16="http://schemas.microsoft.com/office/drawing/2014/main" xmlns="" id="{E71B2ED4-6B50-48A5-8184-9074336D6478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94290" y="4421717"/>
            <a:ext cx="7799327" cy="141181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1" name="Espace réservé du contenu 10">
            <a:extLst>
              <a:ext uri="{FF2B5EF4-FFF2-40B4-BE49-F238E27FC236}">
                <a16:creationId xmlns:a16="http://schemas.microsoft.com/office/drawing/2014/main" xmlns="" id="{96D1620E-578D-4E51-A618-CEE15551CED5}"/>
              </a:ext>
            </a:extLst>
          </p:cNvPr>
          <p:cNvSpPr>
            <a:spLocks noGrp="1"/>
          </p:cNvSpPr>
          <p:nvPr>
            <p:ph sz="quarter" idx="22"/>
          </p:nvPr>
        </p:nvSpPr>
        <p:spPr>
          <a:xfrm>
            <a:off x="9057218" y="1390651"/>
            <a:ext cx="2315633" cy="44428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9" name="Espace réservé du contenu 8">
            <a:extLst>
              <a:ext uri="{FF2B5EF4-FFF2-40B4-BE49-F238E27FC236}">
                <a16:creationId xmlns:a16="http://schemas.microsoft.com/office/drawing/2014/main" xmlns="" id="{AA8417F8-D10E-45F6-82A8-09862DD272DD}"/>
              </a:ext>
            </a:extLst>
          </p:cNvPr>
          <p:cNvSpPr>
            <a:spLocks noGrp="1"/>
          </p:cNvSpPr>
          <p:nvPr>
            <p:ph sz="quarter" idx="21"/>
          </p:nvPr>
        </p:nvSpPr>
        <p:spPr>
          <a:xfrm>
            <a:off x="393700" y="1390652"/>
            <a:ext cx="7799917" cy="269663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C579B05C-D95E-4EF1-B353-7756486CC6F7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BF7E20D9-7432-49BE-BA25-D88AAE534277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D73ED002-F570-4FC2-BAA0-2256C9D5F764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027E0880-EAAC-4815-8F3D-AA6BA506E876}"/>
              </a:ext>
            </a:extLst>
          </p:cNvPr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2C76499B-F1B4-4F00-9007-52B4BFC33FCE}" type="datetime4">
              <a:rPr lang="fr-FR" smtClean="0"/>
              <a:t>5 mars 2025</a:t>
            </a:fld>
            <a:endParaRPr lang="fr-FR" dirty="0"/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xmlns="" id="{983B57AD-C079-0149-9B88-2454F249264F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2AD15A41-6907-0F45-AD4E-778F275719AC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xmlns="" id="{DA9A57CE-326D-714E-8A1B-2FE4CC40FF7A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7485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multiblocs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Espace réservé du texte 12">
            <a:extLst>
              <a:ext uri="{FF2B5EF4-FFF2-40B4-BE49-F238E27FC236}">
                <a16:creationId xmlns:a16="http://schemas.microsoft.com/office/drawing/2014/main" xmlns="" id="{25061DA7-4A58-464D-830C-EB3533BD466A}"/>
              </a:ext>
            </a:extLst>
          </p:cNvPr>
          <p:cNvSpPr>
            <a:spLocks noGrp="1"/>
          </p:cNvSpPr>
          <p:nvPr>
            <p:ph type="body" sz="quarter" idx="23"/>
          </p:nvPr>
        </p:nvSpPr>
        <p:spPr>
          <a:xfrm>
            <a:off x="392624" y="4734984"/>
            <a:ext cx="11397209" cy="1117600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11" name="Espace réservé du contenu 10">
            <a:extLst>
              <a:ext uri="{FF2B5EF4-FFF2-40B4-BE49-F238E27FC236}">
                <a16:creationId xmlns:a16="http://schemas.microsoft.com/office/drawing/2014/main" xmlns="" id="{C3F69748-7A4C-403E-B6D9-8624201F1D72}"/>
              </a:ext>
            </a:extLst>
          </p:cNvPr>
          <p:cNvSpPr>
            <a:spLocks noGrp="1"/>
          </p:cNvSpPr>
          <p:nvPr>
            <p:ph sz="quarter" idx="22"/>
          </p:nvPr>
        </p:nvSpPr>
        <p:spPr>
          <a:xfrm>
            <a:off x="6324601" y="1322918"/>
            <a:ext cx="5482167" cy="281093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9" name="Espace réservé du contenu 8">
            <a:extLst>
              <a:ext uri="{FF2B5EF4-FFF2-40B4-BE49-F238E27FC236}">
                <a16:creationId xmlns:a16="http://schemas.microsoft.com/office/drawing/2014/main" xmlns="" id="{8FE8CFA6-4612-4963-86A9-5A215B241342}"/>
              </a:ext>
            </a:extLst>
          </p:cNvPr>
          <p:cNvSpPr>
            <a:spLocks noGrp="1"/>
          </p:cNvSpPr>
          <p:nvPr>
            <p:ph sz="quarter" idx="21"/>
          </p:nvPr>
        </p:nvSpPr>
        <p:spPr>
          <a:xfrm>
            <a:off x="385234" y="1322918"/>
            <a:ext cx="5710767" cy="281093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80B0E92B-0813-43F2-8EBF-8D5767515939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712331CB-8CA2-447D-8A3A-905040CCAA4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A17335B4-24F4-4417-B2CD-216405841804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725EB028-6D74-482C-BB91-D368DC9A8F64}"/>
              </a:ext>
            </a:extLst>
          </p:cNvPr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959D75B2-AA4B-4425-A34F-8E17F25F3145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B596949-8F7A-4386-B251-633323215417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xmlns="" id="{8BAD4F59-A9C8-3A47-9AEA-4142B062F6A4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D4F35780-40E4-574B-8D4D-41C883435DAC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xmlns="" id="{BC6ECEEE-E8D4-8C46-BDDE-9AB4CF4DADF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826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re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contenu 6">
            <a:extLst>
              <a:ext uri="{FF2B5EF4-FFF2-40B4-BE49-F238E27FC236}">
                <a16:creationId xmlns:a16="http://schemas.microsoft.com/office/drawing/2014/main" xmlns="" id="{0D9EF205-4F22-49C1-8F01-F14FF6AA5633}"/>
              </a:ext>
            </a:extLst>
          </p:cNvPr>
          <p:cNvSpPr>
            <a:spLocks noGrp="1"/>
          </p:cNvSpPr>
          <p:nvPr>
            <p:ph sz="quarter" idx="20"/>
          </p:nvPr>
        </p:nvSpPr>
        <p:spPr>
          <a:xfrm>
            <a:off x="393701" y="1322918"/>
            <a:ext cx="11358033" cy="470534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3" name="Espace réservé du numéro de diapositive 2">
            <a:extLst>
              <a:ext uri="{FF2B5EF4-FFF2-40B4-BE49-F238E27FC236}">
                <a16:creationId xmlns:a16="http://schemas.microsoft.com/office/drawing/2014/main" xmlns="" id="{80B0E92B-0813-43F2-8EBF-8D5767515939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14" name="Title 1">
            <a:extLst>
              <a:ext uri="{FF2B5EF4-FFF2-40B4-BE49-F238E27FC236}">
                <a16:creationId xmlns:a16="http://schemas.microsoft.com/office/drawing/2014/main" xmlns="" id="{712331CB-8CA2-447D-8A3A-905040CCAA42}"/>
              </a:ext>
            </a:extLst>
          </p:cNvPr>
          <p:cNvSpPr>
            <a:spLocks noGrp="1"/>
          </p:cNvSpPr>
          <p:nvPr>
            <p:ph type="ctrTitle" hasCustomPrompt="1"/>
          </p:nvPr>
        </p:nvSpPr>
        <p:spPr>
          <a:xfrm>
            <a:off x="384381" y="304826"/>
            <a:ext cx="6769417" cy="621553"/>
          </a:xfrm>
        </p:spPr>
        <p:txBody>
          <a:bodyPr lIns="0" tIns="0" rIns="0" bIns="0" anchor="t" anchorCtr="0">
            <a:noAutofit/>
          </a:bodyPr>
          <a:lstStyle>
            <a:lvl1pPr algn="l">
              <a:defRPr sz="2800" b="1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Titre</a:t>
            </a:r>
            <a:endParaRPr lang="en-US" dirty="0"/>
          </a:p>
        </p:txBody>
      </p: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A17335B4-24F4-4417-B2CD-216405841804}"/>
              </a:ext>
            </a:extLst>
          </p:cNvPr>
          <p:cNvCxnSpPr>
            <a:cxnSpLocks/>
          </p:cNvCxnSpPr>
          <p:nvPr userDrawn="1"/>
        </p:nvCxnSpPr>
        <p:spPr>
          <a:xfrm>
            <a:off x="394291" y="828697"/>
            <a:ext cx="1614584" cy="0"/>
          </a:xfrm>
          <a:prstGeom prst="line">
            <a:avLst/>
          </a:prstGeom>
          <a:ln w="19050">
            <a:solidFill>
              <a:schemeClr val="accent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725EB028-6D74-482C-BB91-D368DC9A8F64}"/>
              </a:ext>
            </a:extLst>
          </p:cNvPr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fld id="{9E0E4A05-573E-489C-9251-DA2D79A32399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B596949-8F7A-4386-B251-633323215417}"/>
              </a:ext>
            </a:extLst>
          </p:cNvPr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xmlns="" id="{3E14654D-5EE7-7E43-B62E-86FDE08F60DC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rcRect/>
          <a:stretch/>
        </p:blipFill>
        <p:spPr>
          <a:xfrm>
            <a:off x="8363373" y="6749799"/>
            <a:ext cx="3828627" cy="118533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xmlns="" id="{99B5BED9-5024-4D48-93AC-0E0358B3C833}"/>
              </a:ext>
            </a:extLst>
          </p:cNvPr>
          <p:cNvSpPr/>
          <p:nvPr userDrawn="1"/>
        </p:nvSpPr>
        <p:spPr>
          <a:xfrm>
            <a:off x="10814355" y="135692"/>
            <a:ext cx="1377645" cy="287323"/>
          </a:xfrm>
          <a:prstGeom prst="rect">
            <a:avLst/>
          </a:prstGeom>
          <a:noFill/>
        </p:spPr>
        <p:txBody>
          <a:bodyPr wrap="square" lIns="121920" tIns="60960" rIns="121920" bIns="60960">
            <a:spAutoFit/>
          </a:bodyPr>
          <a:lstStyle/>
          <a:p>
            <a:pPr algn="ctr"/>
            <a:r>
              <a:rPr lang="fr-FR" sz="1067" b="1" cap="none" spc="67" dirty="0">
                <a:ln w="0"/>
                <a:solidFill>
                  <a:schemeClr val="accent5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  <a:latin typeface="Arial" panose="020B0604020202020204" pitchFamily="34" charset="0"/>
                <a:cs typeface="Arial" panose="020B0604020202020204" pitchFamily="34" charset="0"/>
              </a:rPr>
              <a:t>CONFIDENTIAL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xmlns="" id="{A59F4342-24E5-C845-BD35-8878B59F2B83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1082531" y="439041"/>
            <a:ext cx="845167" cy="742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10905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dirty="0"/>
              <a:t>Modifiez le style du titre</a:t>
            </a:r>
            <a:endParaRPr lang="en-US" dirty="0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xmlns="" id="{90DC9C94-12B9-4640-8658-AA19F16BA6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40396" y="6356351"/>
            <a:ext cx="131669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33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9CD748FD-E96E-8F4D-8C5F-51F7EC52E272}" type="slidenum">
              <a:rPr lang="fr-FR" smtClean="0"/>
              <a:pPr/>
              <a:t>‹#›</a:t>
            </a:fld>
            <a:endParaRPr lang="fr-FR" dirty="0"/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BCB88EC3-171D-4161-890C-C641395471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980028" y="6356351"/>
            <a:ext cx="2743200" cy="3661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5B9D335-E2A5-484E-9EC4-8CF3192139F3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82489A60-215D-43BF-BFDC-D3054BC2C6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1661160" y="6356351"/>
            <a:ext cx="4114800" cy="3661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Titre de la réunion</a:t>
            </a:r>
            <a:endParaRPr lang="fr-FR" dirty="0"/>
          </a:p>
        </p:txBody>
      </p:sp>
      <p:sp>
        <p:nvSpPr>
          <p:cNvPr id="8" name="Espace réservé du texte 7">
            <a:extLst>
              <a:ext uri="{FF2B5EF4-FFF2-40B4-BE49-F238E27FC236}">
                <a16:creationId xmlns:a16="http://schemas.microsoft.com/office/drawing/2014/main" xmlns="" id="{E6537628-8A28-48AC-9AF8-EE80C62611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6684"/>
            <a:ext cx="10515600" cy="43497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</a:p>
        </p:txBody>
      </p:sp>
    </p:spTree>
    <p:extLst>
      <p:ext uri="{BB962C8B-B14F-4D97-AF65-F5344CB8AC3E}">
        <p14:creationId xmlns:p14="http://schemas.microsoft.com/office/powerpoint/2010/main" val="6924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</p:sldLayoutIdLst>
  <p:hf hdr="0"/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rgbClr val="202856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0" indent="0" algn="l" defTabSz="914377" rtl="0" eaLnBrk="1" latinLnBrk="0" hangingPunct="1">
        <a:lnSpc>
          <a:spcPct val="150000"/>
        </a:lnSpc>
        <a:spcBef>
          <a:spcPts val="1000"/>
        </a:spcBef>
        <a:buFont typeface="Arial" panose="020B0604020202020204" pitchFamily="34" charset="0"/>
        <a:buNone/>
        <a:defRPr sz="2133" kern="1200">
          <a:solidFill>
            <a:srgbClr val="202856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719649" indent="-239178" algn="l" defTabSz="914377" rtl="0" eaLnBrk="1" latinLnBrk="0" hangingPunct="1">
        <a:lnSpc>
          <a:spcPct val="150000"/>
        </a:lnSpc>
        <a:spcBef>
          <a:spcPts val="500"/>
        </a:spcBef>
        <a:buClr>
          <a:schemeClr val="tx2"/>
        </a:buClr>
        <a:buFont typeface="Arial" panose="020B0604020202020204" pitchFamily="34" charset="0"/>
        <a:buChar char="−"/>
        <a:defRPr sz="2133" kern="1200">
          <a:solidFill>
            <a:srgbClr val="202856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200121" indent="-241294" algn="l" defTabSz="914377" rtl="0" eaLnBrk="1" latinLnBrk="0" hangingPunct="1">
        <a:lnSpc>
          <a:spcPct val="150000"/>
        </a:lnSpc>
        <a:spcBef>
          <a:spcPts val="500"/>
        </a:spcBef>
        <a:buClr>
          <a:schemeClr val="accent4"/>
        </a:buClr>
        <a:buFont typeface="Arial" panose="020B0604020202020204" pitchFamily="34" charset="0"/>
        <a:buChar char="•"/>
        <a:defRPr sz="2133" kern="1200">
          <a:solidFill>
            <a:schemeClr val="accent4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78475" indent="-239178" algn="l" defTabSz="914377" rtl="0" eaLnBrk="1" latinLnBrk="0" hangingPunct="1">
        <a:lnSpc>
          <a:spcPct val="150000"/>
        </a:lnSpc>
        <a:spcBef>
          <a:spcPts val="500"/>
        </a:spcBef>
        <a:buClr>
          <a:schemeClr val="accent5"/>
        </a:buClr>
        <a:buFont typeface="Courier New" panose="02070309020205020404" pitchFamily="49" charset="0"/>
        <a:buChar char="o"/>
        <a:defRPr sz="2133" kern="1200">
          <a:solidFill>
            <a:schemeClr val="accent5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148364" indent="-239178" algn="l" defTabSz="914377" rtl="0" eaLnBrk="1" latinLnBrk="0" hangingPunct="1">
        <a:lnSpc>
          <a:spcPct val="150000"/>
        </a:lnSpc>
        <a:spcBef>
          <a:spcPts val="500"/>
        </a:spcBef>
        <a:buClr>
          <a:srgbClr val="3EC0F0"/>
        </a:buClr>
        <a:buFont typeface="Arial" panose="020B0604020202020204" pitchFamily="34" charset="0"/>
        <a:buChar char="−"/>
        <a:defRPr sz="2133" kern="1200">
          <a:solidFill>
            <a:schemeClr val="accent3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5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8179E82-58CE-BBDE-74B3-6082FD87AF7F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40396" y="6356351"/>
            <a:ext cx="1316697" cy="365125"/>
          </a:xfrm>
        </p:spPr>
        <p:txBody>
          <a:bodyPr/>
          <a:lstStyle/>
          <a:p>
            <a:fld id="{9CD748FD-E96E-8F4D-8C5F-51F7EC52E272}" type="slidenum">
              <a:rPr lang="fr-FR" smtClean="0"/>
              <a:pPr/>
              <a:t>1</a:t>
            </a:fld>
            <a:endParaRPr lang="fr-FR" dirty="0"/>
          </a:p>
        </p:txBody>
      </p:sp>
      <p:grpSp>
        <p:nvGrpSpPr>
          <p:cNvPr id="2" name="Groupe 1">
            <a:extLst>
              <a:ext uri="{FF2B5EF4-FFF2-40B4-BE49-F238E27FC236}">
                <a16:creationId xmlns:a16="http://schemas.microsoft.com/office/drawing/2014/main" xmlns="" id="{0E1320A6-B81F-52AD-7E21-D83D62187FC9}"/>
              </a:ext>
            </a:extLst>
          </p:cNvPr>
          <p:cNvGrpSpPr/>
          <p:nvPr/>
        </p:nvGrpSpPr>
        <p:grpSpPr>
          <a:xfrm>
            <a:off x="228599" y="79305"/>
            <a:ext cx="11267833" cy="6819295"/>
            <a:chOff x="228599" y="79305"/>
            <a:chExt cx="11267833" cy="6819295"/>
          </a:xfrm>
        </p:grpSpPr>
        <p:graphicFrame>
          <p:nvGraphicFramePr>
            <p:cNvPr id="7" name="Diagramme 6">
              <a:extLst>
                <a:ext uri="{FF2B5EF4-FFF2-40B4-BE49-F238E27FC236}">
                  <a16:creationId xmlns:a16="http://schemas.microsoft.com/office/drawing/2014/main" xmlns="" id="{ED176041-AA54-C403-2026-34C34E34238D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546568428"/>
                </p:ext>
              </p:extLst>
            </p:nvPr>
          </p:nvGraphicFramePr>
          <p:xfrm>
            <a:off x="228599" y="79305"/>
            <a:ext cx="11267833" cy="6819295"/>
          </p:xfrm>
          <a:graphic>
            <a:graphicData uri="http://schemas.openxmlformats.org/drawingml/2006/diagram">
              <dgm:relIds xmlns:dgm="http://schemas.openxmlformats.org/drawingml/2006/diagram" xmlns:r="http://schemas.openxmlformats.org/officeDocument/2006/relationships" r:dm="rId2" r:lo="rId3" r:qs="rId4" r:cs="rId5"/>
            </a:graphicData>
          </a:graphic>
        </p:graphicFrame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xmlns="" id="{08927928-1871-6527-1EB1-F4BF635977EA}"/>
                </a:ext>
              </a:extLst>
            </p:cNvPr>
            <p:cNvSpPr txBox="1"/>
            <p:nvPr/>
          </p:nvSpPr>
          <p:spPr>
            <a:xfrm>
              <a:off x="8218714" y="1643743"/>
              <a:ext cx="21611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solidFill>
                    <a:schemeClr val="accent5">
                      <a:lumMod val="75000"/>
                    </a:schemeClr>
                  </a:solidFill>
                </a:rPr>
                <a:t>*</a:t>
              </a:r>
              <a:r>
                <a:rPr lang="fr-FR" sz="1100" dirty="0" err="1">
                  <a:solidFill>
                    <a:schemeClr val="accent5">
                      <a:lumMod val="75000"/>
                    </a:schemeClr>
                  </a:solidFill>
                </a:rPr>
                <a:t>excluded</a:t>
              </a:r>
              <a:r>
                <a:rPr lang="fr-FR" sz="1100" dirty="0">
                  <a:solidFill>
                    <a:schemeClr val="accent5">
                      <a:lumMod val="75000"/>
                    </a:schemeClr>
                  </a:solidFill>
                </a:rPr>
                <a:t> </a:t>
              </a:r>
              <a:r>
                <a:rPr lang="fr-FR" sz="1100" dirty="0" err="1">
                  <a:solidFill>
                    <a:schemeClr val="accent5">
                      <a:lumMod val="75000"/>
                    </a:schemeClr>
                  </a:solidFill>
                </a:rPr>
                <a:t>from</a:t>
              </a:r>
              <a:r>
                <a:rPr lang="fr-FR" sz="1100" dirty="0">
                  <a:solidFill>
                    <a:schemeClr val="accent5">
                      <a:lumMod val="75000"/>
                    </a:schemeClr>
                  </a:solidFill>
                </a:rPr>
                <a:t> </a:t>
              </a:r>
              <a:r>
                <a:rPr lang="fr-FR" sz="1100" dirty="0" err="1">
                  <a:solidFill>
                    <a:schemeClr val="accent5">
                      <a:lumMod val="75000"/>
                    </a:schemeClr>
                  </a:solidFill>
                </a:rPr>
                <a:t>sensitivity</a:t>
              </a:r>
              <a:r>
                <a:rPr lang="fr-FR" sz="1100" dirty="0">
                  <a:solidFill>
                    <a:schemeClr val="accent5">
                      <a:lumMod val="75000"/>
                    </a:schemeClr>
                  </a:solidFill>
                </a:rPr>
                <a:t> </a:t>
              </a:r>
              <a:r>
                <a:rPr lang="fr-FR" sz="1100" dirty="0" err="1">
                  <a:solidFill>
                    <a:schemeClr val="accent5">
                      <a:lumMod val="75000"/>
                    </a:schemeClr>
                  </a:solidFill>
                </a:rPr>
                <a:t>analysis</a:t>
              </a:r>
              <a:endParaRPr lang="fr-FR" sz="1100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</p:grpSp>
      <p:sp>
        <p:nvSpPr>
          <p:cNvPr id="10" name="Titre 2">
            <a:extLst>
              <a:ext uri="{FF2B5EF4-FFF2-40B4-BE49-F238E27FC236}">
                <a16:creationId xmlns:a16="http://schemas.microsoft.com/office/drawing/2014/main" xmlns="" id="{A78D9A3B-A89F-A854-6C78-0949A3D862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0396" y="0"/>
            <a:ext cx="6769417" cy="621553"/>
          </a:xfrm>
        </p:spPr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34529531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re 2">
            <a:extLst>
              <a:ext uri="{FF2B5EF4-FFF2-40B4-BE49-F238E27FC236}">
                <a16:creationId xmlns:a16="http://schemas.microsoft.com/office/drawing/2014/main" xmlns="" id="{5AC6D93B-FE9C-101B-1455-CD77B425323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figure 2A: </a:t>
            </a:r>
            <a:r>
              <a:rPr lang="fr-FR" dirty="0" err="1"/>
              <a:t>outcome</a:t>
            </a:r>
            <a:r>
              <a:rPr lang="fr-FR" dirty="0"/>
              <a:t> of MYC/BCL2 DH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706FA98C-6A5C-0C9D-0E07-ED2763E7B1B9}"/>
              </a:ext>
            </a:extLst>
          </p:cNvPr>
          <p:cNvSpPr>
            <a:spLocks noGrp="1"/>
          </p:cNvSpPr>
          <p:nvPr>
            <p:ph type="dt" sz="half" idx="4294967295"/>
          </p:nvPr>
        </p:nvSpPr>
        <p:spPr>
          <a:xfrm>
            <a:off x="5980028" y="6356351"/>
            <a:ext cx="2743200" cy="366183"/>
          </a:xfrm>
        </p:spPr>
        <p:txBody>
          <a:bodyPr/>
          <a:lstStyle/>
          <a:p>
            <a:fld id="{A3A8360B-24F6-447E-AA6B-327C84B79722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3B62807-025A-CA4A-BD1C-A536239CAC62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40396" y="6356351"/>
            <a:ext cx="1316697" cy="365125"/>
          </a:xfrm>
        </p:spPr>
        <p:txBody>
          <a:bodyPr/>
          <a:lstStyle/>
          <a:p>
            <a:fld id="{9CD748FD-E96E-8F4D-8C5F-51F7EC52E272}" type="slidenum">
              <a:rPr lang="fr-FR" smtClean="0"/>
              <a:pPr/>
              <a:t>2</a:t>
            </a:fld>
            <a:endParaRPr lang="fr-FR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xmlns="" id="{E5B0FABA-53FA-AD61-966D-16F4AF7368F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6668" y="1481095"/>
            <a:ext cx="5760720" cy="4320540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97D378EE-AAFD-C255-0D06-66206C46EF89}"/>
              </a:ext>
            </a:extLst>
          </p:cNvPr>
          <p:cNvSpPr txBox="1"/>
          <p:nvPr/>
        </p:nvSpPr>
        <p:spPr>
          <a:xfrm>
            <a:off x="4330712" y="4180115"/>
            <a:ext cx="20842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/>
              <a:t>HR: 5.722 (95% CI: 1.828-17.910)</a:t>
            </a:r>
          </a:p>
        </p:txBody>
      </p:sp>
    </p:spTree>
    <p:extLst>
      <p:ext uri="{BB962C8B-B14F-4D97-AF65-F5344CB8AC3E}">
        <p14:creationId xmlns:p14="http://schemas.microsoft.com/office/powerpoint/2010/main" val="3161486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re 2">
            <a:extLst>
              <a:ext uri="{FF2B5EF4-FFF2-40B4-BE49-F238E27FC236}">
                <a16:creationId xmlns:a16="http://schemas.microsoft.com/office/drawing/2014/main" xmlns="" id="{1730EA9A-1611-F2B4-AA08-0F668EE8058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err="1"/>
              <a:t>Supplementary</a:t>
            </a:r>
            <a:r>
              <a:rPr lang="fr-FR" dirty="0"/>
              <a:t> figure 2B: </a:t>
            </a:r>
            <a:r>
              <a:rPr lang="fr-FR" dirty="0" err="1"/>
              <a:t>outcome</a:t>
            </a:r>
            <a:r>
              <a:rPr lang="fr-FR" dirty="0"/>
              <a:t> and </a:t>
            </a:r>
            <a:r>
              <a:rPr lang="fr-FR" dirty="0" err="1"/>
              <a:t>molecular</a:t>
            </a:r>
            <a:r>
              <a:rPr lang="fr-FR" dirty="0"/>
              <a:t> data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5FD70BD-787F-459B-CDF7-C16BF2960645}"/>
              </a:ext>
            </a:extLst>
          </p:cNvPr>
          <p:cNvSpPr>
            <a:spLocks noGrp="1"/>
          </p:cNvSpPr>
          <p:nvPr>
            <p:ph type="dt" sz="half" idx="4294967295"/>
          </p:nvPr>
        </p:nvSpPr>
        <p:spPr>
          <a:xfrm>
            <a:off x="5980028" y="6356351"/>
            <a:ext cx="2743200" cy="366183"/>
          </a:xfrm>
        </p:spPr>
        <p:txBody>
          <a:bodyPr/>
          <a:lstStyle/>
          <a:p>
            <a:fld id="{A3A8360B-24F6-447E-AA6B-327C84B79722}" type="datetime4">
              <a:rPr lang="fr-FR" smtClean="0"/>
              <a:t>5 mars 2025</a:t>
            </a:fld>
            <a:endParaRPr lang="fr-FR" dirty="0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A4B5F72F-73A1-AEB4-D895-E4DDFD005812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1661160" y="6356351"/>
            <a:ext cx="4114800" cy="366183"/>
          </a:xfrm>
        </p:spPr>
        <p:txBody>
          <a:bodyPr/>
          <a:lstStyle/>
          <a:p>
            <a:r>
              <a:rPr lang="fr-FR"/>
              <a:t>Titre de la réunion</a:t>
            </a:r>
            <a:endParaRPr lang="fr-FR" dirty="0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A5317C0-C729-108D-13C8-5447C8004CBB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140396" y="6356351"/>
            <a:ext cx="1316697" cy="365125"/>
          </a:xfrm>
        </p:spPr>
        <p:txBody>
          <a:bodyPr/>
          <a:lstStyle/>
          <a:p>
            <a:fld id="{9CD748FD-E96E-8F4D-8C5F-51F7EC52E272}" type="slidenum">
              <a:rPr lang="fr-FR" smtClean="0"/>
              <a:pPr/>
              <a:t>3</a:t>
            </a:fld>
            <a:endParaRPr lang="fr-FR" dirty="0"/>
          </a:p>
        </p:txBody>
      </p:sp>
      <p:grpSp>
        <p:nvGrpSpPr>
          <p:cNvPr id="7" name="Groupe 6">
            <a:extLst>
              <a:ext uri="{FF2B5EF4-FFF2-40B4-BE49-F238E27FC236}">
                <a16:creationId xmlns:a16="http://schemas.microsoft.com/office/drawing/2014/main" xmlns="" id="{7997576A-FC21-BAA9-D0B3-55338A513C66}"/>
              </a:ext>
            </a:extLst>
          </p:cNvPr>
          <p:cNvGrpSpPr/>
          <p:nvPr/>
        </p:nvGrpSpPr>
        <p:grpSpPr>
          <a:xfrm>
            <a:off x="225347" y="1194598"/>
            <a:ext cx="6443504" cy="4963605"/>
            <a:chOff x="225347" y="1194598"/>
            <a:chExt cx="6443504" cy="4963605"/>
          </a:xfrm>
        </p:grpSpPr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xmlns="" id="{2DBBAD8E-9A78-E436-6D7F-1F592B09D9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5348" y="1194598"/>
              <a:ext cx="3181643" cy="2382728"/>
            </a:xfrm>
            <a:prstGeom prst="rect">
              <a:avLst/>
            </a:prstGeom>
          </p:spPr>
        </p:pic>
        <p:pic>
          <p:nvPicPr>
            <p:cNvPr id="15" name="Image 14">
              <a:extLst>
                <a:ext uri="{FF2B5EF4-FFF2-40B4-BE49-F238E27FC236}">
                  <a16:creationId xmlns:a16="http://schemas.microsoft.com/office/drawing/2014/main" xmlns="" id="{273FA096-6AD7-CA9B-6F2A-97E773201D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87206" y="1203425"/>
              <a:ext cx="3169858" cy="2373902"/>
            </a:xfrm>
            <a:prstGeom prst="rect">
              <a:avLst/>
            </a:prstGeom>
          </p:spPr>
        </p:pic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xmlns="" id="{FFE684C4-A5FB-CEFF-DBA2-BC8AA72B64D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5347" y="3775474"/>
              <a:ext cx="3181643" cy="2382728"/>
            </a:xfrm>
            <a:prstGeom prst="rect">
              <a:avLst/>
            </a:prstGeom>
          </p:spPr>
        </p:pic>
        <p:pic>
          <p:nvPicPr>
            <p:cNvPr id="2" name="Image 1">
              <a:extLst>
                <a:ext uri="{FF2B5EF4-FFF2-40B4-BE49-F238E27FC236}">
                  <a16:creationId xmlns:a16="http://schemas.microsoft.com/office/drawing/2014/main" xmlns="" id="{63F672CE-74E1-3B99-A2FB-B158BCAEE6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87207" y="3775474"/>
              <a:ext cx="3181644" cy="2382729"/>
            </a:xfrm>
            <a:prstGeom prst="rect">
              <a:avLst/>
            </a:prstGeom>
          </p:spPr>
        </p:pic>
      </p:grpSp>
      <p:pic>
        <p:nvPicPr>
          <p:cNvPr id="11" name="Image 10" descr="Une image contenant texte, capture d’écran, affichage, nombre&#10;&#10;Description générée automatiquement">
            <a:extLst>
              <a:ext uri="{FF2B5EF4-FFF2-40B4-BE49-F238E27FC236}">
                <a16:creationId xmlns:a16="http://schemas.microsoft.com/office/drawing/2014/main" xmlns="" id="{DBDE98D1-A5D2-7DD8-9A15-E5BAA8B1ED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37279" y="1194598"/>
            <a:ext cx="3169859" cy="2377394"/>
          </a:xfrm>
          <a:prstGeom prst="rect">
            <a:avLst/>
          </a:prstGeom>
        </p:spPr>
      </p:pic>
      <p:sp>
        <p:nvSpPr>
          <p:cNvPr id="9" name="ZoneTexte 8">
            <a:extLst>
              <a:ext uri="{FF2B5EF4-FFF2-40B4-BE49-F238E27FC236}">
                <a16:creationId xmlns:a16="http://schemas.microsoft.com/office/drawing/2014/main" xmlns="" id="{239EF317-D0F4-CEFA-0EAD-A5533A0DFF9C}"/>
              </a:ext>
            </a:extLst>
          </p:cNvPr>
          <p:cNvSpPr txBox="1"/>
          <p:nvPr/>
        </p:nvSpPr>
        <p:spPr>
          <a:xfrm>
            <a:off x="1080286" y="2623849"/>
            <a:ext cx="122706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kern="0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R=1.9 (0.7;5.4)</a:t>
            </a:r>
            <a:r>
              <a:rPr lang="fr-FR" sz="700" dirty="0">
                <a:effectLst/>
              </a:rPr>
              <a:t> </a:t>
            </a:r>
            <a:endParaRPr lang="fr-FR" sz="7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7E63DA67-E5C2-FE33-0E0C-2DC447F4BBC2}"/>
              </a:ext>
            </a:extLst>
          </p:cNvPr>
          <p:cNvSpPr txBox="1"/>
          <p:nvPr/>
        </p:nvSpPr>
        <p:spPr>
          <a:xfrm>
            <a:off x="4388802" y="2634735"/>
            <a:ext cx="122706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kern="0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R=0.9 (0.2;4.2)</a:t>
            </a:r>
            <a:endParaRPr lang="fr-FR" sz="700" dirty="0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xmlns="" id="{5D2C5935-64D1-B41E-6F4D-69E83C059470}"/>
              </a:ext>
            </a:extLst>
          </p:cNvPr>
          <p:cNvSpPr txBox="1"/>
          <p:nvPr/>
        </p:nvSpPr>
        <p:spPr>
          <a:xfrm>
            <a:off x="1240380" y="5214649"/>
            <a:ext cx="122706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kern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R=0.9 (0.7;5.4)</a:t>
            </a:r>
            <a:endParaRPr lang="fr-FR" sz="7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xmlns="" id="{0BD60CC3-CBF1-EF56-9528-A972A7985DB3}"/>
              </a:ext>
            </a:extLst>
          </p:cNvPr>
          <p:cNvSpPr txBox="1"/>
          <p:nvPr/>
        </p:nvSpPr>
        <p:spPr>
          <a:xfrm>
            <a:off x="7719090" y="2623849"/>
            <a:ext cx="122706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700" kern="0" dirty="0">
                <a:effectLst/>
                <a:latin typeface="Aptos" panose="020B00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R=0.9 (0.3;3.0)</a:t>
            </a:r>
            <a:endParaRPr lang="fr-FR" sz="700" dirty="0"/>
          </a:p>
        </p:txBody>
      </p:sp>
    </p:spTree>
    <p:extLst>
      <p:ext uri="{BB962C8B-B14F-4D97-AF65-F5344CB8AC3E}">
        <p14:creationId xmlns:p14="http://schemas.microsoft.com/office/powerpoint/2010/main" val="2136216684"/>
      </p:ext>
    </p:extLst>
  </p:cSld>
  <p:clrMapOvr>
    <a:masterClrMapping/>
  </p:clrMapOvr>
</p:sld>
</file>

<file path=ppt/theme/theme1.xml><?xml version="1.0" encoding="utf-8"?>
<a:theme xmlns:a="http://schemas.openxmlformats.org/drawingml/2006/main" name="1_Thème Office">
  <a:themeElements>
    <a:clrScheme name="lysa">
      <a:dk1>
        <a:srgbClr val="000000"/>
      </a:dk1>
      <a:lt1>
        <a:srgbClr val="FFFFFF"/>
      </a:lt1>
      <a:dk2>
        <a:srgbClr val="232E61"/>
      </a:dk2>
      <a:lt2>
        <a:srgbClr val="A7A8AA"/>
      </a:lt2>
      <a:accent1>
        <a:srgbClr val="A8D2E3"/>
      </a:accent1>
      <a:accent2>
        <a:srgbClr val="BEDEE3"/>
      </a:accent2>
      <a:accent3>
        <a:srgbClr val="22BFDD"/>
      </a:accent3>
      <a:accent4>
        <a:srgbClr val="3C649D"/>
      </a:accent4>
      <a:accent5>
        <a:srgbClr val="E5326B"/>
      </a:accent5>
      <a:accent6>
        <a:srgbClr val="891B51"/>
      </a:accent6>
      <a:hlink>
        <a:srgbClr val="57CFDD"/>
      </a:hlink>
      <a:folHlink>
        <a:srgbClr val="5D7E9D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Template ppt LYSA Confidential 20210317" id="{4A1723FC-D916-4AE6-AF0F-A3D9D1A10654}" vid="{F854EFEE-7131-4783-9D76-338834526AC3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xmlns="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7</TotalTime>
  <Words>264</Words>
  <Application>Microsoft Office PowerPoint</Application>
  <PresentationFormat>Custom</PresentationFormat>
  <Paragraphs>5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1_Thème Office</vt:lpstr>
      <vt:lpstr>Supplementary figure 1</vt:lpstr>
      <vt:lpstr>Supplementary figure 2A: outcome of MYC/BCL2 DH</vt:lpstr>
      <vt:lpstr>Supplementary figure 2B: outcome and molecular data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Patient disposition</dc:title>
  <dc:creator>Clementine Sarkozy</dc:creator>
  <cp:lastModifiedBy>Ahamed Shuhail KA.</cp:lastModifiedBy>
  <cp:revision>25</cp:revision>
  <dcterms:created xsi:type="dcterms:W3CDTF">2024-04-19T13:31:08Z</dcterms:created>
  <dcterms:modified xsi:type="dcterms:W3CDTF">2025-03-05T08:01:43Z</dcterms:modified>
</cp:coreProperties>
</file>